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6" r:id="rId2"/>
  </p:sldIdLst>
  <p:sldSz cx="9144000" cy="6858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0" name="jl x" initials="jx" lastIdx="1" clrIdx="0"/>
  <p:cmAuthor id="1" name="jl" initials="jl" lastIdx="1" clrIdx="1"/>
  <p:cmAuthor id="2" name="焦玉霞" initials="YJ" lastIdx="1" clrIdx="2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5810" autoAdjust="0"/>
  </p:normalViewPr>
  <p:slideViewPr>
    <p:cSldViewPr>
      <p:cViewPr>
        <p:scale>
          <a:sx n="100" d="100"/>
          <a:sy n="100" d="100"/>
        </p:scale>
        <p:origin x="-936" y="158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158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E976C69A-5E69-41C1-924F-6B9CD9D0C143}" type="datetimeFigureOut">
              <a:rPr lang="zh-CN" altLang="en-US" smtClean="0"/>
              <a:pPr/>
              <a:t>2016/3/29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2853E29-EAFB-4E1C-A8F9-A34ADFBBA5B5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2401878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altLang="zh-CN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 </a:t>
            </a:r>
            <a:endParaRPr lang="zh-CN" altLang="zh-CN" sz="1200" kern="1200" dirty="0" smtClean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  <a:p>
            <a:r>
              <a:rPr lang="en-US" altLang="zh-CN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 </a:t>
            </a:r>
            <a:endParaRPr lang="zh-CN" altLang="zh-CN" sz="1200" kern="1200" dirty="0" smtClean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82853E29-EAFB-4E1C-A8F9-A34ADFBBA5B5}" type="slidenum">
              <a:rPr lang="zh-CN" altLang="en-US" smtClean="0"/>
              <a:pPr/>
              <a:t>1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2670077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399A9B-321E-42BE-8BDA-3CA8308C4A2D}" type="datetimeFigureOut">
              <a:rPr lang="zh-CN" altLang="en-US" smtClean="0"/>
              <a:pPr/>
              <a:t>2016/3/29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649C5A-AEE6-445B-B75C-09BA9BB07C75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931147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399A9B-321E-42BE-8BDA-3CA8308C4A2D}" type="datetimeFigureOut">
              <a:rPr lang="zh-CN" altLang="en-US" smtClean="0"/>
              <a:pPr/>
              <a:t>2016/3/29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649C5A-AEE6-445B-B75C-09BA9BB07C75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6894699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399A9B-321E-42BE-8BDA-3CA8308C4A2D}" type="datetimeFigureOut">
              <a:rPr lang="zh-CN" altLang="en-US" smtClean="0"/>
              <a:pPr/>
              <a:t>2016/3/29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649C5A-AEE6-445B-B75C-09BA9BB07C75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23254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399A9B-321E-42BE-8BDA-3CA8308C4A2D}" type="datetimeFigureOut">
              <a:rPr lang="zh-CN" altLang="en-US" smtClean="0"/>
              <a:pPr/>
              <a:t>2016/3/29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649C5A-AEE6-445B-B75C-09BA9BB07C75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4728408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399A9B-321E-42BE-8BDA-3CA8308C4A2D}" type="datetimeFigureOut">
              <a:rPr lang="zh-CN" altLang="en-US" smtClean="0"/>
              <a:pPr/>
              <a:t>2016/3/29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649C5A-AEE6-445B-B75C-09BA9BB07C75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82818597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399A9B-321E-42BE-8BDA-3CA8308C4A2D}" type="datetimeFigureOut">
              <a:rPr lang="zh-CN" altLang="en-US" smtClean="0"/>
              <a:pPr/>
              <a:t>2016/3/29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649C5A-AEE6-445B-B75C-09BA9BB07C75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0708575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399A9B-321E-42BE-8BDA-3CA8308C4A2D}" type="datetimeFigureOut">
              <a:rPr lang="zh-CN" altLang="en-US" smtClean="0"/>
              <a:pPr/>
              <a:t>2016/3/29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649C5A-AEE6-445B-B75C-09BA9BB07C75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4384790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399A9B-321E-42BE-8BDA-3CA8308C4A2D}" type="datetimeFigureOut">
              <a:rPr lang="zh-CN" altLang="en-US" smtClean="0"/>
              <a:pPr/>
              <a:t>2016/3/29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649C5A-AEE6-445B-B75C-09BA9BB07C75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458062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399A9B-321E-42BE-8BDA-3CA8308C4A2D}" type="datetimeFigureOut">
              <a:rPr lang="zh-CN" altLang="en-US" smtClean="0"/>
              <a:pPr/>
              <a:t>2016/3/29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649C5A-AEE6-445B-B75C-09BA9BB07C75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9630698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399A9B-321E-42BE-8BDA-3CA8308C4A2D}" type="datetimeFigureOut">
              <a:rPr lang="zh-CN" altLang="en-US" smtClean="0"/>
              <a:pPr/>
              <a:t>2016/3/29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649C5A-AEE6-445B-B75C-09BA9BB07C75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6734469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399A9B-321E-42BE-8BDA-3CA8308C4A2D}" type="datetimeFigureOut">
              <a:rPr lang="zh-CN" altLang="en-US" smtClean="0"/>
              <a:pPr/>
              <a:t>2016/3/29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649C5A-AEE6-445B-B75C-09BA9BB07C75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5525127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B399A9B-321E-42BE-8BDA-3CA8308C4A2D}" type="datetimeFigureOut">
              <a:rPr lang="zh-CN" altLang="en-US" smtClean="0"/>
              <a:pPr/>
              <a:t>2016/3/29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B649C5A-AEE6-445B-B75C-09BA9BB07C75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8752789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75" name="Group 74"/>
          <p:cNvGrpSpPr/>
          <p:nvPr/>
        </p:nvGrpSpPr>
        <p:grpSpPr>
          <a:xfrm>
            <a:off x="3053659" y="294259"/>
            <a:ext cx="2813741" cy="717557"/>
            <a:chOff x="228600" y="505223"/>
            <a:chExt cx="2796766" cy="637778"/>
          </a:xfrm>
          <a:solidFill>
            <a:schemeClr val="bg1"/>
          </a:solidFill>
        </p:grpSpPr>
        <p:sp>
          <p:nvSpPr>
            <p:cNvPr id="76" name="Freeform 75"/>
            <p:cNvSpPr/>
            <p:nvPr/>
          </p:nvSpPr>
          <p:spPr>
            <a:xfrm>
              <a:off x="228600" y="505223"/>
              <a:ext cx="2796766" cy="637778"/>
            </a:xfrm>
            <a:custGeom>
              <a:avLst/>
              <a:gdLst>
                <a:gd name="connsiteX0" fmla="*/ 1439501 w 5135879"/>
                <a:gd name="connsiteY0" fmla="*/ 253497 h 683987"/>
                <a:gd name="connsiteX1" fmla="*/ 1484768 w 5135879"/>
                <a:gd name="connsiteY1" fmla="*/ 208230 h 683987"/>
                <a:gd name="connsiteX2" fmla="*/ 1511928 w 5135879"/>
                <a:gd name="connsiteY2" fmla="*/ 190123 h 683987"/>
                <a:gd name="connsiteX3" fmla="*/ 1575303 w 5135879"/>
                <a:gd name="connsiteY3" fmla="*/ 162963 h 683987"/>
                <a:gd name="connsiteX4" fmla="*/ 1629623 w 5135879"/>
                <a:gd name="connsiteY4" fmla="*/ 117695 h 683987"/>
                <a:gd name="connsiteX5" fmla="*/ 1665837 w 5135879"/>
                <a:gd name="connsiteY5" fmla="*/ 108642 h 683987"/>
                <a:gd name="connsiteX6" fmla="*/ 1692998 w 5135879"/>
                <a:gd name="connsiteY6" fmla="*/ 99588 h 683987"/>
                <a:gd name="connsiteX7" fmla="*/ 1865014 w 5135879"/>
                <a:gd name="connsiteY7" fmla="*/ 81481 h 683987"/>
                <a:gd name="connsiteX8" fmla="*/ 2136617 w 5135879"/>
                <a:gd name="connsiteY8" fmla="*/ 63374 h 683987"/>
                <a:gd name="connsiteX9" fmla="*/ 2172831 w 5135879"/>
                <a:gd name="connsiteY9" fmla="*/ 54321 h 683987"/>
                <a:gd name="connsiteX10" fmla="*/ 2227152 w 5135879"/>
                <a:gd name="connsiteY10" fmla="*/ 45268 h 683987"/>
                <a:gd name="connsiteX11" fmla="*/ 2353901 w 5135879"/>
                <a:gd name="connsiteY11" fmla="*/ 18107 h 683987"/>
                <a:gd name="connsiteX12" fmla="*/ 2417275 w 5135879"/>
                <a:gd name="connsiteY12" fmla="*/ 0 h 683987"/>
                <a:gd name="connsiteX13" fmla="*/ 2996697 w 5135879"/>
                <a:gd name="connsiteY13" fmla="*/ 9054 h 683987"/>
                <a:gd name="connsiteX14" fmla="*/ 3132499 w 5135879"/>
                <a:gd name="connsiteY14" fmla="*/ 18107 h 683987"/>
                <a:gd name="connsiteX15" fmla="*/ 3159659 w 5135879"/>
                <a:gd name="connsiteY15" fmla="*/ 36214 h 683987"/>
                <a:gd name="connsiteX16" fmla="*/ 3213980 w 5135879"/>
                <a:gd name="connsiteY16" fmla="*/ 63374 h 683987"/>
                <a:gd name="connsiteX17" fmla="*/ 3268301 w 5135879"/>
                <a:gd name="connsiteY17" fmla="*/ 99588 h 683987"/>
                <a:gd name="connsiteX18" fmla="*/ 3295461 w 5135879"/>
                <a:gd name="connsiteY18" fmla="*/ 117695 h 683987"/>
                <a:gd name="connsiteX19" fmla="*/ 3395049 w 5135879"/>
                <a:gd name="connsiteY19" fmla="*/ 126749 h 683987"/>
                <a:gd name="connsiteX20" fmla="*/ 3422210 w 5135879"/>
                <a:gd name="connsiteY20" fmla="*/ 135802 h 683987"/>
                <a:gd name="connsiteX21" fmla="*/ 3449370 w 5135879"/>
                <a:gd name="connsiteY21" fmla="*/ 162963 h 683987"/>
                <a:gd name="connsiteX22" fmla="*/ 3467477 w 5135879"/>
                <a:gd name="connsiteY22" fmla="*/ 190123 h 683987"/>
                <a:gd name="connsiteX23" fmla="*/ 3521798 w 5135879"/>
                <a:gd name="connsiteY23" fmla="*/ 226337 h 683987"/>
                <a:gd name="connsiteX24" fmla="*/ 3548958 w 5135879"/>
                <a:gd name="connsiteY24" fmla="*/ 253497 h 683987"/>
                <a:gd name="connsiteX25" fmla="*/ 3612332 w 5135879"/>
                <a:gd name="connsiteY25" fmla="*/ 262551 h 683987"/>
                <a:gd name="connsiteX26" fmla="*/ 3675707 w 5135879"/>
                <a:gd name="connsiteY26" fmla="*/ 280658 h 683987"/>
                <a:gd name="connsiteX27" fmla="*/ 3702867 w 5135879"/>
                <a:gd name="connsiteY27" fmla="*/ 289711 h 683987"/>
                <a:gd name="connsiteX28" fmla="*/ 3793402 w 5135879"/>
                <a:gd name="connsiteY28" fmla="*/ 307818 h 683987"/>
                <a:gd name="connsiteX29" fmla="*/ 3883936 w 5135879"/>
                <a:gd name="connsiteY29" fmla="*/ 334978 h 683987"/>
                <a:gd name="connsiteX30" fmla="*/ 3920150 w 5135879"/>
                <a:gd name="connsiteY30" fmla="*/ 353085 h 683987"/>
                <a:gd name="connsiteX31" fmla="*/ 3947311 w 5135879"/>
                <a:gd name="connsiteY31" fmla="*/ 362139 h 683987"/>
                <a:gd name="connsiteX32" fmla="*/ 4200808 w 5135879"/>
                <a:gd name="connsiteY32" fmla="*/ 380246 h 683987"/>
                <a:gd name="connsiteX33" fmla="*/ 4409037 w 5135879"/>
                <a:gd name="connsiteY33" fmla="*/ 398353 h 683987"/>
                <a:gd name="connsiteX34" fmla="*/ 4472412 w 5135879"/>
                <a:gd name="connsiteY34" fmla="*/ 407406 h 683987"/>
                <a:gd name="connsiteX35" fmla="*/ 4508625 w 5135879"/>
                <a:gd name="connsiteY35" fmla="*/ 416460 h 683987"/>
                <a:gd name="connsiteX36" fmla="*/ 4689695 w 5135879"/>
                <a:gd name="connsiteY36" fmla="*/ 434567 h 683987"/>
                <a:gd name="connsiteX37" fmla="*/ 5069940 w 5135879"/>
                <a:gd name="connsiteY37" fmla="*/ 443620 h 683987"/>
                <a:gd name="connsiteX38" fmla="*/ 5097101 w 5135879"/>
                <a:gd name="connsiteY38" fmla="*/ 452673 h 683987"/>
                <a:gd name="connsiteX39" fmla="*/ 5133315 w 5135879"/>
                <a:gd name="connsiteY39" fmla="*/ 443620 h 683987"/>
                <a:gd name="connsiteX40" fmla="*/ 5069940 w 5135879"/>
                <a:gd name="connsiteY40" fmla="*/ 452673 h 683987"/>
                <a:gd name="connsiteX41" fmla="*/ 5042780 w 5135879"/>
                <a:gd name="connsiteY41" fmla="*/ 461727 h 683987"/>
                <a:gd name="connsiteX42" fmla="*/ 4997513 w 5135879"/>
                <a:gd name="connsiteY42" fmla="*/ 470780 h 683987"/>
                <a:gd name="connsiteX43" fmla="*/ 4961299 w 5135879"/>
                <a:gd name="connsiteY43" fmla="*/ 479834 h 683987"/>
                <a:gd name="connsiteX44" fmla="*/ 4762122 w 5135879"/>
                <a:gd name="connsiteY44" fmla="*/ 506994 h 683987"/>
                <a:gd name="connsiteX45" fmla="*/ 4680641 w 5135879"/>
                <a:gd name="connsiteY45" fmla="*/ 525101 h 683987"/>
                <a:gd name="connsiteX46" fmla="*/ 4164594 w 5135879"/>
                <a:gd name="connsiteY46" fmla="*/ 516048 h 683987"/>
                <a:gd name="connsiteX47" fmla="*/ 4137433 w 5135879"/>
                <a:gd name="connsiteY47" fmla="*/ 525101 h 683987"/>
                <a:gd name="connsiteX48" fmla="*/ 3811509 w 5135879"/>
                <a:gd name="connsiteY48" fmla="*/ 534155 h 683987"/>
                <a:gd name="connsiteX49" fmla="*/ 3902043 w 5135879"/>
                <a:gd name="connsiteY49" fmla="*/ 552262 h 683987"/>
                <a:gd name="connsiteX50" fmla="*/ 3929204 w 5135879"/>
                <a:gd name="connsiteY50" fmla="*/ 570369 h 683987"/>
                <a:gd name="connsiteX51" fmla="*/ 4046899 w 5135879"/>
                <a:gd name="connsiteY51" fmla="*/ 606582 h 683987"/>
                <a:gd name="connsiteX52" fmla="*/ 4092166 w 5135879"/>
                <a:gd name="connsiteY52" fmla="*/ 615636 h 683987"/>
                <a:gd name="connsiteX53" fmla="*/ 4155540 w 5135879"/>
                <a:gd name="connsiteY53" fmla="*/ 642796 h 683987"/>
                <a:gd name="connsiteX54" fmla="*/ 4218915 w 5135879"/>
                <a:gd name="connsiteY54" fmla="*/ 651850 h 683987"/>
                <a:gd name="connsiteX55" fmla="*/ 4191754 w 5135879"/>
                <a:gd name="connsiteY55" fmla="*/ 669957 h 683987"/>
                <a:gd name="connsiteX56" fmla="*/ 3766241 w 5135879"/>
                <a:gd name="connsiteY56" fmla="*/ 651850 h 683987"/>
                <a:gd name="connsiteX57" fmla="*/ 3485584 w 5135879"/>
                <a:gd name="connsiteY57" fmla="*/ 660903 h 683987"/>
                <a:gd name="connsiteX58" fmla="*/ 3431263 w 5135879"/>
                <a:gd name="connsiteY58" fmla="*/ 651850 h 683987"/>
                <a:gd name="connsiteX59" fmla="*/ 2833734 w 5135879"/>
                <a:gd name="connsiteY59" fmla="*/ 660903 h 683987"/>
                <a:gd name="connsiteX60" fmla="*/ 2544023 w 5135879"/>
                <a:gd name="connsiteY60" fmla="*/ 679010 h 683987"/>
                <a:gd name="connsiteX61" fmla="*/ 1638677 w 5135879"/>
                <a:gd name="connsiteY61" fmla="*/ 660903 h 683987"/>
                <a:gd name="connsiteX62" fmla="*/ 1539089 w 5135879"/>
                <a:gd name="connsiteY62" fmla="*/ 651850 h 683987"/>
                <a:gd name="connsiteX63" fmla="*/ 1502875 w 5135879"/>
                <a:gd name="connsiteY63" fmla="*/ 642796 h 683987"/>
                <a:gd name="connsiteX64" fmla="*/ 1358019 w 5135879"/>
                <a:gd name="connsiteY64" fmla="*/ 633743 h 683987"/>
                <a:gd name="connsiteX65" fmla="*/ 1312752 w 5135879"/>
                <a:gd name="connsiteY65" fmla="*/ 606582 h 683987"/>
                <a:gd name="connsiteX66" fmla="*/ 1050202 w 5135879"/>
                <a:gd name="connsiteY66" fmla="*/ 579422 h 683987"/>
                <a:gd name="connsiteX67" fmla="*/ 1013988 w 5135879"/>
                <a:gd name="connsiteY67" fmla="*/ 570369 h 683987"/>
                <a:gd name="connsiteX68" fmla="*/ 986827 w 5135879"/>
                <a:gd name="connsiteY68" fmla="*/ 561315 h 683987"/>
                <a:gd name="connsiteX69" fmla="*/ 488887 w 5135879"/>
                <a:gd name="connsiteY69" fmla="*/ 552262 h 683987"/>
                <a:gd name="connsiteX70" fmla="*/ 72427 w 5135879"/>
                <a:gd name="connsiteY70" fmla="*/ 534155 h 683987"/>
                <a:gd name="connsiteX71" fmla="*/ 54320 w 5135879"/>
                <a:gd name="connsiteY71" fmla="*/ 506994 h 683987"/>
                <a:gd name="connsiteX72" fmla="*/ 0 w 5135879"/>
                <a:gd name="connsiteY72" fmla="*/ 516048 h 683987"/>
                <a:gd name="connsiteX73" fmla="*/ 54320 w 5135879"/>
                <a:gd name="connsiteY73" fmla="*/ 525101 h 683987"/>
                <a:gd name="connsiteX74" fmla="*/ 90534 w 5135879"/>
                <a:gd name="connsiteY74" fmla="*/ 534155 h 683987"/>
                <a:gd name="connsiteX75" fmla="*/ 434566 w 5135879"/>
                <a:gd name="connsiteY75" fmla="*/ 525101 h 683987"/>
                <a:gd name="connsiteX76" fmla="*/ 552261 w 5135879"/>
                <a:gd name="connsiteY76" fmla="*/ 506994 h 683987"/>
                <a:gd name="connsiteX77" fmla="*/ 905346 w 5135879"/>
                <a:gd name="connsiteY77" fmla="*/ 488887 h 683987"/>
                <a:gd name="connsiteX78" fmla="*/ 932507 w 5135879"/>
                <a:gd name="connsiteY78" fmla="*/ 479834 h 683987"/>
                <a:gd name="connsiteX79" fmla="*/ 787651 w 5135879"/>
                <a:gd name="connsiteY79" fmla="*/ 461727 h 683987"/>
                <a:gd name="connsiteX80" fmla="*/ 706170 w 5135879"/>
                <a:gd name="connsiteY80" fmla="*/ 434567 h 683987"/>
                <a:gd name="connsiteX81" fmla="*/ 778598 w 5135879"/>
                <a:gd name="connsiteY81" fmla="*/ 425513 h 683987"/>
                <a:gd name="connsiteX82" fmla="*/ 905346 w 5135879"/>
                <a:gd name="connsiteY82" fmla="*/ 416460 h 683987"/>
                <a:gd name="connsiteX83" fmla="*/ 923453 w 5135879"/>
                <a:gd name="connsiteY83" fmla="*/ 380246 h 683987"/>
                <a:gd name="connsiteX84" fmla="*/ 1068309 w 5135879"/>
                <a:gd name="connsiteY84" fmla="*/ 371192 h 683987"/>
                <a:gd name="connsiteX85" fmla="*/ 1122629 w 5135879"/>
                <a:gd name="connsiteY85" fmla="*/ 362139 h 683987"/>
                <a:gd name="connsiteX86" fmla="*/ 968720 w 5135879"/>
                <a:gd name="connsiteY86" fmla="*/ 353085 h 683987"/>
                <a:gd name="connsiteX87" fmla="*/ 995881 w 5135879"/>
                <a:gd name="connsiteY87" fmla="*/ 334978 h 683987"/>
                <a:gd name="connsiteX88" fmla="*/ 1041148 w 5135879"/>
                <a:gd name="connsiteY88" fmla="*/ 316871 h 683987"/>
                <a:gd name="connsiteX89" fmla="*/ 1258431 w 5135879"/>
                <a:gd name="connsiteY89" fmla="*/ 307818 h 683987"/>
                <a:gd name="connsiteX90" fmla="*/ 1339913 w 5135879"/>
                <a:gd name="connsiteY90" fmla="*/ 298765 h 683987"/>
                <a:gd name="connsiteX91" fmla="*/ 1403287 w 5135879"/>
                <a:gd name="connsiteY91" fmla="*/ 280658 h 683987"/>
                <a:gd name="connsiteX92" fmla="*/ 1430447 w 5135879"/>
                <a:gd name="connsiteY92" fmla="*/ 262551 h 683987"/>
                <a:gd name="connsiteX93" fmla="*/ 1457608 w 5135879"/>
                <a:gd name="connsiteY93" fmla="*/ 235390 h 683987"/>
                <a:gd name="connsiteX94" fmla="*/ 1530035 w 5135879"/>
                <a:gd name="connsiteY94" fmla="*/ 226337 h 683987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  <a:cxn ang="0">
                  <a:pos x="connsiteX19" y="connsiteY19"/>
                </a:cxn>
                <a:cxn ang="0">
                  <a:pos x="connsiteX20" y="connsiteY20"/>
                </a:cxn>
                <a:cxn ang="0">
                  <a:pos x="connsiteX21" y="connsiteY21"/>
                </a:cxn>
                <a:cxn ang="0">
                  <a:pos x="connsiteX22" y="connsiteY22"/>
                </a:cxn>
                <a:cxn ang="0">
                  <a:pos x="connsiteX23" y="connsiteY23"/>
                </a:cxn>
                <a:cxn ang="0">
                  <a:pos x="connsiteX24" y="connsiteY24"/>
                </a:cxn>
                <a:cxn ang="0">
                  <a:pos x="connsiteX25" y="connsiteY25"/>
                </a:cxn>
                <a:cxn ang="0">
                  <a:pos x="connsiteX26" y="connsiteY26"/>
                </a:cxn>
                <a:cxn ang="0">
                  <a:pos x="connsiteX27" y="connsiteY27"/>
                </a:cxn>
                <a:cxn ang="0">
                  <a:pos x="connsiteX28" y="connsiteY28"/>
                </a:cxn>
                <a:cxn ang="0">
                  <a:pos x="connsiteX29" y="connsiteY29"/>
                </a:cxn>
                <a:cxn ang="0">
                  <a:pos x="connsiteX30" y="connsiteY30"/>
                </a:cxn>
                <a:cxn ang="0">
                  <a:pos x="connsiteX31" y="connsiteY31"/>
                </a:cxn>
                <a:cxn ang="0">
                  <a:pos x="connsiteX32" y="connsiteY32"/>
                </a:cxn>
                <a:cxn ang="0">
                  <a:pos x="connsiteX33" y="connsiteY33"/>
                </a:cxn>
                <a:cxn ang="0">
                  <a:pos x="connsiteX34" y="connsiteY34"/>
                </a:cxn>
                <a:cxn ang="0">
                  <a:pos x="connsiteX35" y="connsiteY35"/>
                </a:cxn>
                <a:cxn ang="0">
                  <a:pos x="connsiteX36" y="connsiteY36"/>
                </a:cxn>
                <a:cxn ang="0">
                  <a:pos x="connsiteX37" y="connsiteY37"/>
                </a:cxn>
                <a:cxn ang="0">
                  <a:pos x="connsiteX38" y="connsiteY38"/>
                </a:cxn>
                <a:cxn ang="0">
                  <a:pos x="connsiteX39" y="connsiteY39"/>
                </a:cxn>
                <a:cxn ang="0">
                  <a:pos x="connsiteX40" y="connsiteY40"/>
                </a:cxn>
                <a:cxn ang="0">
                  <a:pos x="connsiteX41" y="connsiteY41"/>
                </a:cxn>
                <a:cxn ang="0">
                  <a:pos x="connsiteX42" y="connsiteY42"/>
                </a:cxn>
                <a:cxn ang="0">
                  <a:pos x="connsiteX43" y="connsiteY43"/>
                </a:cxn>
                <a:cxn ang="0">
                  <a:pos x="connsiteX44" y="connsiteY44"/>
                </a:cxn>
                <a:cxn ang="0">
                  <a:pos x="connsiteX45" y="connsiteY45"/>
                </a:cxn>
                <a:cxn ang="0">
                  <a:pos x="connsiteX46" y="connsiteY46"/>
                </a:cxn>
                <a:cxn ang="0">
                  <a:pos x="connsiteX47" y="connsiteY47"/>
                </a:cxn>
                <a:cxn ang="0">
                  <a:pos x="connsiteX48" y="connsiteY48"/>
                </a:cxn>
                <a:cxn ang="0">
                  <a:pos x="connsiteX49" y="connsiteY49"/>
                </a:cxn>
                <a:cxn ang="0">
                  <a:pos x="connsiteX50" y="connsiteY50"/>
                </a:cxn>
                <a:cxn ang="0">
                  <a:pos x="connsiteX51" y="connsiteY51"/>
                </a:cxn>
                <a:cxn ang="0">
                  <a:pos x="connsiteX52" y="connsiteY52"/>
                </a:cxn>
                <a:cxn ang="0">
                  <a:pos x="connsiteX53" y="connsiteY53"/>
                </a:cxn>
                <a:cxn ang="0">
                  <a:pos x="connsiteX54" y="connsiteY54"/>
                </a:cxn>
                <a:cxn ang="0">
                  <a:pos x="connsiteX55" y="connsiteY55"/>
                </a:cxn>
                <a:cxn ang="0">
                  <a:pos x="connsiteX56" y="connsiteY56"/>
                </a:cxn>
                <a:cxn ang="0">
                  <a:pos x="connsiteX57" y="connsiteY57"/>
                </a:cxn>
                <a:cxn ang="0">
                  <a:pos x="connsiteX58" y="connsiteY58"/>
                </a:cxn>
                <a:cxn ang="0">
                  <a:pos x="connsiteX59" y="connsiteY59"/>
                </a:cxn>
                <a:cxn ang="0">
                  <a:pos x="connsiteX60" y="connsiteY60"/>
                </a:cxn>
                <a:cxn ang="0">
                  <a:pos x="connsiteX61" y="connsiteY61"/>
                </a:cxn>
                <a:cxn ang="0">
                  <a:pos x="connsiteX62" y="connsiteY62"/>
                </a:cxn>
                <a:cxn ang="0">
                  <a:pos x="connsiteX63" y="connsiteY63"/>
                </a:cxn>
                <a:cxn ang="0">
                  <a:pos x="connsiteX64" y="connsiteY64"/>
                </a:cxn>
                <a:cxn ang="0">
                  <a:pos x="connsiteX65" y="connsiteY65"/>
                </a:cxn>
                <a:cxn ang="0">
                  <a:pos x="connsiteX66" y="connsiteY66"/>
                </a:cxn>
                <a:cxn ang="0">
                  <a:pos x="connsiteX67" y="connsiteY67"/>
                </a:cxn>
                <a:cxn ang="0">
                  <a:pos x="connsiteX68" y="connsiteY68"/>
                </a:cxn>
                <a:cxn ang="0">
                  <a:pos x="connsiteX69" y="connsiteY69"/>
                </a:cxn>
                <a:cxn ang="0">
                  <a:pos x="connsiteX70" y="connsiteY70"/>
                </a:cxn>
                <a:cxn ang="0">
                  <a:pos x="connsiteX71" y="connsiteY71"/>
                </a:cxn>
                <a:cxn ang="0">
                  <a:pos x="connsiteX72" y="connsiteY72"/>
                </a:cxn>
                <a:cxn ang="0">
                  <a:pos x="connsiteX73" y="connsiteY73"/>
                </a:cxn>
                <a:cxn ang="0">
                  <a:pos x="connsiteX74" y="connsiteY74"/>
                </a:cxn>
                <a:cxn ang="0">
                  <a:pos x="connsiteX75" y="connsiteY75"/>
                </a:cxn>
                <a:cxn ang="0">
                  <a:pos x="connsiteX76" y="connsiteY76"/>
                </a:cxn>
                <a:cxn ang="0">
                  <a:pos x="connsiteX77" y="connsiteY77"/>
                </a:cxn>
                <a:cxn ang="0">
                  <a:pos x="connsiteX78" y="connsiteY78"/>
                </a:cxn>
                <a:cxn ang="0">
                  <a:pos x="connsiteX79" y="connsiteY79"/>
                </a:cxn>
                <a:cxn ang="0">
                  <a:pos x="connsiteX80" y="connsiteY80"/>
                </a:cxn>
                <a:cxn ang="0">
                  <a:pos x="connsiteX81" y="connsiteY81"/>
                </a:cxn>
                <a:cxn ang="0">
                  <a:pos x="connsiteX82" y="connsiteY82"/>
                </a:cxn>
                <a:cxn ang="0">
                  <a:pos x="connsiteX83" y="connsiteY83"/>
                </a:cxn>
                <a:cxn ang="0">
                  <a:pos x="connsiteX84" y="connsiteY84"/>
                </a:cxn>
                <a:cxn ang="0">
                  <a:pos x="connsiteX85" y="connsiteY85"/>
                </a:cxn>
                <a:cxn ang="0">
                  <a:pos x="connsiteX86" y="connsiteY86"/>
                </a:cxn>
                <a:cxn ang="0">
                  <a:pos x="connsiteX87" y="connsiteY87"/>
                </a:cxn>
                <a:cxn ang="0">
                  <a:pos x="connsiteX88" y="connsiteY88"/>
                </a:cxn>
                <a:cxn ang="0">
                  <a:pos x="connsiteX89" y="connsiteY89"/>
                </a:cxn>
                <a:cxn ang="0">
                  <a:pos x="connsiteX90" y="connsiteY90"/>
                </a:cxn>
                <a:cxn ang="0">
                  <a:pos x="connsiteX91" y="connsiteY91"/>
                </a:cxn>
                <a:cxn ang="0">
                  <a:pos x="connsiteX92" y="connsiteY92"/>
                </a:cxn>
                <a:cxn ang="0">
                  <a:pos x="connsiteX93" y="connsiteY93"/>
                </a:cxn>
                <a:cxn ang="0">
                  <a:pos x="connsiteX94" y="connsiteY94"/>
                </a:cxn>
              </a:cxnLst>
              <a:rect l="l" t="t" r="r" b="b"/>
              <a:pathLst>
                <a:path w="5135879" h="683987">
                  <a:moveTo>
                    <a:pt x="1439501" y="253497"/>
                  </a:moveTo>
                  <a:cubicBezTo>
                    <a:pt x="1454590" y="238408"/>
                    <a:pt x="1468709" y="222282"/>
                    <a:pt x="1484768" y="208230"/>
                  </a:cubicBezTo>
                  <a:cubicBezTo>
                    <a:pt x="1492957" y="201065"/>
                    <a:pt x="1502481" y="195521"/>
                    <a:pt x="1511928" y="190123"/>
                  </a:cubicBezTo>
                  <a:cubicBezTo>
                    <a:pt x="1543254" y="172222"/>
                    <a:pt x="1544831" y="173120"/>
                    <a:pt x="1575303" y="162963"/>
                  </a:cubicBezTo>
                  <a:cubicBezTo>
                    <a:pt x="1591617" y="146648"/>
                    <a:pt x="1607565" y="127148"/>
                    <a:pt x="1629623" y="117695"/>
                  </a:cubicBezTo>
                  <a:cubicBezTo>
                    <a:pt x="1641060" y="112794"/>
                    <a:pt x="1653873" y="112060"/>
                    <a:pt x="1665837" y="108642"/>
                  </a:cubicBezTo>
                  <a:cubicBezTo>
                    <a:pt x="1675013" y="106020"/>
                    <a:pt x="1683542" y="100877"/>
                    <a:pt x="1692998" y="99588"/>
                  </a:cubicBezTo>
                  <a:cubicBezTo>
                    <a:pt x="1750125" y="91798"/>
                    <a:pt x="1865014" y="81481"/>
                    <a:pt x="1865014" y="81481"/>
                  </a:cubicBezTo>
                  <a:cubicBezTo>
                    <a:pt x="1983445" y="51874"/>
                    <a:pt x="1850668" y="82437"/>
                    <a:pt x="2136617" y="63374"/>
                  </a:cubicBezTo>
                  <a:cubicBezTo>
                    <a:pt x="2149032" y="62546"/>
                    <a:pt x="2160630" y="56761"/>
                    <a:pt x="2172831" y="54321"/>
                  </a:cubicBezTo>
                  <a:cubicBezTo>
                    <a:pt x="2190831" y="50721"/>
                    <a:pt x="2209045" y="48286"/>
                    <a:pt x="2227152" y="45268"/>
                  </a:cubicBezTo>
                  <a:cubicBezTo>
                    <a:pt x="2284915" y="6760"/>
                    <a:pt x="2234694" y="34001"/>
                    <a:pt x="2353901" y="18107"/>
                  </a:cubicBezTo>
                  <a:cubicBezTo>
                    <a:pt x="2372854" y="15580"/>
                    <a:pt x="2398650" y="6209"/>
                    <a:pt x="2417275" y="0"/>
                  </a:cubicBezTo>
                  <a:lnTo>
                    <a:pt x="2996697" y="9054"/>
                  </a:lnTo>
                  <a:cubicBezTo>
                    <a:pt x="3042050" y="10202"/>
                    <a:pt x="3087748" y="10649"/>
                    <a:pt x="3132499" y="18107"/>
                  </a:cubicBezTo>
                  <a:cubicBezTo>
                    <a:pt x="3143232" y="19896"/>
                    <a:pt x="3149927" y="31348"/>
                    <a:pt x="3159659" y="36214"/>
                  </a:cubicBezTo>
                  <a:cubicBezTo>
                    <a:pt x="3200486" y="56628"/>
                    <a:pt x="3175065" y="30946"/>
                    <a:pt x="3213980" y="63374"/>
                  </a:cubicBezTo>
                  <a:cubicBezTo>
                    <a:pt x="3259193" y="101051"/>
                    <a:pt x="3220567" y="83678"/>
                    <a:pt x="3268301" y="99588"/>
                  </a:cubicBezTo>
                  <a:cubicBezTo>
                    <a:pt x="3277354" y="105624"/>
                    <a:pt x="3284822" y="115415"/>
                    <a:pt x="3295461" y="117695"/>
                  </a:cubicBezTo>
                  <a:cubicBezTo>
                    <a:pt x="3328054" y="124679"/>
                    <a:pt x="3362051" y="122035"/>
                    <a:pt x="3395049" y="126749"/>
                  </a:cubicBezTo>
                  <a:cubicBezTo>
                    <a:pt x="3404496" y="128099"/>
                    <a:pt x="3413156" y="132784"/>
                    <a:pt x="3422210" y="135802"/>
                  </a:cubicBezTo>
                  <a:cubicBezTo>
                    <a:pt x="3431263" y="144856"/>
                    <a:pt x="3441173" y="153127"/>
                    <a:pt x="3449370" y="162963"/>
                  </a:cubicBezTo>
                  <a:cubicBezTo>
                    <a:pt x="3456336" y="171322"/>
                    <a:pt x="3459288" y="182958"/>
                    <a:pt x="3467477" y="190123"/>
                  </a:cubicBezTo>
                  <a:cubicBezTo>
                    <a:pt x="3483855" y="204453"/>
                    <a:pt x="3506410" y="210949"/>
                    <a:pt x="3521798" y="226337"/>
                  </a:cubicBezTo>
                  <a:cubicBezTo>
                    <a:pt x="3530851" y="235390"/>
                    <a:pt x="3537070" y="248742"/>
                    <a:pt x="3548958" y="253497"/>
                  </a:cubicBezTo>
                  <a:cubicBezTo>
                    <a:pt x="3568771" y="261422"/>
                    <a:pt x="3591207" y="259533"/>
                    <a:pt x="3612332" y="262551"/>
                  </a:cubicBezTo>
                  <a:cubicBezTo>
                    <a:pt x="3677461" y="284259"/>
                    <a:pt x="3596122" y="257919"/>
                    <a:pt x="3675707" y="280658"/>
                  </a:cubicBezTo>
                  <a:cubicBezTo>
                    <a:pt x="3684883" y="283280"/>
                    <a:pt x="3693568" y="287565"/>
                    <a:pt x="3702867" y="289711"/>
                  </a:cubicBezTo>
                  <a:cubicBezTo>
                    <a:pt x="3732855" y="296631"/>
                    <a:pt x="3764205" y="298086"/>
                    <a:pt x="3793402" y="307818"/>
                  </a:cubicBezTo>
                  <a:cubicBezTo>
                    <a:pt x="3859526" y="329860"/>
                    <a:pt x="3829206" y="321296"/>
                    <a:pt x="3883936" y="334978"/>
                  </a:cubicBezTo>
                  <a:cubicBezTo>
                    <a:pt x="3896007" y="341014"/>
                    <a:pt x="3907745" y="347769"/>
                    <a:pt x="3920150" y="353085"/>
                  </a:cubicBezTo>
                  <a:cubicBezTo>
                    <a:pt x="3928922" y="356844"/>
                    <a:pt x="3938135" y="359517"/>
                    <a:pt x="3947311" y="362139"/>
                  </a:cubicBezTo>
                  <a:cubicBezTo>
                    <a:pt x="4038255" y="388123"/>
                    <a:pt x="4061951" y="374460"/>
                    <a:pt x="4200808" y="380246"/>
                  </a:cubicBezTo>
                  <a:lnTo>
                    <a:pt x="4409037" y="398353"/>
                  </a:lnTo>
                  <a:cubicBezTo>
                    <a:pt x="4430271" y="400476"/>
                    <a:pt x="4451417" y="403589"/>
                    <a:pt x="4472412" y="407406"/>
                  </a:cubicBezTo>
                  <a:cubicBezTo>
                    <a:pt x="4484654" y="409632"/>
                    <a:pt x="4496279" y="414917"/>
                    <a:pt x="4508625" y="416460"/>
                  </a:cubicBezTo>
                  <a:cubicBezTo>
                    <a:pt x="4568814" y="423984"/>
                    <a:pt x="4629108" y="431635"/>
                    <a:pt x="4689695" y="434567"/>
                  </a:cubicBezTo>
                  <a:cubicBezTo>
                    <a:pt x="4816331" y="440694"/>
                    <a:pt x="4943192" y="440602"/>
                    <a:pt x="5069940" y="443620"/>
                  </a:cubicBezTo>
                  <a:cubicBezTo>
                    <a:pt x="5078994" y="446638"/>
                    <a:pt x="5087558" y="452673"/>
                    <a:pt x="5097101" y="452673"/>
                  </a:cubicBezTo>
                  <a:cubicBezTo>
                    <a:pt x="5109544" y="452673"/>
                    <a:pt x="5145758" y="443620"/>
                    <a:pt x="5133315" y="443620"/>
                  </a:cubicBezTo>
                  <a:cubicBezTo>
                    <a:pt x="5111976" y="443620"/>
                    <a:pt x="5091065" y="449655"/>
                    <a:pt x="5069940" y="452673"/>
                  </a:cubicBezTo>
                  <a:cubicBezTo>
                    <a:pt x="5060887" y="455691"/>
                    <a:pt x="5052038" y="459412"/>
                    <a:pt x="5042780" y="461727"/>
                  </a:cubicBezTo>
                  <a:cubicBezTo>
                    <a:pt x="5027852" y="465459"/>
                    <a:pt x="5012534" y="467442"/>
                    <a:pt x="4997513" y="470780"/>
                  </a:cubicBezTo>
                  <a:cubicBezTo>
                    <a:pt x="4985366" y="473479"/>
                    <a:pt x="4973370" y="476816"/>
                    <a:pt x="4961299" y="479834"/>
                  </a:cubicBezTo>
                  <a:cubicBezTo>
                    <a:pt x="4882986" y="532041"/>
                    <a:pt x="4962822" y="485491"/>
                    <a:pt x="4762122" y="506994"/>
                  </a:cubicBezTo>
                  <a:cubicBezTo>
                    <a:pt x="4734457" y="509958"/>
                    <a:pt x="4707801" y="519065"/>
                    <a:pt x="4680641" y="525101"/>
                  </a:cubicBezTo>
                  <a:lnTo>
                    <a:pt x="4164594" y="516048"/>
                  </a:lnTo>
                  <a:cubicBezTo>
                    <a:pt x="4155051" y="516048"/>
                    <a:pt x="4146964" y="524612"/>
                    <a:pt x="4137433" y="525101"/>
                  </a:cubicBezTo>
                  <a:cubicBezTo>
                    <a:pt x="4028892" y="530667"/>
                    <a:pt x="3920150" y="531137"/>
                    <a:pt x="3811509" y="534155"/>
                  </a:cubicBezTo>
                  <a:cubicBezTo>
                    <a:pt x="3834871" y="537492"/>
                    <a:pt x="3876758" y="539619"/>
                    <a:pt x="3902043" y="552262"/>
                  </a:cubicBezTo>
                  <a:cubicBezTo>
                    <a:pt x="3911775" y="557128"/>
                    <a:pt x="3919160" y="566184"/>
                    <a:pt x="3929204" y="570369"/>
                  </a:cubicBezTo>
                  <a:cubicBezTo>
                    <a:pt x="3961487" y="583820"/>
                    <a:pt x="4009423" y="598254"/>
                    <a:pt x="4046899" y="606582"/>
                  </a:cubicBezTo>
                  <a:cubicBezTo>
                    <a:pt x="4061920" y="609920"/>
                    <a:pt x="4077077" y="612618"/>
                    <a:pt x="4092166" y="615636"/>
                  </a:cubicBezTo>
                  <a:cubicBezTo>
                    <a:pt x="4111799" y="625452"/>
                    <a:pt x="4133336" y="638355"/>
                    <a:pt x="4155540" y="642796"/>
                  </a:cubicBezTo>
                  <a:cubicBezTo>
                    <a:pt x="4176465" y="646981"/>
                    <a:pt x="4197790" y="648832"/>
                    <a:pt x="4218915" y="651850"/>
                  </a:cubicBezTo>
                  <a:cubicBezTo>
                    <a:pt x="4209861" y="657886"/>
                    <a:pt x="4202633" y="669721"/>
                    <a:pt x="4191754" y="669957"/>
                  </a:cubicBezTo>
                  <a:cubicBezTo>
                    <a:pt x="3856540" y="677244"/>
                    <a:pt x="3922004" y="690789"/>
                    <a:pt x="3766241" y="651850"/>
                  </a:cubicBezTo>
                  <a:cubicBezTo>
                    <a:pt x="3672689" y="654868"/>
                    <a:pt x="3579185" y="660903"/>
                    <a:pt x="3485584" y="660903"/>
                  </a:cubicBezTo>
                  <a:cubicBezTo>
                    <a:pt x="3467227" y="660903"/>
                    <a:pt x="3449620" y="651850"/>
                    <a:pt x="3431263" y="651850"/>
                  </a:cubicBezTo>
                  <a:cubicBezTo>
                    <a:pt x="3232064" y="651850"/>
                    <a:pt x="3032910" y="657885"/>
                    <a:pt x="2833734" y="660903"/>
                  </a:cubicBezTo>
                  <a:cubicBezTo>
                    <a:pt x="2727171" y="696427"/>
                    <a:pt x="2782424" y="680858"/>
                    <a:pt x="2544023" y="679010"/>
                  </a:cubicBezTo>
                  <a:cubicBezTo>
                    <a:pt x="2242190" y="676670"/>
                    <a:pt x="1940459" y="666939"/>
                    <a:pt x="1638677" y="660903"/>
                  </a:cubicBezTo>
                  <a:cubicBezTo>
                    <a:pt x="1605481" y="657885"/>
                    <a:pt x="1572129" y="656255"/>
                    <a:pt x="1539089" y="651850"/>
                  </a:cubicBezTo>
                  <a:cubicBezTo>
                    <a:pt x="1526755" y="650205"/>
                    <a:pt x="1515256" y="644034"/>
                    <a:pt x="1502875" y="642796"/>
                  </a:cubicBezTo>
                  <a:cubicBezTo>
                    <a:pt x="1454736" y="637982"/>
                    <a:pt x="1406304" y="636761"/>
                    <a:pt x="1358019" y="633743"/>
                  </a:cubicBezTo>
                  <a:cubicBezTo>
                    <a:pt x="1342930" y="624689"/>
                    <a:pt x="1329176" y="612899"/>
                    <a:pt x="1312752" y="606582"/>
                  </a:cubicBezTo>
                  <a:cubicBezTo>
                    <a:pt x="1232293" y="575636"/>
                    <a:pt x="1128733" y="583161"/>
                    <a:pt x="1050202" y="579422"/>
                  </a:cubicBezTo>
                  <a:cubicBezTo>
                    <a:pt x="1038131" y="576404"/>
                    <a:pt x="1025952" y="573787"/>
                    <a:pt x="1013988" y="570369"/>
                  </a:cubicBezTo>
                  <a:cubicBezTo>
                    <a:pt x="1004812" y="567747"/>
                    <a:pt x="996365" y="561644"/>
                    <a:pt x="986827" y="561315"/>
                  </a:cubicBezTo>
                  <a:cubicBezTo>
                    <a:pt x="820918" y="555594"/>
                    <a:pt x="654867" y="555280"/>
                    <a:pt x="488887" y="552262"/>
                  </a:cubicBezTo>
                  <a:cubicBezTo>
                    <a:pt x="313421" y="508393"/>
                    <a:pt x="630724" y="584909"/>
                    <a:pt x="72427" y="534155"/>
                  </a:cubicBezTo>
                  <a:cubicBezTo>
                    <a:pt x="61591" y="533170"/>
                    <a:pt x="60356" y="516048"/>
                    <a:pt x="54320" y="506994"/>
                  </a:cubicBezTo>
                  <a:lnTo>
                    <a:pt x="0" y="516048"/>
                  </a:lnTo>
                  <a:cubicBezTo>
                    <a:pt x="0" y="534404"/>
                    <a:pt x="36320" y="521501"/>
                    <a:pt x="54320" y="525101"/>
                  </a:cubicBezTo>
                  <a:cubicBezTo>
                    <a:pt x="66521" y="527541"/>
                    <a:pt x="78463" y="531137"/>
                    <a:pt x="90534" y="534155"/>
                  </a:cubicBezTo>
                  <a:lnTo>
                    <a:pt x="434566" y="525101"/>
                  </a:lnTo>
                  <a:cubicBezTo>
                    <a:pt x="811578" y="509392"/>
                    <a:pt x="409175" y="527435"/>
                    <a:pt x="552261" y="506994"/>
                  </a:cubicBezTo>
                  <a:cubicBezTo>
                    <a:pt x="646932" y="493469"/>
                    <a:pt x="844608" y="491056"/>
                    <a:pt x="905346" y="488887"/>
                  </a:cubicBezTo>
                  <a:cubicBezTo>
                    <a:pt x="914400" y="485869"/>
                    <a:pt x="941561" y="482852"/>
                    <a:pt x="932507" y="479834"/>
                  </a:cubicBezTo>
                  <a:cubicBezTo>
                    <a:pt x="868018" y="458337"/>
                    <a:pt x="914861" y="471512"/>
                    <a:pt x="787651" y="461727"/>
                  </a:cubicBezTo>
                  <a:cubicBezTo>
                    <a:pt x="784395" y="460913"/>
                    <a:pt x="699353" y="441384"/>
                    <a:pt x="706170" y="434567"/>
                  </a:cubicBezTo>
                  <a:cubicBezTo>
                    <a:pt x="723375" y="417363"/>
                    <a:pt x="754367" y="427716"/>
                    <a:pt x="778598" y="425513"/>
                  </a:cubicBezTo>
                  <a:cubicBezTo>
                    <a:pt x="820781" y="421678"/>
                    <a:pt x="863097" y="419478"/>
                    <a:pt x="905346" y="416460"/>
                  </a:cubicBezTo>
                  <a:cubicBezTo>
                    <a:pt x="911382" y="404389"/>
                    <a:pt x="910449" y="383858"/>
                    <a:pt x="923453" y="380246"/>
                  </a:cubicBezTo>
                  <a:cubicBezTo>
                    <a:pt x="970068" y="367297"/>
                    <a:pt x="1020128" y="375572"/>
                    <a:pt x="1068309" y="371192"/>
                  </a:cubicBezTo>
                  <a:cubicBezTo>
                    <a:pt x="1086590" y="369530"/>
                    <a:pt x="1104522" y="365157"/>
                    <a:pt x="1122629" y="362139"/>
                  </a:cubicBezTo>
                  <a:cubicBezTo>
                    <a:pt x="1071326" y="359121"/>
                    <a:pt x="1018971" y="363853"/>
                    <a:pt x="968720" y="353085"/>
                  </a:cubicBezTo>
                  <a:cubicBezTo>
                    <a:pt x="958080" y="350805"/>
                    <a:pt x="986149" y="339844"/>
                    <a:pt x="995881" y="334978"/>
                  </a:cubicBezTo>
                  <a:cubicBezTo>
                    <a:pt x="1010417" y="327710"/>
                    <a:pt x="1024983" y="318543"/>
                    <a:pt x="1041148" y="316871"/>
                  </a:cubicBezTo>
                  <a:cubicBezTo>
                    <a:pt x="1113254" y="309412"/>
                    <a:pt x="1186003" y="310836"/>
                    <a:pt x="1258431" y="307818"/>
                  </a:cubicBezTo>
                  <a:cubicBezTo>
                    <a:pt x="1285592" y="304800"/>
                    <a:pt x="1312903" y="302920"/>
                    <a:pt x="1339913" y="298765"/>
                  </a:cubicBezTo>
                  <a:cubicBezTo>
                    <a:pt x="1361016" y="295518"/>
                    <a:pt x="1383012" y="287416"/>
                    <a:pt x="1403287" y="280658"/>
                  </a:cubicBezTo>
                  <a:cubicBezTo>
                    <a:pt x="1412340" y="274622"/>
                    <a:pt x="1422088" y="269517"/>
                    <a:pt x="1430447" y="262551"/>
                  </a:cubicBezTo>
                  <a:cubicBezTo>
                    <a:pt x="1440283" y="254354"/>
                    <a:pt x="1446491" y="241743"/>
                    <a:pt x="1457608" y="235390"/>
                  </a:cubicBezTo>
                  <a:cubicBezTo>
                    <a:pt x="1478574" y="223409"/>
                    <a:pt x="1507532" y="226337"/>
                    <a:pt x="1530035" y="226337"/>
                  </a:cubicBezTo>
                </a:path>
              </a:pathLst>
            </a:custGeom>
            <a:grpFill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endParaRPr lang="en-US" sz="110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endParaRPr>
            </a:p>
          </p:txBody>
        </p:sp>
        <p:sp>
          <p:nvSpPr>
            <p:cNvPr id="77" name="Oval 76"/>
            <p:cNvSpPr/>
            <p:nvPr/>
          </p:nvSpPr>
          <p:spPr>
            <a:xfrm>
              <a:off x="990600" y="609600"/>
              <a:ext cx="1219200" cy="463045"/>
            </a:xfrm>
            <a:prstGeom prst="ellipse">
              <a:avLst/>
            </a:prstGeom>
            <a:solidFill>
              <a:schemeClr val="bg1">
                <a:lumMod val="85000"/>
              </a:schemeClr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sz="1200" b="1" dirty="0" smtClean="0">
                  <a:solidFill>
                    <a:schemeClr val="tx1"/>
                  </a:solidFill>
                  <a:latin typeface="Arial Unicode MS" panose="020B0604020202020204" pitchFamily="34" charset="-122"/>
                  <a:ea typeface="Arial Unicode MS" panose="020B0604020202020204" pitchFamily="34" charset="-122"/>
                  <a:cs typeface="Arial Unicode MS" panose="020B0604020202020204" pitchFamily="34" charset="-122"/>
                </a:rPr>
                <a:t>WT</a:t>
              </a:r>
              <a:endParaRPr lang="en-US" sz="1200" b="1" dirty="0">
                <a:solidFill>
                  <a:schemeClr val="tx1"/>
                </a:solidFill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endParaRPr>
            </a:p>
          </p:txBody>
        </p:sp>
      </p:grpSp>
      <p:grpSp>
        <p:nvGrpSpPr>
          <p:cNvPr id="78" name="Group 77"/>
          <p:cNvGrpSpPr/>
          <p:nvPr/>
        </p:nvGrpSpPr>
        <p:grpSpPr>
          <a:xfrm>
            <a:off x="0" y="5355216"/>
            <a:ext cx="2813741" cy="717557"/>
            <a:chOff x="228600" y="505223"/>
            <a:chExt cx="2796766" cy="637778"/>
          </a:xfrm>
          <a:solidFill>
            <a:schemeClr val="bg1"/>
          </a:solidFill>
        </p:grpSpPr>
        <p:sp>
          <p:nvSpPr>
            <p:cNvPr id="79" name="Freeform 78"/>
            <p:cNvSpPr/>
            <p:nvPr/>
          </p:nvSpPr>
          <p:spPr>
            <a:xfrm>
              <a:off x="228600" y="505223"/>
              <a:ext cx="2796766" cy="637778"/>
            </a:xfrm>
            <a:custGeom>
              <a:avLst/>
              <a:gdLst>
                <a:gd name="connsiteX0" fmla="*/ 1439501 w 5135879"/>
                <a:gd name="connsiteY0" fmla="*/ 253497 h 683987"/>
                <a:gd name="connsiteX1" fmla="*/ 1484768 w 5135879"/>
                <a:gd name="connsiteY1" fmla="*/ 208230 h 683987"/>
                <a:gd name="connsiteX2" fmla="*/ 1511928 w 5135879"/>
                <a:gd name="connsiteY2" fmla="*/ 190123 h 683987"/>
                <a:gd name="connsiteX3" fmla="*/ 1575303 w 5135879"/>
                <a:gd name="connsiteY3" fmla="*/ 162963 h 683987"/>
                <a:gd name="connsiteX4" fmla="*/ 1629623 w 5135879"/>
                <a:gd name="connsiteY4" fmla="*/ 117695 h 683987"/>
                <a:gd name="connsiteX5" fmla="*/ 1665837 w 5135879"/>
                <a:gd name="connsiteY5" fmla="*/ 108642 h 683987"/>
                <a:gd name="connsiteX6" fmla="*/ 1692998 w 5135879"/>
                <a:gd name="connsiteY6" fmla="*/ 99588 h 683987"/>
                <a:gd name="connsiteX7" fmla="*/ 1865014 w 5135879"/>
                <a:gd name="connsiteY7" fmla="*/ 81481 h 683987"/>
                <a:gd name="connsiteX8" fmla="*/ 2136617 w 5135879"/>
                <a:gd name="connsiteY8" fmla="*/ 63374 h 683987"/>
                <a:gd name="connsiteX9" fmla="*/ 2172831 w 5135879"/>
                <a:gd name="connsiteY9" fmla="*/ 54321 h 683987"/>
                <a:gd name="connsiteX10" fmla="*/ 2227152 w 5135879"/>
                <a:gd name="connsiteY10" fmla="*/ 45268 h 683987"/>
                <a:gd name="connsiteX11" fmla="*/ 2353901 w 5135879"/>
                <a:gd name="connsiteY11" fmla="*/ 18107 h 683987"/>
                <a:gd name="connsiteX12" fmla="*/ 2417275 w 5135879"/>
                <a:gd name="connsiteY12" fmla="*/ 0 h 683987"/>
                <a:gd name="connsiteX13" fmla="*/ 2996697 w 5135879"/>
                <a:gd name="connsiteY13" fmla="*/ 9054 h 683987"/>
                <a:gd name="connsiteX14" fmla="*/ 3132499 w 5135879"/>
                <a:gd name="connsiteY14" fmla="*/ 18107 h 683987"/>
                <a:gd name="connsiteX15" fmla="*/ 3159659 w 5135879"/>
                <a:gd name="connsiteY15" fmla="*/ 36214 h 683987"/>
                <a:gd name="connsiteX16" fmla="*/ 3213980 w 5135879"/>
                <a:gd name="connsiteY16" fmla="*/ 63374 h 683987"/>
                <a:gd name="connsiteX17" fmla="*/ 3268301 w 5135879"/>
                <a:gd name="connsiteY17" fmla="*/ 99588 h 683987"/>
                <a:gd name="connsiteX18" fmla="*/ 3295461 w 5135879"/>
                <a:gd name="connsiteY18" fmla="*/ 117695 h 683987"/>
                <a:gd name="connsiteX19" fmla="*/ 3395049 w 5135879"/>
                <a:gd name="connsiteY19" fmla="*/ 126749 h 683987"/>
                <a:gd name="connsiteX20" fmla="*/ 3422210 w 5135879"/>
                <a:gd name="connsiteY20" fmla="*/ 135802 h 683987"/>
                <a:gd name="connsiteX21" fmla="*/ 3449370 w 5135879"/>
                <a:gd name="connsiteY21" fmla="*/ 162963 h 683987"/>
                <a:gd name="connsiteX22" fmla="*/ 3467477 w 5135879"/>
                <a:gd name="connsiteY22" fmla="*/ 190123 h 683987"/>
                <a:gd name="connsiteX23" fmla="*/ 3521798 w 5135879"/>
                <a:gd name="connsiteY23" fmla="*/ 226337 h 683987"/>
                <a:gd name="connsiteX24" fmla="*/ 3548958 w 5135879"/>
                <a:gd name="connsiteY24" fmla="*/ 253497 h 683987"/>
                <a:gd name="connsiteX25" fmla="*/ 3612332 w 5135879"/>
                <a:gd name="connsiteY25" fmla="*/ 262551 h 683987"/>
                <a:gd name="connsiteX26" fmla="*/ 3675707 w 5135879"/>
                <a:gd name="connsiteY26" fmla="*/ 280658 h 683987"/>
                <a:gd name="connsiteX27" fmla="*/ 3702867 w 5135879"/>
                <a:gd name="connsiteY27" fmla="*/ 289711 h 683987"/>
                <a:gd name="connsiteX28" fmla="*/ 3793402 w 5135879"/>
                <a:gd name="connsiteY28" fmla="*/ 307818 h 683987"/>
                <a:gd name="connsiteX29" fmla="*/ 3883936 w 5135879"/>
                <a:gd name="connsiteY29" fmla="*/ 334978 h 683987"/>
                <a:gd name="connsiteX30" fmla="*/ 3920150 w 5135879"/>
                <a:gd name="connsiteY30" fmla="*/ 353085 h 683987"/>
                <a:gd name="connsiteX31" fmla="*/ 3947311 w 5135879"/>
                <a:gd name="connsiteY31" fmla="*/ 362139 h 683987"/>
                <a:gd name="connsiteX32" fmla="*/ 4200808 w 5135879"/>
                <a:gd name="connsiteY32" fmla="*/ 380246 h 683987"/>
                <a:gd name="connsiteX33" fmla="*/ 4409037 w 5135879"/>
                <a:gd name="connsiteY33" fmla="*/ 398353 h 683987"/>
                <a:gd name="connsiteX34" fmla="*/ 4472412 w 5135879"/>
                <a:gd name="connsiteY34" fmla="*/ 407406 h 683987"/>
                <a:gd name="connsiteX35" fmla="*/ 4508625 w 5135879"/>
                <a:gd name="connsiteY35" fmla="*/ 416460 h 683987"/>
                <a:gd name="connsiteX36" fmla="*/ 4689695 w 5135879"/>
                <a:gd name="connsiteY36" fmla="*/ 434567 h 683987"/>
                <a:gd name="connsiteX37" fmla="*/ 5069940 w 5135879"/>
                <a:gd name="connsiteY37" fmla="*/ 443620 h 683987"/>
                <a:gd name="connsiteX38" fmla="*/ 5097101 w 5135879"/>
                <a:gd name="connsiteY38" fmla="*/ 452673 h 683987"/>
                <a:gd name="connsiteX39" fmla="*/ 5133315 w 5135879"/>
                <a:gd name="connsiteY39" fmla="*/ 443620 h 683987"/>
                <a:gd name="connsiteX40" fmla="*/ 5069940 w 5135879"/>
                <a:gd name="connsiteY40" fmla="*/ 452673 h 683987"/>
                <a:gd name="connsiteX41" fmla="*/ 5042780 w 5135879"/>
                <a:gd name="connsiteY41" fmla="*/ 461727 h 683987"/>
                <a:gd name="connsiteX42" fmla="*/ 4997513 w 5135879"/>
                <a:gd name="connsiteY42" fmla="*/ 470780 h 683987"/>
                <a:gd name="connsiteX43" fmla="*/ 4961299 w 5135879"/>
                <a:gd name="connsiteY43" fmla="*/ 479834 h 683987"/>
                <a:gd name="connsiteX44" fmla="*/ 4762122 w 5135879"/>
                <a:gd name="connsiteY44" fmla="*/ 506994 h 683987"/>
                <a:gd name="connsiteX45" fmla="*/ 4680641 w 5135879"/>
                <a:gd name="connsiteY45" fmla="*/ 525101 h 683987"/>
                <a:gd name="connsiteX46" fmla="*/ 4164594 w 5135879"/>
                <a:gd name="connsiteY46" fmla="*/ 516048 h 683987"/>
                <a:gd name="connsiteX47" fmla="*/ 4137433 w 5135879"/>
                <a:gd name="connsiteY47" fmla="*/ 525101 h 683987"/>
                <a:gd name="connsiteX48" fmla="*/ 3811509 w 5135879"/>
                <a:gd name="connsiteY48" fmla="*/ 534155 h 683987"/>
                <a:gd name="connsiteX49" fmla="*/ 3902043 w 5135879"/>
                <a:gd name="connsiteY49" fmla="*/ 552262 h 683987"/>
                <a:gd name="connsiteX50" fmla="*/ 3929204 w 5135879"/>
                <a:gd name="connsiteY50" fmla="*/ 570369 h 683987"/>
                <a:gd name="connsiteX51" fmla="*/ 4046899 w 5135879"/>
                <a:gd name="connsiteY51" fmla="*/ 606582 h 683987"/>
                <a:gd name="connsiteX52" fmla="*/ 4092166 w 5135879"/>
                <a:gd name="connsiteY52" fmla="*/ 615636 h 683987"/>
                <a:gd name="connsiteX53" fmla="*/ 4155540 w 5135879"/>
                <a:gd name="connsiteY53" fmla="*/ 642796 h 683987"/>
                <a:gd name="connsiteX54" fmla="*/ 4218915 w 5135879"/>
                <a:gd name="connsiteY54" fmla="*/ 651850 h 683987"/>
                <a:gd name="connsiteX55" fmla="*/ 4191754 w 5135879"/>
                <a:gd name="connsiteY55" fmla="*/ 669957 h 683987"/>
                <a:gd name="connsiteX56" fmla="*/ 3766241 w 5135879"/>
                <a:gd name="connsiteY56" fmla="*/ 651850 h 683987"/>
                <a:gd name="connsiteX57" fmla="*/ 3485584 w 5135879"/>
                <a:gd name="connsiteY57" fmla="*/ 660903 h 683987"/>
                <a:gd name="connsiteX58" fmla="*/ 3431263 w 5135879"/>
                <a:gd name="connsiteY58" fmla="*/ 651850 h 683987"/>
                <a:gd name="connsiteX59" fmla="*/ 2833734 w 5135879"/>
                <a:gd name="connsiteY59" fmla="*/ 660903 h 683987"/>
                <a:gd name="connsiteX60" fmla="*/ 2544023 w 5135879"/>
                <a:gd name="connsiteY60" fmla="*/ 679010 h 683987"/>
                <a:gd name="connsiteX61" fmla="*/ 1638677 w 5135879"/>
                <a:gd name="connsiteY61" fmla="*/ 660903 h 683987"/>
                <a:gd name="connsiteX62" fmla="*/ 1539089 w 5135879"/>
                <a:gd name="connsiteY62" fmla="*/ 651850 h 683987"/>
                <a:gd name="connsiteX63" fmla="*/ 1502875 w 5135879"/>
                <a:gd name="connsiteY63" fmla="*/ 642796 h 683987"/>
                <a:gd name="connsiteX64" fmla="*/ 1358019 w 5135879"/>
                <a:gd name="connsiteY64" fmla="*/ 633743 h 683987"/>
                <a:gd name="connsiteX65" fmla="*/ 1312752 w 5135879"/>
                <a:gd name="connsiteY65" fmla="*/ 606582 h 683987"/>
                <a:gd name="connsiteX66" fmla="*/ 1050202 w 5135879"/>
                <a:gd name="connsiteY66" fmla="*/ 579422 h 683987"/>
                <a:gd name="connsiteX67" fmla="*/ 1013988 w 5135879"/>
                <a:gd name="connsiteY67" fmla="*/ 570369 h 683987"/>
                <a:gd name="connsiteX68" fmla="*/ 986827 w 5135879"/>
                <a:gd name="connsiteY68" fmla="*/ 561315 h 683987"/>
                <a:gd name="connsiteX69" fmla="*/ 488887 w 5135879"/>
                <a:gd name="connsiteY69" fmla="*/ 552262 h 683987"/>
                <a:gd name="connsiteX70" fmla="*/ 72427 w 5135879"/>
                <a:gd name="connsiteY70" fmla="*/ 534155 h 683987"/>
                <a:gd name="connsiteX71" fmla="*/ 54320 w 5135879"/>
                <a:gd name="connsiteY71" fmla="*/ 506994 h 683987"/>
                <a:gd name="connsiteX72" fmla="*/ 0 w 5135879"/>
                <a:gd name="connsiteY72" fmla="*/ 516048 h 683987"/>
                <a:gd name="connsiteX73" fmla="*/ 54320 w 5135879"/>
                <a:gd name="connsiteY73" fmla="*/ 525101 h 683987"/>
                <a:gd name="connsiteX74" fmla="*/ 90534 w 5135879"/>
                <a:gd name="connsiteY74" fmla="*/ 534155 h 683987"/>
                <a:gd name="connsiteX75" fmla="*/ 434566 w 5135879"/>
                <a:gd name="connsiteY75" fmla="*/ 525101 h 683987"/>
                <a:gd name="connsiteX76" fmla="*/ 552261 w 5135879"/>
                <a:gd name="connsiteY76" fmla="*/ 506994 h 683987"/>
                <a:gd name="connsiteX77" fmla="*/ 905346 w 5135879"/>
                <a:gd name="connsiteY77" fmla="*/ 488887 h 683987"/>
                <a:gd name="connsiteX78" fmla="*/ 932507 w 5135879"/>
                <a:gd name="connsiteY78" fmla="*/ 479834 h 683987"/>
                <a:gd name="connsiteX79" fmla="*/ 787651 w 5135879"/>
                <a:gd name="connsiteY79" fmla="*/ 461727 h 683987"/>
                <a:gd name="connsiteX80" fmla="*/ 706170 w 5135879"/>
                <a:gd name="connsiteY80" fmla="*/ 434567 h 683987"/>
                <a:gd name="connsiteX81" fmla="*/ 778598 w 5135879"/>
                <a:gd name="connsiteY81" fmla="*/ 425513 h 683987"/>
                <a:gd name="connsiteX82" fmla="*/ 905346 w 5135879"/>
                <a:gd name="connsiteY82" fmla="*/ 416460 h 683987"/>
                <a:gd name="connsiteX83" fmla="*/ 923453 w 5135879"/>
                <a:gd name="connsiteY83" fmla="*/ 380246 h 683987"/>
                <a:gd name="connsiteX84" fmla="*/ 1068309 w 5135879"/>
                <a:gd name="connsiteY84" fmla="*/ 371192 h 683987"/>
                <a:gd name="connsiteX85" fmla="*/ 1122629 w 5135879"/>
                <a:gd name="connsiteY85" fmla="*/ 362139 h 683987"/>
                <a:gd name="connsiteX86" fmla="*/ 968720 w 5135879"/>
                <a:gd name="connsiteY86" fmla="*/ 353085 h 683987"/>
                <a:gd name="connsiteX87" fmla="*/ 995881 w 5135879"/>
                <a:gd name="connsiteY87" fmla="*/ 334978 h 683987"/>
                <a:gd name="connsiteX88" fmla="*/ 1041148 w 5135879"/>
                <a:gd name="connsiteY88" fmla="*/ 316871 h 683987"/>
                <a:gd name="connsiteX89" fmla="*/ 1258431 w 5135879"/>
                <a:gd name="connsiteY89" fmla="*/ 307818 h 683987"/>
                <a:gd name="connsiteX90" fmla="*/ 1339913 w 5135879"/>
                <a:gd name="connsiteY90" fmla="*/ 298765 h 683987"/>
                <a:gd name="connsiteX91" fmla="*/ 1403287 w 5135879"/>
                <a:gd name="connsiteY91" fmla="*/ 280658 h 683987"/>
                <a:gd name="connsiteX92" fmla="*/ 1430447 w 5135879"/>
                <a:gd name="connsiteY92" fmla="*/ 262551 h 683987"/>
                <a:gd name="connsiteX93" fmla="*/ 1457608 w 5135879"/>
                <a:gd name="connsiteY93" fmla="*/ 235390 h 683987"/>
                <a:gd name="connsiteX94" fmla="*/ 1530035 w 5135879"/>
                <a:gd name="connsiteY94" fmla="*/ 226337 h 683987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  <a:cxn ang="0">
                  <a:pos x="connsiteX19" y="connsiteY19"/>
                </a:cxn>
                <a:cxn ang="0">
                  <a:pos x="connsiteX20" y="connsiteY20"/>
                </a:cxn>
                <a:cxn ang="0">
                  <a:pos x="connsiteX21" y="connsiteY21"/>
                </a:cxn>
                <a:cxn ang="0">
                  <a:pos x="connsiteX22" y="connsiteY22"/>
                </a:cxn>
                <a:cxn ang="0">
                  <a:pos x="connsiteX23" y="connsiteY23"/>
                </a:cxn>
                <a:cxn ang="0">
                  <a:pos x="connsiteX24" y="connsiteY24"/>
                </a:cxn>
                <a:cxn ang="0">
                  <a:pos x="connsiteX25" y="connsiteY25"/>
                </a:cxn>
                <a:cxn ang="0">
                  <a:pos x="connsiteX26" y="connsiteY26"/>
                </a:cxn>
                <a:cxn ang="0">
                  <a:pos x="connsiteX27" y="connsiteY27"/>
                </a:cxn>
                <a:cxn ang="0">
                  <a:pos x="connsiteX28" y="connsiteY28"/>
                </a:cxn>
                <a:cxn ang="0">
                  <a:pos x="connsiteX29" y="connsiteY29"/>
                </a:cxn>
                <a:cxn ang="0">
                  <a:pos x="connsiteX30" y="connsiteY30"/>
                </a:cxn>
                <a:cxn ang="0">
                  <a:pos x="connsiteX31" y="connsiteY31"/>
                </a:cxn>
                <a:cxn ang="0">
                  <a:pos x="connsiteX32" y="connsiteY32"/>
                </a:cxn>
                <a:cxn ang="0">
                  <a:pos x="connsiteX33" y="connsiteY33"/>
                </a:cxn>
                <a:cxn ang="0">
                  <a:pos x="connsiteX34" y="connsiteY34"/>
                </a:cxn>
                <a:cxn ang="0">
                  <a:pos x="connsiteX35" y="connsiteY35"/>
                </a:cxn>
                <a:cxn ang="0">
                  <a:pos x="connsiteX36" y="connsiteY36"/>
                </a:cxn>
                <a:cxn ang="0">
                  <a:pos x="connsiteX37" y="connsiteY37"/>
                </a:cxn>
                <a:cxn ang="0">
                  <a:pos x="connsiteX38" y="connsiteY38"/>
                </a:cxn>
                <a:cxn ang="0">
                  <a:pos x="connsiteX39" y="connsiteY39"/>
                </a:cxn>
                <a:cxn ang="0">
                  <a:pos x="connsiteX40" y="connsiteY40"/>
                </a:cxn>
                <a:cxn ang="0">
                  <a:pos x="connsiteX41" y="connsiteY41"/>
                </a:cxn>
                <a:cxn ang="0">
                  <a:pos x="connsiteX42" y="connsiteY42"/>
                </a:cxn>
                <a:cxn ang="0">
                  <a:pos x="connsiteX43" y="connsiteY43"/>
                </a:cxn>
                <a:cxn ang="0">
                  <a:pos x="connsiteX44" y="connsiteY44"/>
                </a:cxn>
                <a:cxn ang="0">
                  <a:pos x="connsiteX45" y="connsiteY45"/>
                </a:cxn>
                <a:cxn ang="0">
                  <a:pos x="connsiteX46" y="connsiteY46"/>
                </a:cxn>
                <a:cxn ang="0">
                  <a:pos x="connsiteX47" y="connsiteY47"/>
                </a:cxn>
                <a:cxn ang="0">
                  <a:pos x="connsiteX48" y="connsiteY48"/>
                </a:cxn>
                <a:cxn ang="0">
                  <a:pos x="connsiteX49" y="connsiteY49"/>
                </a:cxn>
                <a:cxn ang="0">
                  <a:pos x="connsiteX50" y="connsiteY50"/>
                </a:cxn>
                <a:cxn ang="0">
                  <a:pos x="connsiteX51" y="connsiteY51"/>
                </a:cxn>
                <a:cxn ang="0">
                  <a:pos x="connsiteX52" y="connsiteY52"/>
                </a:cxn>
                <a:cxn ang="0">
                  <a:pos x="connsiteX53" y="connsiteY53"/>
                </a:cxn>
                <a:cxn ang="0">
                  <a:pos x="connsiteX54" y="connsiteY54"/>
                </a:cxn>
                <a:cxn ang="0">
                  <a:pos x="connsiteX55" y="connsiteY55"/>
                </a:cxn>
                <a:cxn ang="0">
                  <a:pos x="connsiteX56" y="connsiteY56"/>
                </a:cxn>
                <a:cxn ang="0">
                  <a:pos x="connsiteX57" y="connsiteY57"/>
                </a:cxn>
                <a:cxn ang="0">
                  <a:pos x="connsiteX58" y="connsiteY58"/>
                </a:cxn>
                <a:cxn ang="0">
                  <a:pos x="connsiteX59" y="connsiteY59"/>
                </a:cxn>
                <a:cxn ang="0">
                  <a:pos x="connsiteX60" y="connsiteY60"/>
                </a:cxn>
                <a:cxn ang="0">
                  <a:pos x="connsiteX61" y="connsiteY61"/>
                </a:cxn>
                <a:cxn ang="0">
                  <a:pos x="connsiteX62" y="connsiteY62"/>
                </a:cxn>
                <a:cxn ang="0">
                  <a:pos x="connsiteX63" y="connsiteY63"/>
                </a:cxn>
                <a:cxn ang="0">
                  <a:pos x="connsiteX64" y="connsiteY64"/>
                </a:cxn>
                <a:cxn ang="0">
                  <a:pos x="connsiteX65" y="connsiteY65"/>
                </a:cxn>
                <a:cxn ang="0">
                  <a:pos x="connsiteX66" y="connsiteY66"/>
                </a:cxn>
                <a:cxn ang="0">
                  <a:pos x="connsiteX67" y="connsiteY67"/>
                </a:cxn>
                <a:cxn ang="0">
                  <a:pos x="connsiteX68" y="connsiteY68"/>
                </a:cxn>
                <a:cxn ang="0">
                  <a:pos x="connsiteX69" y="connsiteY69"/>
                </a:cxn>
                <a:cxn ang="0">
                  <a:pos x="connsiteX70" y="connsiteY70"/>
                </a:cxn>
                <a:cxn ang="0">
                  <a:pos x="connsiteX71" y="connsiteY71"/>
                </a:cxn>
                <a:cxn ang="0">
                  <a:pos x="connsiteX72" y="connsiteY72"/>
                </a:cxn>
                <a:cxn ang="0">
                  <a:pos x="connsiteX73" y="connsiteY73"/>
                </a:cxn>
                <a:cxn ang="0">
                  <a:pos x="connsiteX74" y="connsiteY74"/>
                </a:cxn>
                <a:cxn ang="0">
                  <a:pos x="connsiteX75" y="connsiteY75"/>
                </a:cxn>
                <a:cxn ang="0">
                  <a:pos x="connsiteX76" y="connsiteY76"/>
                </a:cxn>
                <a:cxn ang="0">
                  <a:pos x="connsiteX77" y="connsiteY77"/>
                </a:cxn>
                <a:cxn ang="0">
                  <a:pos x="connsiteX78" y="connsiteY78"/>
                </a:cxn>
                <a:cxn ang="0">
                  <a:pos x="connsiteX79" y="connsiteY79"/>
                </a:cxn>
                <a:cxn ang="0">
                  <a:pos x="connsiteX80" y="connsiteY80"/>
                </a:cxn>
                <a:cxn ang="0">
                  <a:pos x="connsiteX81" y="connsiteY81"/>
                </a:cxn>
                <a:cxn ang="0">
                  <a:pos x="connsiteX82" y="connsiteY82"/>
                </a:cxn>
                <a:cxn ang="0">
                  <a:pos x="connsiteX83" y="connsiteY83"/>
                </a:cxn>
                <a:cxn ang="0">
                  <a:pos x="connsiteX84" y="connsiteY84"/>
                </a:cxn>
                <a:cxn ang="0">
                  <a:pos x="connsiteX85" y="connsiteY85"/>
                </a:cxn>
                <a:cxn ang="0">
                  <a:pos x="connsiteX86" y="connsiteY86"/>
                </a:cxn>
                <a:cxn ang="0">
                  <a:pos x="connsiteX87" y="connsiteY87"/>
                </a:cxn>
                <a:cxn ang="0">
                  <a:pos x="connsiteX88" y="connsiteY88"/>
                </a:cxn>
                <a:cxn ang="0">
                  <a:pos x="connsiteX89" y="connsiteY89"/>
                </a:cxn>
                <a:cxn ang="0">
                  <a:pos x="connsiteX90" y="connsiteY90"/>
                </a:cxn>
                <a:cxn ang="0">
                  <a:pos x="connsiteX91" y="connsiteY91"/>
                </a:cxn>
                <a:cxn ang="0">
                  <a:pos x="connsiteX92" y="connsiteY92"/>
                </a:cxn>
                <a:cxn ang="0">
                  <a:pos x="connsiteX93" y="connsiteY93"/>
                </a:cxn>
                <a:cxn ang="0">
                  <a:pos x="connsiteX94" y="connsiteY94"/>
                </a:cxn>
              </a:cxnLst>
              <a:rect l="l" t="t" r="r" b="b"/>
              <a:pathLst>
                <a:path w="5135879" h="683987">
                  <a:moveTo>
                    <a:pt x="1439501" y="253497"/>
                  </a:moveTo>
                  <a:cubicBezTo>
                    <a:pt x="1454590" y="238408"/>
                    <a:pt x="1468709" y="222282"/>
                    <a:pt x="1484768" y="208230"/>
                  </a:cubicBezTo>
                  <a:cubicBezTo>
                    <a:pt x="1492957" y="201065"/>
                    <a:pt x="1502481" y="195521"/>
                    <a:pt x="1511928" y="190123"/>
                  </a:cubicBezTo>
                  <a:cubicBezTo>
                    <a:pt x="1543254" y="172222"/>
                    <a:pt x="1544831" y="173120"/>
                    <a:pt x="1575303" y="162963"/>
                  </a:cubicBezTo>
                  <a:cubicBezTo>
                    <a:pt x="1591617" y="146648"/>
                    <a:pt x="1607565" y="127148"/>
                    <a:pt x="1629623" y="117695"/>
                  </a:cubicBezTo>
                  <a:cubicBezTo>
                    <a:pt x="1641060" y="112794"/>
                    <a:pt x="1653873" y="112060"/>
                    <a:pt x="1665837" y="108642"/>
                  </a:cubicBezTo>
                  <a:cubicBezTo>
                    <a:pt x="1675013" y="106020"/>
                    <a:pt x="1683542" y="100877"/>
                    <a:pt x="1692998" y="99588"/>
                  </a:cubicBezTo>
                  <a:cubicBezTo>
                    <a:pt x="1750125" y="91798"/>
                    <a:pt x="1865014" y="81481"/>
                    <a:pt x="1865014" y="81481"/>
                  </a:cubicBezTo>
                  <a:cubicBezTo>
                    <a:pt x="1983445" y="51874"/>
                    <a:pt x="1850668" y="82437"/>
                    <a:pt x="2136617" y="63374"/>
                  </a:cubicBezTo>
                  <a:cubicBezTo>
                    <a:pt x="2149032" y="62546"/>
                    <a:pt x="2160630" y="56761"/>
                    <a:pt x="2172831" y="54321"/>
                  </a:cubicBezTo>
                  <a:cubicBezTo>
                    <a:pt x="2190831" y="50721"/>
                    <a:pt x="2209045" y="48286"/>
                    <a:pt x="2227152" y="45268"/>
                  </a:cubicBezTo>
                  <a:cubicBezTo>
                    <a:pt x="2284915" y="6760"/>
                    <a:pt x="2234694" y="34001"/>
                    <a:pt x="2353901" y="18107"/>
                  </a:cubicBezTo>
                  <a:cubicBezTo>
                    <a:pt x="2372854" y="15580"/>
                    <a:pt x="2398650" y="6209"/>
                    <a:pt x="2417275" y="0"/>
                  </a:cubicBezTo>
                  <a:lnTo>
                    <a:pt x="2996697" y="9054"/>
                  </a:lnTo>
                  <a:cubicBezTo>
                    <a:pt x="3042050" y="10202"/>
                    <a:pt x="3087748" y="10649"/>
                    <a:pt x="3132499" y="18107"/>
                  </a:cubicBezTo>
                  <a:cubicBezTo>
                    <a:pt x="3143232" y="19896"/>
                    <a:pt x="3149927" y="31348"/>
                    <a:pt x="3159659" y="36214"/>
                  </a:cubicBezTo>
                  <a:cubicBezTo>
                    <a:pt x="3200486" y="56628"/>
                    <a:pt x="3175065" y="30946"/>
                    <a:pt x="3213980" y="63374"/>
                  </a:cubicBezTo>
                  <a:cubicBezTo>
                    <a:pt x="3259193" y="101051"/>
                    <a:pt x="3220567" y="83678"/>
                    <a:pt x="3268301" y="99588"/>
                  </a:cubicBezTo>
                  <a:cubicBezTo>
                    <a:pt x="3277354" y="105624"/>
                    <a:pt x="3284822" y="115415"/>
                    <a:pt x="3295461" y="117695"/>
                  </a:cubicBezTo>
                  <a:cubicBezTo>
                    <a:pt x="3328054" y="124679"/>
                    <a:pt x="3362051" y="122035"/>
                    <a:pt x="3395049" y="126749"/>
                  </a:cubicBezTo>
                  <a:cubicBezTo>
                    <a:pt x="3404496" y="128099"/>
                    <a:pt x="3413156" y="132784"/>
                    <a:pt x="3422210" y="135802"/>
                  </a:cubicBezTo>
                  <a:cubicBezTo>
                    <a:pt x="3431263" y="144856"/>
                    <a:pt x="3441173" y="153127"/>
                    <a:pt x="3449370" y="162963"/>
                  </a:cubicBezTo>
                  <a:cubicBezTo>
                    <a:pt x="3456336" y="171322"/>
                    <a:pt x="3459288" y="182958"/>
                    <a:pt x="3467477" y="190123"/>
                  </a:cubicBezTo>
                  <a:cubicBezTo>
                    <a:pt x="3483855" y="204453"/>
                    <a:pt x="3506410" y="210949"/>
                    <a:pt x="3521798" y="226337"/>
                  </a:cubicBezTo>
                  <a:cubicBezTo>
                    <a:pt x="3530851" y="235390"/>
                    <a:pt x="3537070" y="248742"/>
                    <a:pt x="3548958" y="253497"/>
                  </a:cubicBezTo>
                  <a:cubicBezTo>
                    <a:pt x="3568771" y="261422"/>
                    <a:pt x="3591207" y="259533"/>
                    <a:pt x="3612332" y="262551"/>
                  </a:cubicBezTo>
                  <a:cubicBezTo>
                    <a:pt x="3677461" y="284259"/>
                    <a:pt x="3596122" y="257919"/>
                    <a:pt x="3675707" y="280658"/>
                  </a:cubicBezTo>
                  <a:cubicBezTo>
                    <a:pt x="3684883" y="283280"/>
                    <a:pt x="3693568" y="287565"/>
                    <a:pt x="3702867" y="289711"/>
                  </a:cubicBezTo>
                  <a:cubicBezTo>
                    <a:pt x="3732855" y="296631"/>
                    <a:pt x="3764205" y="298086"/>
                    <a:pt x="3793402" y="307818"/>
                  </a:cubicBezTo>
                  <a:cubicBezTo>
                    <a:pt x="3859526" y="329860"/>
                    <a:pt x="3829206" y="321296"/>
                    <a:pt x="3883936" y="334978"/>
                  </a:cubicBezTo>
                  <a:cubicBezTo>
                    <a:pt x="3896007" y="341014"/>
                    <a:pt x="3907745" y="347769"/>
                    <a:pt x="3920150" y="353085"/>
                  </a:cubicBezTo>
                  <a:cubicBezTo>
                    <a:pt x="3928922" y="356844"/>
                    <a:pt x="3938135" y="359517"/>
                    <a:pt x="3947311" y="362139"/>
                  </a:cubicBezTo>
                  <a:cubicBezTo>
                    <a:pt x="4038255" y="388123"/>
                    <a:pt x="4061951" y="374460"/>
                    <a:pt x="4200808" y="380246"/>
                  </a:cubicBezTo>
                  <a:lnTo>
                    <a:pt x="4409037" y="398353"/>
                  </a:lnTo>
                  <a:cubicBezTo>
                    <a:pt x="4430271" y="400476"/>
                    <a:pt x="4451417" y="403589"/>
                    <a:pt x="4472412" y="407406"/>
                  </a:cubicBezTo>
                  <a:cubicBezTo>
                    <a:pt x="4484654" y="409632"/>
                    <a:pt x="4496279" y="414917"/>
                    <a:pt x="4508625" y="416460"/>
                  </a:cubicBezTo>
                  <a:cubicBezTo>
                    <a:pt x="4568814" y="423984"/>
                    <a:pt x="4629108" y="431635"/>
                    <a:pt x="4689695" y="434567"/>
                  </a:cubicBezTo>
                  <a:cubicBezTo>
                    <a:pt x="4816331" y="440694"/>
                    <a:pt x="4943192" y="440602"/>
                    <a:pt x="5069940" y="443620"/>
                  </a:cubicBezTo>
                  <a:cubicBezTo>
                    <a:pt x="5078994" y="446638"/>
                    <a:pt x="5087558" y="452673"/>
                    <a:pt x="5097101" y="452673"/>
                  </a:cubicBezTo>
                  <a:cubicBezTo>
                    <a:pt x="5109544" y="452673"/>
                    <a:pt x="5145758" y="443620"/>
                    <a:pt x="5133315" y="443620"/>
                  </a:cubicBezTo>
                  <a:cubicBezTo>
                    <a:pt x="5111976" y="443620"/>
                    <a:pt x="5091065" y="449655"/>
                    <a:pt x="5069940" y="452673"/>
                  </a:cubicBezTo>
                  <a:cubicBezTo>
                    <a:pt x="5060887" y="455691"/>
                    <a:pt x="5052038" y="459412"/>
                    <a:pt x="5042780" y="461727"/>
                  </a:cubicBezTo>
                  <a:cubicBezTo>
                    <a:pt x="5027852" y="465459"/>
                    <a:pt x="5012534" y="467442"/>
                    <a:pt x="4997513" y="470780"/>
                  </a:cubicBezTo>
                  <a:cubicBezTo>
                    <a:pt x="4985366" y="473479"/>
                    <a:pt x="4973370" y="476816"/>
                    <a:pt x="4961299" y="479834"/>
                  </a:cubicBezTo>
                  <a:cubicBezTo>
                    <a:pt x="4882986" y="532041"/>
                    <a:pt x="4962822" y="485491"/>
                    <a:pt x="4762122" y="506994"/>
                  </a:cubicBezTo>
                  <a:cubicBezTo>
                    <a:pt x="4734457" y="509958"/>
                    <a:pt x="4707801" y="519065"/>
                    <a:pt x="4680641" y="525101"/>
                  </a:cubicBezTo>
                  <a:lnTo>
                    <a:pt x="4164594" y="516048"/>
                  </a:lnTo>
                  <a:cubicBezTo>
                    <a:pt x="4155051" y="516048"/>
                    <a:pt x="4146964" y="524612"/>
                    <a:pt x="4137433" y="525101"/>
                  </a:cubicBezTo>
                  <a:cubicBezTo>
                    <a:pt x="4028892" y="530667"/>
                    <a:pt x="3920150" y="531137"/>
                    <a:pt x="3811509" y="534155"/>
                  </a:cubicBezTo>
                  <a:cubicBezTo>
                    <a:pt x="3834871" y="537492"/>
                    <a:pt x="3876758" y="539619"/>
                    <a:pt x="3902043" y="552262"/>
                  </a:cubicBezTo>
                  <a:cubicBezTo>
                    <a:pt x="3911775" y="557128"/>
                    <a:pt x="3919160" y="566184"/>
                    <a:pt x="3929204" y="570369"/>
                  </a:cubicBezTo>
                  <a:cubicBezTo>
                    <a:pt x="3961487" y="583820"/>
                    <a:pt x="4009423" y="598254"/>
                    <a:pt x="4046899" y="606582"/>
                  </a:cubicBezTo>
                  <a:cubicBezTo>
                    <a:pt x="4061920" y="609920"/>
                    <a:pt x="4077077" y="612618"/>
                    <a:pt x="4092166" y="615636"/>
                  </a:cubicBezTo>
                  <a:cubicBezTo>
                    <a:pt x="4111799" y="625452"/>
                    <a:pt x="4133336" y="638355"/>
                    <a:pt x="4155540" y="642796"/>
                  </a:cubicBezTo>
                  <a:cubicBezTo>
                    <a:pt x="4176465" y="646981"/>
                    <a:pt x="4197790" y="648832"/>
                    <a:pt x="4218915" y="651850"/>
                  </a:cubicBezTo>
                  <a:cubicBezTo>
                    <a:pt x="4209861" y="657886"/>
                    <a:pt x="4202633" y="669721"/>
                    <a:pt x="4191754" y="669957"/>
                  </a:cubicBezTo>
                  <a:cubicBezTo>
                    <a:pt x="3856540" y="677244"/>
                    <a:pt x="3922004" y="690789"/>
                    <a:pt x="3766241" y="651850"/>
                  </a:cubicBezTo>
                  <a:cubicBezTo>
                    <a:pt x="3672689" y="654868"/>
                    <a:pt x="3579185" y="660903"/>
                    <a:pt x="3485584" y="660903"/>
                  </a:cubicBezTo>
                  <a:cubicBezTo>
                    <a:pt x="3467227" y="660903"/>
                    <a:pt x="3449620" y="651850"/>
                    <a:pt x="3431263" y="651850"/>
                  </a:cubicBezTo>
                  <a:cubicBezTo>
                    <a:pt x="3232064" y="651850"/>
                    <a:pt x="3032910" y="657885"/>
                    <a:pt x="2833734" y="660903"/>
                  </a:cubicBezTo>
                  <a:cubicBezTo>
                    <a:pt x="2727171" y="696427"/>
                    <a:pt x="2782424" y="680858"/>
                    <a:pt x="2544023" y="679010"/>
                  </a:cubicBezTo>
                  <a:cubicBezTo>
                    <a:pt x="2242190" y="676670"/>
                    <a:pt x="1940459" y="666939"/>
                    <a:pt x="1638677" y="660903"/>
                  </a:cubicBezTo>
                  <a:cubicBezTo>
                    <a:pt x="1605481" y="657885"/>
                    <a:pt x="1572129" y="656255"/>
                    <a:pt x="1539089" y="651850"/>
                  </a:cubicBezTo>
                  <a:cubicBezTo>
                    <a:pt x="1526755" y="650205"/>
                    <a:pt x="1515256" y="644034"/>
                    <a:pt x="1502875" y="642796"/>
                  </a:cubicBezTo>
                  <a:cubicBezTo>
                    <a:pt x="1454736" y="637982"/>
                    <a:pt x="1406304" y="636761"/>
                    <a:pt x="1358019" y="633743"/>
                  </a:cubicBezTo>
                  <a:cubicBezTo>
                    <a:pt x="1342930" y="624689"/>
                    <a:pt x="1329176" y="612899"/>
                    <a:pt x="1312752" y="606582"/>
                  </a:cubicBezTo>
                  <a:cubicBezTo>
                    <a:pt x="1232293" y="575636"/>
                    <a:pt x="1128733" y="583161"/>
                    <a:pt x="1050202" y="579422"/>
                  </a:cubicBezTo>
                  <a:cubicBezTo>
                    <a:pt x="1038131" y="576404"/>
                    <a:pt x="1025952" y="573787"/>
                    <a:pt x="1013988" y="570369"/>
                  </a:cubicBezTo>
                  <a:cubicBezTo>
                    <a:pt x="1004812" y="567747"/>
                    <a:pt x="996365" y="561644"/>
                    <a:pt x="986827" y="561315"/>
                  </a:cubicBezTo>
                  <a:cubicBezTo>
                    <a:pt x="820918" y="555594"/>
                    <a:pt x="654867" y="555280"/>
                    <a:pt x="488887" y="552262"/>
                  </a:cubicBezTo>
                  <a:cubicBezTo>
                    <a:pt x="313421" y="508393"/>
                    <a:pt x="630724" y="584909"/>
                    <a:pt x="72427" y="534155"/>
                  </a:cubicBezTo>
                  <a:cubicBezTo>
                    <a:pt x="61591" y="533170"/>
                    <a:pt x="60356" y="516048"/>
                    <a:pt x="54320" y="506994"/>
                  </a:cubicBezTo>
                  <a:lnTo>
                    <a:pt x="0" y="516048"/>
                  </a:lnTo>
                  <a:cubicBezTo>
                    <a:pt x="0" y="534404"/>
                    <a:pt x="36320" y="521501"/>
                    <a:pt x="54320" y="525101"/>
                  </a:cubicBezTo>
                  <a:cubicBezTo>
                    <a:pt x="66521" y="527541"/>
                    <a:pt x="78463" y="531137"/>
                    <a:pt x="90534" y="534155"/>
                  </a:cubicBezTo>
                  <a:lnTo>
                    <a:pt x="434566" y="525101"/>
                  </a:lnTo>
                  <a:cubicBezTo>
                    <a:pt x="811578" y="509392"/>
                    <a:pt x="409175" y="527435"/>
                    <a:pt x="552261" y="506994"/>
                  </a:cubicBezTo>
                  <a:cubicBezTo>
                    <a:pt x="646932" y="493469"/>
                    <a:pt x="844608" y="491056"/>
                    <a:pt x="905346" y="488887"/>
                  </a:cubicBezTo>
                  <a:cubicBezTo>
                    <a:pt x="914400" y="485869"/>
                    <a:pt x="941561" y="482852"/>
                    <a:pt x="932507" y="479834"/>
                  </a:cubicBezTo>
                  <a:cubicBezTo>
                    <a:pt x="868018" y="458337"/>
                    <a:pt x="914861" y="471512"/>
                    <a:pt x="787651" y="461727"/>
                  </a:cubicBezTo>
                  <a:cubicBezTo>
                    <a:pt x="784395" y="460913"/>
                    <a:pt x="699353" y="441384"/>
                    <a:pt x="706170" y="434567"/>
                  </a:cubicBezTo>
                  <a:cubicBezTo>
                    <a:pt x="723375" y="417363"/>
                    <a:pt x="754367" y="427716"/>
                    <a:pt x="778598" y="425513"/>
                  </a:cubicBezTo>
                  <a:cubicBezTo>
                    <a:pt x="820781" y="421678"/>
                    <a:pt x="863097" y="419478"/>
                    <a:pt x="905346" y="416460"/>
                  </a:cubicBezTo>
                  <a:cubicBezTo>
                    <a:pt x="911382" y="404389"/>
                    <a:pt x="910449" y="383858"/>
                    <a:pt x="923453" y="380246"/>
                  </a:cubicBezTo>
                  <a:cubicBezTo>
                    <a:pt x="970068" y="367297"/>
                    <a:pt x="1020128" y="375572"/>
                    <a:pt x="1068309" y="371192"/>
                  </a:cubicBezTo>
                  <a:cubicBezTo>
                    <a:pt x="1086590" y="369530"/>
                    <a:pt x="1104522" y="365157"/>
                    <a:pt x="1122629" y="362139"/>
                  </a:cubicBezTo>
                  <a:cubicBezTo>
                    <a:pt x="1071326" y="359121"/>
                    <a:pt x="1018971" y="363853"/>
                    <a:pt x="968720" y="353085"/>
                  </a:cubicBezTo>
                  <a:cubicBezTo>
                    <a:pt x="958080" y="350805"/>
                    <a:pt x="986149" y="339844"/>
                    <a:pt x="995881" y="334978"/>
                  </a:cubicBezTo>
                  <a:cubicBezTo>
                    <a:pt x="1010417" y="327710"/>
                    <a:pt x="1024983" y="318543"/>
                    <a:pt x="1041148" y="316871"/>
                  </a:cubicBezTo>
                  <a:cubicBezTo>
                    <a:pt x="1113254" y="309412"/>
                    <a:pt x="1186003" y="310836"/>
                    <a:pt x="1258431" y="307818"/>
                  </a:cubicBezTo>
                  <a:cubicBezTo>
                    <a:pt x="1285592" y="304800"/>
                    <a:pt x="1312903" y="302920"/>
                    <a:pt x="1339913" y="298765"/>
                  </a:cubicBezTo>
                  <a:cubicBezTo>
                    <a:pt x="1361016" y="295518"/>
                    <a:pt x="1383012" y="287416"/>
                    <a:pt x="1403287" y="280658"/>
                  </a:cubicBezTo>
                  <a:cubicBezTo>
                    <a:pt x="1412340" y="274622"/>
                    <a:pt x="1422088" y="269517"/>
                    <a:pt x="1430447" y="262551"/>
                  </a:cubicBezTo>
                  <a:cubicBezTo>
                    <a:pt x="1440283" y="254354"/>
                    <a:pt x="1446491" y="241743"/>
                    <a:pt x="1457608" y="235390"/>
                  </a:cubicBezTo>
                  <a:cubicBezTo>
                    <a:pt x="1478574" y="223409"/>
                    <a:pt x="1507532" y="226337"/>
                    <a:pt x="1530035" y="226337"/>
                  </a:cubicBezTo>
                </a:path>
              </a:pathLst>
            </a:custGeom>
            <a:grpFill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endParaRPr lang="en-US" sz="1100">
                <a:latin typeface="Arial" panose="020B0604020202020204" pitchFamily="34" charset="0"/>
                <a:ea typeface="Arial Unicode MS" panose="020B0604020202020204" pitchFamily="34" charset="-122"/>
                <a:cs typeface="Arial" panose="020B0604020202020204" pitchFamily="34" charset="0"/>
              </a:endParaRPr>
            </a:p>
          </p:txBody>
        </p:sp>
        <p:sp>
          <p:nvSpPr>
            <p:cNvPr id="80" name="Oval 79"/>
            <p:cNvSpPr/>
            <p:nvPr/>
          </p:nvSpPr>
          <p:spPr>
            <a:xfrm>
              <a:off x="990600" y="609600"/>
              <a:ext cx="1219200" cy="463045"/>
            </a:xfrm>
            <a:prstGeom prst="ellipse">
              <a:avLst/>
            </a:prstGeom>
            <a:pattFill prst="wdUpDiag">
              <a:fgClr>
                <a:schemeClr val="bg1">
                  <a:lumMod val="75000"/>
                </a:schemeClr>
              </a:fgClr>
              <a:bgClr>
                <a:schemeClr val="bg1"/>
              </a:bgClr>
            </a:patt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sz="1200" b="1" dirty="0" smtClean="0">
                  <a:solidFill>
                    <a:schemeClr val="tx1"/>
                  </a:solidFill>
                  <a:latin typeface="Arial" panose="020B0604020202020204" pitchFamily="34" charset="0"/>
                  <a:ea typeface="Arial Unicode MS" panose="020B0604020202020204" pitchFamily="34" charset="-122"/>
                  <a:cs typeface="Arial" panose="020B0604020202020204" pitchFamily="34" charset="0"/>
                </a:rPr>
                <a:t>COX-1 </a:t>
              </a:r>
              <a:r>
                <a:rPr lang="en-US" sz="1200" b="1" baseline="30000" dirty="0" smtClean="0">
                  <a:solidFill>
                    <a:schemeClr val="tx1"/>
                  </a:solidFill>
                  <a:latin typeface="Arial" panose="020B0604020202020204" pitchFamily="34" charset="0"/>
                  <a:ea typeface="Arial Unicode MS" panose="020B0604020202020204" pitchFamily="34" charset="-122"/>
                  <a:cs typeface="Arial" panose="020B0604020202020204" pitchFamily="34" charset="0"/>
                </a:rPr>
                <a:t>-/-</a:t>
              </a:r>
              <a:endParaRPr lang="en-US" sz="1200" b="1" baseline="30000" dirty="0">
                <a:solidFill>
                  <a:schemeClr val="tx1"/>
                </a:solidFill>
                <a:latin typeface="Arial" panose="020B0604020202020204" pitchFamily="34" charset="0"/>
                <a:ea typeface="Arial Unicode MS" panose="020B0604020202020204" pitchFamily="34" charset="-122"/>
                <a:cs typeface="Arial" panose="020B0604020202020204" pitchFamily="34" charset="0"/>
              </a:endParaRPr>
            </a:p>
          </p:txBody>
        </p:sp>
      </p:grpSp>
      <p:grpSp>
        <p:nvGrpSpPr>
          <p:cNvPr id="81" name="Group 80"/>
          <p:cNvGrpSpPr/>
          <p:nvPr/>
        </p:nvGrpSpPr>
        <p:grpSpPr>
          <a:xfrm>
            <a:off x="6254059" y="5323459"/>
            <a:ext cx="2813741" cy="717557"/>
            <a:chOff x="228600" y="505223"/>
            <a:chExt cx="2796766" cy="637778"/>
          </a:xfrm>
          <a:solidFill>
            <a:schemeClr val="bg1"/>
          </a:solidFill>
        </p:grpSpPr>
        <p:sp>
          <p:nvSpPr>
            <p:cNvPr id="82" name="Freeform 81"/>
            <p:cNvSpPr/>
            <p:nvPr/>
          </p:nvSpPr>
          <p:spPr>
            <a:xfrm>
              <a:off x="228600" y="505223"/>
              <a:ext cx="2796766" cy="637778"/>
            </a:xfrm>
            <a:custGeom>
              <a:avLst/>
              <a:gdLst>
                <a:gd name="connsiteX0" fmla="*/ 1439501 w 5135879"/>
                <a:gd name="connsiteY0" fmla="*/ 253497 h 683987"/>
                <a:gd name="connsiteX1" fmla="*/ 1484768 w 5135879"/>
                <a:gd name="connsiteY1" fmla="*/ 208230 h 683987"/>
                <a:gd name="connsiteX2" fmla="*/ 1511928 w 5135879"/>
                <a:gd name="connsiteY2" fmla="*/ 190123 h 683987"/>
                <a:gd name="connsiteX3" fmla="*/ 1575303 w 5135879"/>
                <a:gd name="connsiteY3" fmla="*/ 162963 h 683987"/>
                <a:gd name="connsiteX4" fmla="*/ 1629623 w 5135879"/>
                <a:gd name="connsiteY4" fmla="*/ 117695 h 683987"/>
                <a:gd name="connsiteX5" fmla="*/ 1665837 w 5135879"/>
                <a:gd name="connsiteY5" fmla="*/ 108642 h 683987"/>
                <a:gd name="connsiteX6" fmla="*/ 1692998 w 5135879"/>
                <a:gd name="connsiteY6" fmla="*/ 99588 h 683987"/>
                <a:gd name="connsiteX7" fmla="*/ 1865014 w 5135879"/>
                <a:gd name="connsiteY7" fmla="*/ 81481 h 683987"/>
                <a:gd name="connsiteX8" fmla="*/ 2136617 w 5135879"/>
                <a:gd name="connsiteY8" fmla="*/ 63374 h 683987"/>
                <a:gd name="connsiteX9" fmla="*/ 2172831 w 5135879"/>
                <a:gd name="connsiteY9" fmla="*/ 54321 h 683987"/>
                <a:gd name="connsiteX10" fmla="*/ 2227152 w 5135879"/>
                <a:gd name="connsiteY10" fmla="*/ 45268 h 683987"/>
                <a:gd name="connsiteX11" fmla="*/ 2353901 w 5135879"/>
                <a:gd name="connsiteY11" fmla="*/ 18107 h 683987"/>
                <a:gd name="connsiteX12" fmla="*/ 2417275 w 5135879"/>
                <a:gd name="connsiteY12" fmla="*/ 0 h 683987"/>
                <a:gd name="connsiteX13" fmla="*/ 2996697 w 5135879"/>
                <a:gd name="connsiteY13" fmla="*/ 9054 h 683987"/>
                <a:gd name="connsiteX14" fmla="*/ 3132499 w 5135879"/>
                <a:gd name="connsiteY14" fmla="*/ 18107 h 683987"/>
                <a:gd name="connsiteX15" fmla="*/ 3159659 w 5135879"/>
                <a:gd name="connsiteY15" fmla="*/ 36214 h 683987"/>
                <a:gd name="connsiteX16" fmla="*/ 3213980 w 5135879"/>
                <a:gd name="connsiteY16" fmla="*/ 63374 h 683987"/>
                <a:gd name="connsiteX17" fmla="*/ 3268301 w 5135879"/>
                <a:gd name="connsiteY17" fmla="*/ 99588 h 683987"/>
                <a:gd name="connsiteX18" fmla="*/ 3295461 w 5135879"/>
                <a:gd name="connsiteY18" fmla="*/ 117695 h 683987"/>
                <a:gd name="connsiteX19" fmla="*/ 3395049 w 5135879"/>
                <a:gd name="connsiteY19" fmla="*/ 126749 h 683987"/>
                <a:gd name="connsiteX20" fmla="*/ 3422210 w 5135879"/>
                <a:gd name="connsiteY20" fmla="*/ 135802 h 683987"/>
                <a:gd name="connsiteX21" fmla="*/ 3449370 w 5135879"/>
                <a:gd name="connsiteY21" fmla="*/ 162963 h 683987"/>
                <a:gd name="connsiteX22" fmla="*/ 3467477 w 5135879"/>
                <a:gd name="connsiteY22" fmla="*/ 190123 h 683987"/>
                <a:gd name="connsiteX23" fmla="*/ 3521798 w 5135879"/>
                <a:gd name="connsiteY23" fmla="*/ 226337 h 683987"/>
                <a:gd name="connsiteX24" fmla="*/ 3548958 w 5135879"/>
                <a:gd name="connsiteY24" fmla="*/ 253497 h 683987"/>
                <a:gd name="connsiteX25" fmla="*/ 3612332 w 5135879"/>
                <a:gd name="connsiteY25" fmla="*/ 262551 h 683987"/>
                <a:gd name="connsiteX26" fmla="*/ 3675707 w 5135879"/>
                <a:gd name="connsiteY26" fmla="*/ 280658 h 683987"/>
                <a:gd name="connsiteX27" fmla="*/ 3702867 w 5135879"/>
                <a:gd name="connsiteY27" fmla="*/ 289711 h 683987"/>
                <a:gd name="connsiteX28" fmla="*/ 3793402 w 5135879"/>
                <a:gd name="connsiteY28" fmla="*/ 307818 h 683987"/>
                <a:gd name="connsiteX29" fmla="*/ 3883936 w 5135879"/>
                <a:gd name="connsiteY29" fmla="*/ 334978 h 683987"/>
                <a:gd name="connsiteX30" fmla="*/ 3920150 w 5135879"/>
                <a:gd name="connsiteY30" fmla="*/ 353085 h 683987"/>
                <a:gd name="connsiteX31" fmla="*/ 3947311 w 5135879"/>
                <a:gd name="connsiteY31" fmla="*/ 362139 h 683987"/>
                <a:gd name="connsiteX32" fmla="*/ 4200808 w 5135879"/>
                <a:gd name="connsiteY32" fmla="*/ 380246 h 683987"/>
                <a:gd name="connsiteX33" fmla="*/ 4409037 w 5135879"/>
                <a:gd name="connsiteY33" fmla="*/ 398353 h 683987"/>
                <a:gd name="connsiteX34" fmla="*/ 4472412 w 5135879"/>
                <a:gd name="connsiteY34" fmla="*/ 407406 h 683987"/>
                <a:gd name="connsiteX35" fmla="*/ 4508625 w 5135879"/>
                <a:gd name="connsiteY35" fmla="*/ 416460 h 683987"/>
                <a:gd name="connsiteX36" fmla="*/ 4689695 w 5135879"/>
                <a:gd name="connsiteY36" fmla="*/ 434567 h 683987"/>
                <a:gd name="connsiteX37" fmla="*/ 5069940 w 5135879"/>
                <a:gd name="connsiteY37" fmla="*/ 443620 h 683987"/>
                <a:gd name="connsiteX38" fmla="*/ 5097101 w 5135879"/>
                <a:gd name="connsiteY38" fmla="*/ 452673 h 683987"/>
                <a:gd name="connsiteX39" fmla="*/ 5133315 w 5135879"/>
                <a:gd name="connsiteY39" fmla="*/ 443620 h 683987"/>
                <a:gd name="connsiteX40" fmla="*/ 5069940 w 5135879"/>
                <a:gd name="connsiteY40" fmla="*/ 452673 h 683987"/>
                <a:gd name="connsiteX41" fmla="*/ 5042780 w 5135879"/>
                <a:gd name="connsiteY41" fmla="*/ 461727 h 683987"/>
                <a:gd name="connsiteX42" fmla="*/ 4997513 w 5135879"/>
                <a:gd name="connsiteY42" fmla="*/ 470780 h 683987"/>
                <a:gd name="connsiteX43" fmla="*/ 4961299 w 5135879"/>
                <a:gd name="connsiteY43" fmla="*/ 479834 h 683987"/>
                <a:gd name="connsiteX44" fmla="*/ 4762122 w 5135879"/>
                <a:gd name="connsiteY44" fmla="*/ 506994 h 683987"/>
                <a:gd name="connsiteX45" fmla="*/ 4680641 w 5135879"/>
                <a:gd name="connsiteY45" fmla="*/ 525101 h 683987"/>
                <a:gd name="connsiteX46" fmla="*/ 4164594 w 5135879"/>
                <a:gd name="connsiteY46" fmla="*/ 516048 h 683987"/>
                <a:gd name="connsiteX47" fmla="*/ 4137433 w 5135879"/>
                <a:gd name="connsiteY47" fmla="*/ 525101 h 683987"/>
                <a:gd name="connsiteX48" fmla="*/ 3811509 w 5135879"/>
                <a:gd name="connsiteY48" fmla="*/ 534155 h 683987"/>
                <a:gd name="connsiteX49" fmla="*/ 3902043 w 5135879"/>
                <a:gd name="connsiteY49" fmla="*/ 552262 h 683987"/>
                <a:gd name="connsiteX50" fmla="*/ 3929204 w 5135879"/>
                <a:gd name="connsiteY50" fmla="*/ 570369 h 683987"/>
                <a:gd name="connsiteX51" fmla="*/ 4046899 w 5135879"/>
                <a:gd name="connsiteY51" fmla="*/ 606582 h 683987"/>
                <a:gd name="connsiteX52" fmla="*/ 4092166 w 5135879"/>
                <a:gd name="connsiteY52" fmla="*/ 615636 h 683987"/>
                <a:gd name="connsiteX53" fmla="*/ 4155540 w 5135879"/>
                <a:gd name="connsiteY53" fmla="*/ 642796 h 683987"/>
                <a:gd name="connsiteX54" fmla="*/ 4218915 w 5135879"/>
                <a:gd name="connsiteY54" fmla="*/ 651850 h 683987"/>
                <a:gd name="connsiteX55" fmla="*/ 4191754 w 5135879"/>
                <a:gd name="connsiteY55" fmla="*/ 669957 h 683987"/>
                <a:gd name="connsiteX56" fmla="*/ 3766241 w 5135879"/>
                <a:gd name="connsiteY56" fmla="*/ 651850 h 683987"/>
                <a:gd name="connsiteX57" fmla="*/ 3485584 w 5135879"/>
                <a:gd name="connsiteY57" fmla="*/ 660903 h 683987"/>
                <a:gd name="connsiteX58" fmla="*/ 3431263 w 5135879"/>
                <a:gd name="connsiteY58" fmla="*/ 651850 h 683987"/>
                <a:gd name="connsiteX59" fmla="*/ 2833734 w 5135879"/>
                <a:gd name="connsiteY59" fmla="*/ 660903 h 683987"/>
                <a:gd name="connsiteX60" fmla="*/ 2544023 w 5135879"/>
                <a:gd name="connsiteY60" fmla="*/ 679010 h 683987"/>
                <a:gd name="connsiteX61" fmla="*/ 1638677 w 5135879"/>
                <a:gd name="connsiteY61" fmla="*/ 660903 h 683987"/>
                <a:gd name="connsiteX62" fmla="*/ 1539089 w 5135879"/>
                <a:gd name="connsiteY62" fmla="*/ 651850 h 683987"/>
                <a:gd name="connsiteX63" fmla="*/ 1502875 w 5135879"/>
                <a:gd name="connsiteY63" fmla="*/ 642796 h 683987"/>
                <a:gd name="connsiteX64" fmla="*/ 1358019 w 5135879"/>
                <a:gd name="connsiteY64" fmla="*/ 633743 h 683987"/>
                <a:gd name="connsiteX65" fmla="*/ 1312752 w 5135879"/>
                <a:gd name="connsiteY65" fmla="*/ 606582 h 683987"/>
                <a:gd name="connsiteX66" fmla="*/ 1050202 w 5135879"/>
                <a:gd name="connsiteY66" fmla="*/ 579422 h 683987"/>
                <a:gd name="connsiteX67" fmla="*/ 1013988 w 5135879"/>
                <a:gd name="connsiteY67" fmla="*/ 570369 h 683987"/>
                <a:gd name="connsiteX68" fmla="*/ 986827 w 5135879"/>
                <a:gd name="connsiteY68" fmla="*/ 561315 h 683987"/>
                <a:gd name="connsiteX69" fmla="*/ 488887 w 5135879"/>
                <a:gd name="connsiteY69" fmla="*/ 552262 h 683987"/>
                <a:gd name="connsiteX70" fmla="*/ 72427 w 5135879"/>
                <a:gd name="connsiteY70" fmla="*/ 534155 h 683987"/>
                <a:gd name="connsiteX71" fmla="*/ 54320 w 5135879"/>
                <a:gd name="connsiteY71" fmla="*/ 506994 h 683987"/>
                <a:gd name="connsiteX72" fmla="*/ 0 w 5135879"/>
                <a:gd name="connsiteY72" fmla="*/ 516048 h 683987"/>
                <a:gd name="connsiteX73" fmla="*/ 54320 w 5135879"/>
                <a:gd name="connsiteY73" fmla="*/ 525101 h 683987"/>
                <a:gd name="connsiteX74" fmla="*/ 90534 w 5135879"/>
                <a:gd name="connsiteY74" fmla="*/ 534155 h 683987"/>
                <a:gd name="connsiteX75" fmla="*/ 434566 w 5135879"/>
                <a:gd name="connsiteY75" fmla="*/ 525101 h 683987"/>
                <a:gd name="connsiteX76" fmla="*/ 552261 w 5135879"/>
                <a:gd name="connsiteY76" fmla="*/ 506994 h 683987"/>
                <a:gd name="connsiteX77" fmla="*/ 905346 w 5135879"/>
                <a:gd name="connsiteY77" fmla="*/ 488887 h 683987"/>
                <a:gd name="connsiteX78" fmla="*/ 932507 w 5135879"/>
                <a:gd name="connsiteY78" fmla="*/ 479834 h 683987"/>
                <a:gd name="connsiteX79" fmla="*/ 787651 w 5135879"/>
                <a:gd name="connsiteY79" fmla="*/ 461727 h 683987"/>
                <a:gd name="connsiteX80" fmla="*/ 706170 w 5135879"/>
                <a:gd name="connsiteY80" fmla="*/ 434567 h 683987"/>
                <a:gd name="connsiteX81" fmla="*/ 778598 w 5135879"/>
                <a:gd name="connsiteY81" fmla="*/ 425513 h 683987"/>
                <a:gd name="connsiteX82" fmla="*/ 905346 w 5135879"/>
                <a:gd name="connsiteY82" fmla="*/ 416460 h 683987"/>
                <a:gd name="connsiteX83" fmla="*/ 923453 w 5135879"/>
                <a:gd name="connsiteY83" fmla="*/ 380246 h 683987"/>
                <a:gd name="connsiteX84" fmla="*/ 1068309 w 5135879"/>
                <a:gd name="connsiteY84" fmla="*/ 371192 h 683987"/>
                <a:gd name="connsiteX85" fmla="*/ 1122629 w 5135879"/>
                <a:gd name="connsiteY85" fmla="*/ 362139 h 683987"/>
                <a:gd name="connsiteX86" fmla="*/ 968720 w 5135879"/>
                <a:gd name="connsiteY86" fmla="*/ 353085 h 683987"/>
                <a:gd name="connsiteX87" fmla="*/ 995881 w 5135879"/>
                <a:gd name="connsiteY87" fmla="*/ 334978 h 683987"/>
                <a:gd name="connsiteX88" fmla="*/ 1041148 w 5135879"/>
                <a:gd name="connsiteY88" fmla="*/ 316871 h 683987"/>
                <a:gd name="connsiteX89" fmla="*/ 1258431 w 5135879"/>
                <a:gd name="connsiteY89" fmla="*/ 307818 h 683987"/>
                <a:gd name="connsiteX90" fmla="*/ 1339913 w 5135879"/>
                <a:gd name="connsiteY90" fmla="*/ 298765 h 683987"/>
                <a:gd name="connsiteX91" fmla="*/ 1403287 w 5135879"/>
                <a:gd name="connsiteY91" fmla="*/ 280658 h 683987"/>
                <a:gd name="connsiteX92" fmla="*/ 1430447 w 5135879"/>
                <a:gd name="connsiteY92" fmla="*/ 262551 h 683987"/>
                <a:gd name="connsiteX93" fmla="*/ 1457608 w 5135879"/>
                <a:gd name="connsiteY93" fmla="*/ 235390 h 683987"/>
                <a:gd name="connsiteX94" fmla="*/ 1530035 w 5135879"/>
                <a:gd name="connsiteY94" fmla="*/ 226337 h 683987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  <a:cxn ang="0">
                  <a:pos x="connsiteX19" y="connsiteY19"/>
                </a:cxn>
                <a:cxn ang="0">
                  <a:pos x="connsiteX20" y="connsiteY20"/>
                </a:cxn>
                <a:cxn ang="0">
                  <a:pos x="connsiteX21" y="connsiteY21"/>
                </a:cxn>
                <a:cxn ang="0">
                  <a:pos x="connsiteX22" y="connsiteY22"/>
                </a:cxn>
                <a:cxn ang="0">
                  <a:pos x="connsiteX23" y="connsiteY23"/>
                </a:cxn>
                <a:cxn ang="0">
                  <a:pos x="connsiteX24" y="connsiteY24"/>
                </a:cxn>
                <a:cxn ang="0">
                  <a:pos x="connsiteX25" y="connsiteY25"/>
                </a:cxn>
                <a:cxn ang="0">
                  <a:pos x="connsiteX26" y="connsiteY26"/>
                </a:cxn>
                <a:cxn ang="0">
                  <a:pos x="connsiteX27" y="connsiteY27"/>
                </a:cxn>
                <a:cxn ang="0">
                  <a:pos x="connsiteX28" y="connsiteY28"/>
                </a:cxn>
                <a:cxn ang="0">
                  <a:pos x="connsiteX29" y="connsiteY29"/>
                </a:cxn>
                <a:cxn ang="0">
                  <a:pos x="connsiteX30" y="connsiteY30"/>
                </a:cxn>
                <a:cxn ang="0">
                  <a:pos x="connsiteX31" y="connsiteY31"/>
                </a:cxn>
                <a:cxn ang="0">
                  <a:pos x="connsiteX32" y="connsiteY32"/>
                </a:cxn>
                <a:cxn ang="0">
                  <a:pos x="connsiteX33" y="connsiteY33"/>
                </a:cxn>
                <a:cxn ang="0">
                  <a:pos x="connsiteX34" y="connsiteY34"/>
                </a:cxn>
                <a:cxn ang="0">
                  <a:pos x="connsiteX35" y="connsiteY35"/>
                </a:cxn>
                <a:cxn ang="0">
                  <a:pos x="connsiteX36" y="connsiteY36"/>
                </a:cxn>
                <a:cxn ang="0">
                  <a:pos x="connsiteX37" y="connsiteY37"/>
                </a:cxn>
                <a:cxn ang="0">
                  <a:pos x="connsiteX38" y="connsiteY38"/>
                </a:cxn>
                <a:cxn ang="0">
                  <a:pos x="connsiteX39" y="connsiteY39"/>
                </a:cxn>
                <a:cxn ang="0">
                  <a:pos x="connsiteX40" y="connsiteY40"/>
                </a:cxn>
                <a:cxn ang="0">
                  <a:pos x="connsiteX41" y="connsiteY41"/>
                </a:cxn>
                <a:cxn ang="0">
                  <a:pos x="connsiteX42" y="connsiteY42"/>
                </a:cxn>
                <a:cxn ang="0">
                  <a:pos x="connsiteX43" y="connsiteY43"/>
                </a:cxn>
                <a:cxn ang="0">
                  <a:pos x="connsiteX44" y="connsiteY44"/>
                </a:cxn>
                <a:cxn ang="0">
                  <a:pos x="connsiteX45" y="connsiteY45"/>
                </a:cxn>
                <a:cxn ang="0">
                  <a:pos x="connsiteX46" y="connsiteY46"/>
                </a:cxn>
                <a:cxn ang="0">
                  <a:pos x="connsiteX47" y="connsiteY47"/>
                </a:cxn>
                <a:cxn ang="0">
                  <a:pos x="connsiteX48" y="connsiteY48"/>
                </a:cxn>
                <a:cxn ang="0">
                  <a:pos x="connsiteX49" y="connsiteY49"/>
                </a:cxn>
                <a:cxn ang="0">
                  <a:pos x="connsiteX50" y="connsiteY50"/>
                </a:cxn>
                <a:cxn ang="0">
                  <a:pos x="connsiteX51" y="connsiteY51"/>
                </a:cxn>
                <a:cxn ang="0">
                  <a:pos x="connsiteX52" y="connsiteY52"/>
                </a:cxn>
                <a:cxn ang="0">
                  <a:pos x="connsiteX53" y="connsiteY53"/>
                </a:cxn>
                <a:cxn ang="0">
                  <a:pos x="connsiteX54" y="connsiteY54"/>
                </a:cxn>
                <a:cxn ang="0">
                  <a:pos x="connsiteX55" y="connsiteY55"/>
                </a:cxn>
                <a:cxn ang="0">
                  <a:pos x="connsiteX56" y="connsiteY56"/>
                </a:cxn>
                <a:cxn ang="0">
                  <a:pos x="connsiteX57" y="connsiteY57"/>
                </a:cxn>
                <a:cxn ang="0">
                  <a:pos x="connsiteX58" y="connsiteY58"/>
                </a:cxn>
                <a:cxn ang="0">
                  <a:pos x="connsiteX59" y="connsiteY59"/>
                </a:cxn>
                <a:cxn ang="0">
                  <a:pos x="connsiteX60" y="connsiteY60"/>
                </a:cxn>
                <a:cxn ang="0">
                  <a:pos x="connsiteX61" y="connsiteY61"/>
                </a:cxn>
                <a:cxn ang="0">
                  <a:pos x="connsiteX62" y="connsiteY62"/>
                </a:cxn>
                <a:cxn ang="0">
                  <a:pos x="connsiteX63" y="connsiteY63"/>
                </a:cxn>
                <a:cxn ang="0">
                  <a:pos x="connsiteX64" y="connsiteY64"/>
                </a:cxn>
                <a:cxn ang="0">
                  <a:pos x="connsiteX65" y="connsiteY65"/>
                </a:cxn>
                <a:cxn ang="0">
                  <a:pos x="connsiteX66" y="connsiteY66"/>
                </a:cxn>
                <a:cxn ang="0">
                  <a:pos x="connsiteX67" y="connsiteY67"/>
                </a:cxn>
                <a:cxn ang="0">
                  <a:pos x="connsiteX68" y="connsiteY68"/>
                </a:cxn>
                <a:cxn ang="0">
                  <a:pos x="connsiteX69" y="connsiteY69"/>
                </a:cxn>
                <a:cxn ang="0">
                  <a:pos x="connsiteX70" y="connsiteY70"/>
                </a:cxn>
                <a:cxn ang="0">
                  <a:pos x="connsiteX71" y="connsiteY71"/>
                </a:cxn>
                <a:cxn ang="0">
                  <a:pos x="connsiteX72" y="connsiteY72"/>
                </a:cxn>
                <a:cxn ang="0">
                  <a:pos x="connsiteX73" y="connsiteY73"/>
                </a:cxn>
                <a:cxn ang="0">
                  <a:pos x="connsiteX74" y="connsiteY74"/>
                </a:cxn>
                <a:cxn ang="0">
                  <a:pos x="connsiteX75" y="connsiteY75"/>
                </a:cxn>
                <a:cxn ang="0">
                  <a:pos x="connsiteX76" y="connsiteY76"/>
                </a:cxn>
                <a:cxn ang="0">
                  <a:pos x="connsiteX77" y="connsiteY77"/>
                </a:cxn>
                <a:cxn ang="0">
                  <a:pos x="connsiteX78" y="connsiteY78"/>
                </a:cxn>
                <a:cxn ang="0">
                  <a:pos x="connsiteX79" y="connsiteY79"/>
                </a:cxn>
                <a:cxn ang="0">
                  <a:pos x="connsiteX80" y="connsiteY80"/>
                </a:cxn>
                <a:cxn ang="0">
                  <a:pos x="connsiteX81" y="connsiteY81"/>
                </a:cxn>
                <a:cxn ang="0">
                  <a:pos x="connsiteX82" y="connsiteY82"/>
                </a:cxn>
                <a:cxn ang="0">
                  <a:pos x="connsiteX83" y="connsiteY83"/>
                </a:cxn>
                <a:cxn ang="0">
                  <a:pos x="connsiteX84" y="connsiteY84"/>
                </a:cxn>
                <a:cxn ang="0">
                  <a:pos x="connsiteX85" y="connsiteY85"/>
                </a:cxn>
                <a:cxn ang="0">
                  <a:pos x="connsiteX86" y="connsiteY86"/>
                </a:cxn>
                <a:cxn ang="0">
                  <a:pos x="connsiteX87" y="connsiteY87"/>
                </a:cxn>
                <a:cxn ang="0">
                  <a:pos x="connsiteX88" y="connsiteY88"/>
                </a:cxn>
                <a:cxn ang="0">
                  <a:pos x="connsiteX89" y="connsiteY89"/>
                </a:cxn>
                <a:cxn ang="0">
                  <a:pos x="connsiteX90" y="connsiteY90"/>
                </a:cxn>
                <a:cxn ang="0">
                  <a:pos x="connsiteX91" y="connsiteY91"/>
                </a:cxn>
                <a:cxn ang="0">
                  <a:pos x="connsiteX92" y="connsiteY92"/>
                </a:cxn>
                <a:cxn ang="0">
                  <a:pos x="connsiteX93" y="connsiteY93"/>
                </a:cxn>
                <a:cxn ang="0">
                  <a:pos x="connsiteX94" y="connsiteY94"/>
                </a:cxn>
              </a:cxnLst>
              <a:rect l="l" t="t" r="r" b="b"/>
              <a:pathLst>
                <a:path w="5135879" h="683987">
                  <a:moveTo>
                    <a:pt x="1439501" y="253497"/>
                  </a:moveTo>
                  <a:cubicBezTo>
                    <a:pt x="1454590" y="238408"/>
                    <a:pt x="1468709" y="222282"/>
                    <a:pt x="1484768" y="208230"/>
                  </a:cubicBezTo>
                  <a:cubicBezTo>
                    <a:pt x="1492957" y="201065"/>
                    <a:pt x="1502481" y="195521"/>
                    <a:pt x="1511928" y="190123"/>
                  </a:cubicBezTo>
                  <a:cubicBezTo>
                    <a:pt x="1543254" y="172222"/>
                    <a:pt x="1544831" y="173120"/>
                    <a:pt x="1575303" y="162963"/>
                  </a:cubicBezTo>
                  <a:cubicBezTo>
                    <a:pt x="1591617" y="146648"/>
                    <a:pt x="1607565" y="127148"/>
                    <a:pt x="1629623" y="117695"/>
                  </a:cubicBezTo>
                  <a:cubicBezTo>
                    <a:pt x="1641060" y="112794"/>
                    <a:pt x="1653873" y="112060"/>
                    <a:pt x="1665837" y="108642"/>
                  </a:cubicBezTo>
                  <a:cubicBezTo>
                    <a:pt x="1675013" y="106020"/>
                    <a:pt x="1683542" y="100877"/>
                    <a:pt x="1692998" y="99588"/>
                  </a:cubicBezTo>
                  <a:cubicBezTo>
                    <a:pt x="1750125" y="91798"/>
                    <a:pt x="1865014" y="81481"/>
                    <a:pt x="1865014" y="81481"/>
                  </a:cubicBezTo>
                  <a:cubicBezTo>
                    <a:pt x="1983445" y="51874"/>
                    <a:pt x="1850668" y="82437"/>
                    <a:pt x="2136617" y="63374"/>
                  </a:cubicBezTo>
                  <a:cubicBezTo>
                    <a:pt x="2149032" y="62546"/>
                    <a:pt x="2160630" y="56761"/>
                    <a:pt x="2172831" y="54321"/>
                  </a:cubicBezTo>
                  <a:cubicBezTo>
                    <a:pt x="2190831" y="50721"/>
                    <a:pt x="2209045" y="48286"/>
                    <a:pt x="2227152" y="45268"/>
                  </a:cubicBezTo>
                  <a:cubicBezTo>
                    <a:pt x="2284915" y="6760"/>
                    <a:pt x="2234694" y="34001"/>
                    <a:pt x="2353901" y="18107"/>
                  </a:cubicBezTo>
                  <a:cubicBezTo>
                    <a:pt x="2372854" y="15580"/>
                    <a:pt x="2398650" y="6209"/>
                    <a:pt x="2417275" y="0"/>
                  </a:cubicBezTo>
                  <a:lnTo>
                    <a:pt x="2996697" y="9054"/>
                  </a:lnTo>
                  <a:cubicBezTo>
                    <a:pt x="3042050" y="10202"/>
                    <a:pt x="3087748" y="10649"/>
                    <a:pt x="3132499" y="18107"/>
                  </a:cubicBezTo>
                  <a:cubicBezTo>
                    <a:pt x="3143232" y="19896"/>
                    <a:pt x="3149927" y="31348"/>
                    <a:pt x="3159659" y="36214"/>
                  </a:cubicBezTo>
                  <a:cubicBezTo>
                    <a:pt x="3200486" y="56628"/>
                    <a:pt x="3175065" y="30946"/>
                    <a:pt x="3213980" y="63374"/>
                  </a:cubicBezTo>
                  <a:cubicBezTo>
                    <a:pt x="3259193" y="101051"/>
                    <a:pt x="3220567" y="83678"/>
                    <a:pt x="3268301" y="99588"/>
                  </a:cubicBezTo>
                  <a:cubicBezTo>
                    <a:pt x="3277354" y="105624"/>
                    <a:pt x="3284822" y="115415"/>
                    <a:pt x="3295461" y="117695"/>
                  </a:cubicBezTo>
                  <a:cubicBezTo>
                    <a:pt x="3328054" y="124679"/>
                    <a:pt x="3362051" y="122035"/>
                    <a:pt x="3395049" y="126749"/>
                  </a:cubicBezTo>
                  <a:cubicBezTo>
                    <a:pt x="3404496" y="128099"/>
                    <a:pt x="3413156" y="132784"/>
                    <a:pt x="3422210" y="135802"/>
                  </a:cubicBezTo>
                  <a:cubicBezTo>
                    <a:pt x="3431263" y="144856"/>
                    <a:pt x="3441173" y="153127"/>
                    <a:pt x="3449370" y="162963"/>
                  </a:cubicBezTo>
                  <a:cubicBezTo>
                    <a:pt x="3456336" y="171322"/>
                    <a:pt x="3459288" y="182958"/>
                    <a:pt x="3467477" y="190123"/>
                  </a:cubicBezTo>
                  <a:cubicBezTo>
                    <a:pt x="3483855" y="204453"/>
                    <a:pt x="3506410" y="210949"/>
                    <a:pt x="3521798" y="226337"/>
                  </a:cubicBezTo>
                  <a:cubicBezTo>
                    <a:pt x="3530851" y="235390"/>
                    <a:pt x="3537070" y="248742"/>
                    <a:pt x="3548958" y="253497"/>
                  </a:cubicBezTo>
                  <a:cubicBezTo>
                    <a:pt x="3568771" y="261422"/>
                    <a:pt x="3591207" y="259533"/>
                    <a:pt x="3612332" y="262551"/>
                  </a:cubicBezTo>
                  <a:cubicBezTo>
                    <a:pt x="3677461" y="284259"/>
                    <a:pt x="3596122" y="257919"/>
                    <a:pt x="3675707" y="280658"/>
                  </a:cubicBezTo>
                  <a:cubicBezTo>
                    <a:pt x="3684883" y="283280"/>
                    <a:pt x="3693568" y="287565"/>
                    <a:pt x="3702867" y="289711"/>
                  </a:cubicBezTo>
                  <a:cubicBezTo>
                    <a:pt x="3732855" y="296631"/>
                    <a:pt x="3764205" y="298086"/>
                    <a:pt x="3793402" y="307818"/>
                  </a:cubicBezTo>
                  <a:cubicBezTo>
                    <a:pt x="3859526" y="329860"/>
                    <a:pt x="3829206" y="321296"/>
                    <a:pt x="3883936" y="334978"/>
                  </a:cubicBezTo>
                  <a:cubicBezTo>
                    <a:pt x="3896007" y="341014"/>
                    <a:pt x="3907745" y="347769"/>
                    <a:pt x="3920150" y="353085"/>
                  </a:cubicBezTo>
                  <a:cubicBezTo>
                    <a:pt x="3928922" y="356844"/>
                    <a:pt x="3938135" y="359517"/>
                    <a:pt x="3947311" y="362139"/>
                  </a:cubicBezTo>
                  <a:cubicBezTo>
                    <a:pt x="4038255" y="388123"/>
                    <a:pt x="4061951" y="374460"/>
                    <a:pt x="4200808" y="380246"/>
                  </a:cubicBezTo>
                  <a:lnTo>
                    <a:pt x="4409037" y="398353"/>
                  </a:lnTo>
                  <a:cubicBezTo>
                    <a:pt x="4430271" y="400476"/>
                    <a:pt x="4451417" y="403589"/>
                    <a:pt x="4472412" y="407406"/>
                  </a:cubicBezTo>
                  <a:cubicBezTo>
                    <a:pt x="4484654" y="409632"/>
                    <a:pt x="4496279" y="414917"/>
                    <a:pt x="4508625" y="416460"/>
                  </a:cubicBezTo>
                  <a:cubicBezTo>
                    <a:pt x="4568814" y="423984"/>
                    <a:pt x="4629108" y="431635"/>
                    <a:pt x="4689695" y="434567"/>
                  </a:cubicBezTo>
                  <a:cubicBezTo>
                    <a:pt x="4816331" y="440694"/>
                    <a:pt x="4943192" y="440602"/>
                    <a:pt x="5069940" y="443620"/>
                  </a:cubicBezTo>
                  <a:cubicBezTo>
                    <a:pt x="5078994" y="446638"/>
                    <a:pt x="5087558" y="452673"/>
                    <a:pt x="5097101" y="452673"/>
                  </a:cubicBezTo>
                  <a:cubicBezTo>
                    <a:pt x="5109544" y="452673"/>
                    <a:pt x="5145758" y="443620"/>
                    <a:pt x="5133315" y="443620"/>
                  </a:cubicBezTo>
                  <a:cubicBezTo>
                    <a:pt x="5111976" y="443620"/>
                    <a:pt x="5091065" y="449655"/>
                    <a:pt x="5069940" y="452673"/>
                  </a:cubicBezTo>
                  <a:cubicBezTo>
                    <a:pt x="5060887" y="455691"/>
                    <a:pt x="5052038" y="459412"/>
                    <a:pt x="5042780" y="461727"/>
                  </a:cubicBezTo>
                  <a:cubicBezTo>
                    <a:pt x="5027852" y="465459"/>
                    <a:pt x="5012534" y="467442"/>
                    <a:pt x="4997513" y="470780"/>
                  </a:cubicBezTo>
                  <a:cubicBezTo>
                    <a:pt x="4985366" y="473479"/>
                    <a:pt x="4973370" y="476816"/>
                    <a:pt x="4961299" y="479834"/>
                  </a:cubicBezTo>
                  <a:cubicBezTo>
                    <a:pt x="4882986" y="532041"/>
                    <a:pt x="4962822" y="485491"/>
                    <a:pt x="4762122" y="506994"/>
                  </a:cubicBezTo>
                  <a:cubicBezTo>
                    <a:pt x="4734457" y="509958"/>
                    <a:pt x="4707801" y="519065"/>
                    <a:pt x="4680641" y="525101"/>
                  </a:cubicBezTo>
                  <a:lnTo>
                    <a:pt x="4164594" y="516048"/>
                  </a:lnTo>
                  <a:cubicBezTo>
                    <a:pt x="4155051" y="516048"/>
                    <a:pt x="4146964" y="524612"/>
                    <a:pt x="4137433" y="525101"/>
                  </a:cubicBezTo>
                  <a:cubicBezTo>
                    <a:pt x="4028892" y="530667"/>
                    <a:pt x="3920150" y="531137"/>
                    <a:pt x="3811509" y="534155"/>
                  </a:cubicBezTo>
                  <a:cubicBezTo>
                    <a:pt x="3834871" y="537492"/>
                    <a:pt x="3876758" y="539619"/>
                    <a:pt x="3902043" y="552262"/>
                  </a:cubicBezTo>
                  <a:cubicBezTo>
                    <a:pt x="3911775" y="557128"/>
                    <a:pt x="3919160" y="566184"/>
                    <a:pt x="3929204" y="570369"/>
                  </a:cubicBezTo>
                  <a:cubicBezTo>
                    <a:pt x="3961487" y="583820"/>
                    <a:pt x="4009423" y="598254"/>
                    <a:pt x="4046899" y="606582"/>
                  </a:cubicBezTo>
                  <a:cubicBezTo>
                    <a:pt x="4061920" y="609920"/>
                    <a:pt x="4077077" y="612618"/>
                    <a:pt x="4092166" y="615636"/>
                  </a:cubicBezTo>
                  <a:cubicBezTo>
                    <a:pt x="4111799" y="625452"/>
                    <a:pt x="4133336" y="638355"/>
                    <a:pt x="4155540" y="642796"/>
                  </a:cubicBezTo>
                  <a:cubicBezTo>
                    <a:pt x="4176465" y="646981"/>
                    <a:pt x="4197790" y="648832"/>
                    <a:pt x="4218915" y="651850"/>
                  </a:cubicBezTo>
                  <a:cubicBezTo>
                    <a:pt x="4209861" y="657886"/>
                    <a:pt x="4202633" y="669721"/>
                    <a:pt x="4191754" y="669957"/>
                  </a:cubicBezTo>
                  <a:cubicBezTo>
                    <a:pt x="3856540" y="677244"/>
                    <a:pt x="3922004" y="690789"/>
                    <a:pt x="3766241" y="651850"/>
                  </a:cubicBezTo>
                  <a:cubicBezTo>
                    <a:pt x="3672689" y="654868"/>
                    <a:pt x="3579185" y="660903"/>
                    <a:pt x="3485584" y="660903"/>
                  </a:cubicBezTo>
                  <a:cubicBezTo>
                    <a:pt x="3467227" y="660903"/>
                    <a:pt x="3449620" y="651850"/>
                    <a:pt x="3431263" y="651850"/>
                  </a:cubicBezTo>
                  <a:cubicBezTo>
                    <a:pt x="3232064" y="651850"/>
                    <a:pt x="3032910" y="657885"/>
                    <a:pt x="2833734" y="660903"/>
                  </a:cubicBezTo>
                  <a:cubicBezTo>
                    <a:pt x="2727171" y="696427"/>
                    <a:pt x="2782424" y="680858"/>
                    <a:pt x="2544023" y="679010"/>
                  </a:cubicBezTo>
                  <a:cubicBezTo>
                    <a:pt x="2242190" y="676670"/>
                    <a:pt x="1940459" y="666939"/>
                    <a:pt x="1638677" y="660903"/>
                  </a:cubicBezTo>
                  <a:cubicBezTo>
                    <a:pt x="1605481" y="657885"/>
                    <a:pt x="1572129" y="656255"/>
                    <a:pt x="1539089" y="651850"/>
                  </a:cubicBezTo>
                  <a:cubicBezTo>
                    <a:pt x="1526755" y="650205"/>
                    <a:pt x="1515256" y="644034"/>
                    <a:pt x="1502875" y="642796"/>
                  </a:cubicBezTo>
                  <a:cubicBezTo>
                    <a:pt x="1454736" y="637982"/>
                    <a:pt x="1406304" y="636761"/>
                    <a:pt x="1358019" y="633743"/>
                  </a:cubicBezTo>
                  <a:cubicBezTo>
                    <a:pt x="1342930" y="624689"/>
                    <a:pt x="1329176" y="612899"/>
                    <a:pt x="1312752" y="606582"/>
                  </a:cubicBezTo>
                  <a:cubicBezTo>
                    <a:pt x="1232293" y="575636"/>
                    <a:pt x="1128733" y="583161"/>
                    <a:pt x="1050202" y="579422"/>
                  </a:cubicBezTo>
                  <a:cubicBezTo>
                    <a:pt x="1038131" y="576404"/>
                    <a:pt x="1025952" y="573787"/>
                    <a:pt x="1013988" y="570369"/>
                  </a:cubicBezTo>
                  <a:cubicBezTo>
                    <a:pt x="1004812" y="567747"/>
                    <a:pt x="996365" y="561644"/>
                    <a:pt x="986827" y="561315"/>
                  </a:cubicBezTo>
                  <a:cubicBezTo>
                    <a:pt x="820918" y="555594"/>
                    <a:pt x="654867" y="555280"/>
                    <a:pt x="488887" y="552262"/>
                  </a:cubicBezTo>
                  <a:cubicBezTo>
                    <a:pt x="313421" y="508393"/>
                    <a:pt x="630724" y="584909"/>
                    <a:pt x="72427" y="534155"/>
                  </a:cubicBezTo>
                  <a:cubicBezTo>
                    <a:pt x="61591" y="533170"/>
                    <a:pt x="60356" y="516048"/>
                    <a:pt x="54320" y="506994"/>
                  </a:cubicBezTo>
                  <a:lnTo>
                    <a:pt x="0" y="516048"/>
                  </a:lnTo>
                  <a:cubicBezTo>
                    <a:pt x="0" y="534404"/>
                    <a:pt x="36320" y="521501"/>
                    <a:pt x="54320" y="525101"/>
                  </a:cubicBezTo>
                  <a:cubicBezTo>
                    <a:pt x="66521" y="527541"/>
                    <a:pt x="78463" y="531137"/>
                    <a:pt x="90534" y="534155"/>
                  </a:cubicBezTo>
                  <a:lnTo>
                    <a:pt x="434566" y="525101"/>
                  </a:lnTo>
                  <a:cubicBezTo>
                    <a:pt x="811578" y="509392"/>
                    <a:pt x="409175" y="527435"/>
                    <a:pt x="552261" y="506994"/>
                  </a:cubicBezTo>
                  <a:cubicBezTo>
                    <a:pt x="646932" y="493469"/>
                    <a:pt x="844608" y="491056"/>
                    <a:pt x="905346" y="488887"/>
                  </a:cubicBezTo>
                  <a:cubicBezTo>
                    <a:pt x="914400" y="485869"/>
                    <a:pt x="941561" y="482852"/>
                    <a:pt x="932507" y="479834"/>
                  </a:cubicBezTo>
                  <a:cubicBezTo>
                    <a:pt x="868018" y="458337"/>
                    <a:pt x="914861" y="471512"/>
                    <a:pt x="787651" y="461727"/>
                  </a:cubicBezTo>
                  <a:cubicBezTo>
                    <a:pt x="784395" y="460913"/>
                    <a:pt x="699353" y="441384"/>
                    <a:pt x="706170" y="434567"/>
                  </a:cubicBezTo>
                  <a:cubicBezTo>
                    <a:pt x="723375" y="417363"/>
                    <a:pt x="754367" y="427716"/>
                    <a:pt x="778598" y="425513"/>
                  </a:cubicBezTo>
                  <a:cubicBezTo>
                    <a:pt x="820781" y="421678"/>
                    <a:pt x="863097" y="419478"/>
                    <a:pt x="905346" y="416460"/>
                  </a:cubicBezTo>
                  <a:cubicBezTo>
                    <a:pt x="911382" y="404389"/>
                    <a:pt x="910449" y="383858"/>
                    <a:pt x="923453" y="380246"/>
                  </a:cubicBezTo>
                  <a:cubicBezTo>
                    <a:pt x="970068" y="367297"/>
                    <a:pt x="1020128" y="375572"/>
                    <a:pt x="1068309" y="371192"/>
                  </a:cubicBezTo>
                  <a:cubicBezTo>
                    <a:pt x="1086590" y="369530"/>
                    <a:pt x="1104522" y="365157"/>
                    <a:pt x="1122629" y="362139"/>
                  </a:cubicBezTo>
                  <a:cubicBezTo>
                    <a:pt x="1071326" y="359121"/>
                    <a:pt x="1018971" y="363853"/>
                    <a:pt x="968720" y="353085"/>
                  </a:cubicBezTo>
                  <a:cubicBezTo>
                    <a:pt x="958080" y="350805"/>
                    <a:pt x="986149" y="339844"/>
                    <a:pt x="995881" y="334978"/>
                  </a:cubicBezTo>
                  <a:cubicBezTo>
                    <a:pt x="1010417" y="327710"/>
                    <a:pt x="1024983" y="318543"/>
                    <a:pt x="1041148" y="316871"/>
                  </a:cubicBezTo>
                  <a:cubicBezTo>
                    <a:pt x="1113254" y="309412"/>
                    <a:pt x="1186003" y="310836"/>
                    <a:pt x="1258431" y="307818"/>
                  </a:cubicBezTo>
                  <a:cubicBezTo>
                    <a:pt x="1285592" y="304800"/>
                    <a:pt x="1312903" y="302920"/>
                    <a:pt x="1339913" y="298765"/>
                  </a:cubicBezTo>
                  <a:cubicBezTo>
                    <a:pt x="1361016" y="295518"/>
                    <a:pt x="1383012" y="287416"/>
                    <a:pt x="1403287" y="280658"/>
                  </a:cubicBezTo>
                  <a:cubicBezTo>
                    <a:pt x="1412340" y="274622"/>
                    <a:pt x="1422088" y="269517"/>
                    <a:pt x="1430447" y="262551"/>
                  </a:cubicBezTo>
                  <a:cubicBezTo>
                    <a:pt x="1440283" y="254354"/>
                    <a:pt x="1446491" y="241743"/>
                    <a:pt x="1457608" y="235390"/>
                  </a:cubicBezTo>
                  <a:cubicBezTo>
                    <a:pt x="1478574" y="223409"/>
                    <a:pt x="1507532" y="226337"/>
                    <a:pt x="1530035" y="226337"/>
                  </a:cubicBezTo>
                </a:path>
              </a:pathLst>
            </a:custGeom>
            <a:grpFill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endParaRPr lang="en-US" sz="1100">
                <a:latin typeface="Arial" panose="020B0604020202020204" pitchFamily="34" charset="0"/>
                <a:ea typeface="Arial Unicode MS" panose="020B0604020202020204" pitchFamily="34" charset="-122"/>
                <a:cs typeface="Arial" panose="020B0604020202020204" pitchFamily="34" charset="0"/>
              </a:endParaRPr>
            </a:p>
          </p:txBody>
        </p:sp>
        <p:sp>
          <p:nvSpPr>
            <p:cNvPr id="83" name="Oval 82"/>
            <p:cNvSpPr/>
            <p:nvPr/>
          </p:nvSpPr>
          <p:spPr>
            <a:xfrm>
              <a:off x="990600" y="609600"/>
              <a:ext cx="1219200" cy="463045"/>
            </a:xfrm>
            <a:prstGeom prst="ellipse">
              <a:avLst/>
            </a:prstGeom>
            <a:pattFill prst="pct10">
              <a:fgClr>
                <a:schemeClr val="bg1">
                  <a:lumMod val="75000"/>
                </a:schemeClr>
              </a:fgClr>
              <a:bgClr>
                <a:schemeClr val="bg1"/>
              </a:bgClr>
            </a:pattFill>
            <a:ln>
              <a:solidFill>
                <a:srgbClr val="BEBE04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sz="1200" b="1" dirty="0" smtClean="0">
                  <a:solidFill>
                    <a:schemeClr val="tx1"/>
                  </a:solidFill>
                  <a:latin typeface="Arial" panose="020B0604020202020204" pitchFamily="34" charset="0"/>
                  <a:ea typeface="Arial Unicode MS" panose="020B0604020202020204" pitchFamily="34" charset="-122"/>
                  <a:cs typeface="Arial" panose="020B0604020202020204" pitchFamily="34" charset="0"/>
                </a:rPr>
                <a:t>COX-2 </a:t>
              </a:r>
              <a:r>
                <a:rPr lang="en-US" sz="1200" b="1" baseline="30000" dirty="0" smtClean="0">
                  <a:solidFill>
                    <a:schemeClr val="tx1"/>
                  </a:solidFill>
                  <a:latin typeface="Arial" panose="020B0604020202020204" pitchFamily="34" charset="0"/>
                  <a:ea typeface="Arial Unicode MS" panose="020B0604020202020204" pitchFamily="34" charset="-122"/>
                  <a:cs typeface="Arial" panose="020B0604020202020204" pitchFamily="34" charset="0"/>
                </a:rPr>
                <a:t>-/-</a:t>
              </a:r>
              <a:endParaRPr lang="en-US" sz="1200" b="1" baseline="30000" dirty="0">
                <a:solidFill>
                  <a:schemeClr val="tx1"/>
                </a:solidFill>
                <a:latin typeface="Arial" panose="020B0604020202020204" pitchFamily="34" charset="0"/>
                <a:ea typeface="Arial Unicode MS" panose="020B0604020202020204" pitchFamily="34" charset="-122"/>
                <a:cs typeface="Arial" panose="020B0604020202020204" pitchFamily="34" charset="0"/>
              </a:endParaRPr>
            </a:p>
          </p:txBody>
        </p:sp>
      </p:grpSp>
      <p:sp>
        <p:nvSpPr>
          <p:cNvPr id="84" name="Curved Down Arrow 83"/>
          <p:cNvSpPr/>
          <p:nvPr/>
        </p:nvSpPr>
        <p:spPr>
          <a:xfrm rot="3901809">
            <a:off x="5051854" y="1706791"/>
            <a:ext cx="5119261" cy="1669639"/>
          </a:xfrm>
          <a:prstGeom prst="curvedDownArrow">
            <a:avLst/>
          </a:prstGeom>
          <a:pattFill prst="solidDmnd">
            <a:fgClr>
              <a:schemeClr val="bg1">
                <a:lumMod val="75000"/>
              </a:schemeClr>
            </a:fgClr>
            <a:bgClr>
              <a:schemeClr val="bg1"/>
            </a:bgClr>
          </a:patt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100">
              <a:solidFill>
                <a:schemeClr val="tx1"/>
              </a:solidFill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87" name="Curved Down Arrow 86"/>
          <p:cNvSpPr/>
          <p:nvPr/>
        </p:nvSpPr>
        <p:spPr>
          <a:xfrm rot="17895910" flipH="1">
            <a:off x="-1360936" y="1530256"/>
            <a:ext cx="5345453" cy="1971663"/>
          </a:xfrm>
          <a:prstGeom prst="curvedDownArrow">
            <a:avLst/>
          </a:prstGeom>
          <a:pattFill prst="wdUpDiag">
            <a:fgClr>
              <a:schemeClr val="bg1"/>
            </a:fgClr>
            <a:bgClr>
              <a:schemeClr val="bg1">
                <a:lumMod val="75000"/>
              </a:schemeClr>
            </a:bgClr>
          </a:patt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100">
              <a:solidFill>
                <a:schemeClr val="tx1"/>
              </a:solidFill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grpSp>
        <p:nvGrpSpPr>
          <p:cNvPr id="5" name="Group 4"/>
          <p:cNvGrpSpPr/>
          <p:nvPr/>
        </p:nvGrpSpPr>
        <p:grpSpPr>
          <a:xfrm>
            <a:off x="2214348" y="1142984"/>
            <a:ext cx="5456347" cy="3839572"/>
            <a:chOff x="1905000" y="1467118"/>
            <a:chExt cx="5414645" cy="3839572"/>
          </a:xfrm>
        </p:grpSpPr>
        <p:sp>
          <p:nvSpPr>
            <p:cNvPr id="4" name="TextBox 3"/>
            <p:cNvSpPr txBox="1"/>
            <p:nvPr/>
          </p:nvSpPr>
          <p:spPr>
            <a:xfrm>
              <a:off x="2895600" y="1467118"/>
              <a:ext cx="2574744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 smtClean="0">
                  <a:latin typeface="Arial" panose="020B0604020202020204" pitchFamily="34" charset="0"/>
                  <a:ea typeface="Arial Unicode MS" panose="020B0604020202020204" pitchFamily="34" charset="-122"/>
                  <a:cs typeface="Arial" panose="020B0604020202020204" pitchFamily="34" charset="0"/>
                </a:rPr>
                <a:t>Diacylglycerol or phospholipid</a:t>
              </a:r>
              <a:endParaRPr lang="en-US" sz="1400" dirty="0">
                <a:latin typeface="Arial" panose="020B0604020202020204" pitchFamily="34" charset="0"/>
                <a:ea typeface="Arial Unicode MS" panose="020B0604020202020204" pitchFamily="34" charset="-122"/>
                <a:cs typeface="Arial" panose="020B0604020202020204" pitchFamily="34" charset="0"/>
              </a:endParaRPr>
            </a:p>
          </p:txBody>
        </p:sp>
        <p:cxnSp>
          <p:nvCxnSpPr>
            <p:cNvPr id="6" name="Straight Arrow Connector 5"/>
            <p:cNvCxnSpPr/>
            <p:nvPr/>
          </p:nvCxnSpPr>
          <p:spPr>
            <a:xfrm>
              <a:off x="3962401" y="1752870"/>
              <a:ext cx="0" cy="612000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" name="TextBox 7"/>
            <p:cNvSpPr txBox="1"/>
            <p:nvPr/>
          </p:nvSpPr>
          <p:spPr>
            <a:xfrm>
              <a:off x="3379489" y="1848450"/>
              <a:ext cx="794252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b="1" dirty="0" smtClean="0">
                  <a:solidFill>
                    <a:srgbClr val="0070C0"/>
                  </a:solidFill>
                  <a:latin typeface="Arial" panose="020B0604020202020204" pitchFamily="34" charset="0"/>
                  <a:ea typeface="Arial Unicode MS" panose="020B0604020202020204" pitchFamily="34" charset="-122"/>
                  <a:cs typeface="Arial" panose="020B0604020202020204" pitchFamily="34" charset="0"/>
                </a:rPr>
                <a:t>cPLA</a:t>
              </a:r>
              <a:r>
                <a:rPr lang="en-US" sz="1100" b="1" baseline="-25000" dirty="0" smtClean="0">
                  <a:solidFill>
                    <a:srgbClr val="0070C0"/>
                  </a:solidFill>
                  <a:latin typeface="Arial" panose="020B0604020202020204" pitchFamily="34" charset="0"/>
                  <a:ea typeface="Arial Unicode MS" panose="020B0604020202020204" pitchFamily="34" charset="-122"/>
                  <a:cs typeface="Arial" panose="020B0604020202020204" pitchFamily="34" charset="0"/>
                </a:rPr>
                <a:t>2</a:t>
              </a:r>
              <a:endParaRPr lang="en-US" sz="1100" b="1" baseline="-25000" dirty="0">
                <a:solidFill>
                  <a:srgbClr val="0070C0"/>
                </a:solidFill>
                <a:latin typeface="Arial" panose="020B0604020202020204" pitchFamily="34" charset="0"/>
                <a:ea typeface="Arial Unicode MS" panose="020B0604020202020204" pitchFamily="34" charset="-122"/>
                <a:cs typeface="Arial" panose="020B0604020202020204" pitchFamily="34" charset="0"/>
              </a:endParaRPr>
            </a:p>
          </p:txBody>
        </p:sp>
        <p:sp>
          <p:nvSpPr>
            <p:cNvPr id="9" name="TextBox 8"/>
            <p:cNvSpPr txBox="1"/>
            <p:nvPr/>
          </p:nvSpPr>
          <p:spPr>
            <a:xfrm>
              <a:off x="3748389" y="2373787"/>
              <a:ext cx="421867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400" dirty="0" smtClean="0">
                  <a:latin typeface="Arial" panose="020B0604020202020204" pitchFamily="34" charset="0"/>
                  <a:ea typeface="Arial Unicode MS" panose="020B0604020202020204" pitchFamily="34" charset="-122"/>
                  <a:cs typeface="Arial" panose="020B0604020202020204" pitchFamily="34" charset="0"/>
                </a:rPr>
                <a:t>AA</a:t>
              </a:r>
              <a:endParaRPr lang="en-US" sz="1400" dirty="0">
                <a:latin typeface="Arial" panose="020B0604020202020204" pitchFamily="34" charset="0"/>
                <a:ea typeface="Arial Unicode MS" panose="020B0604020202020204" pitchFamily="34" charset="-122"/>
                <a:cs typeface="Arial" panose="020B0604020202020204" pitchFamily="34" charset="0"/>
              </a:endParaRPr>
            </a:p>
          </p:txBody>
        </p:sp>
        <p:cxnSp>
          <p:nvCxnSpPr>
            <p:cNvPr id="10" name="Straight Arrow Connector 9"/>
            <p:cNvCxnSpPr/>
            <p:nvPr/>
          </p:nvCxnSpPr>
          <p:spPr>
            <a:xfrm>
              <a:off x="3962401" y="2674258"/>
              <a:ext cx="0" cy="936000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1" name="TextBox 10"/>
            <p:cNvSpPr txBox="1"/>
            <p:nvPr/>
          </p:nvSpPr>
          <p:spPr>
            <a:xfrm>
              <a:off x="2614116" y="2771001"/>
              <a:ext cx="1516591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b="1" dirty="0" smtClean="0">
                  <a:solidFill>
                    <a:srgbClr val="0070C0"/>
                  </a:solidFill>
                  <a:latin typeface="Arial" panose="020B0604020202020204" pitchFamily="34" charset="0"/>
                  <a:ea typeface="Arial Unicode MS" panose="020B0604020202020204" pitchFamily="34" charset="-122"/>
                  <a:cs typeface="Arial" panose="020B0604020202020204" pitchFamily="34" charset="0"/>
                </a:rPr>
                <a:t>PGH synthase</a:t>
              </a:r>
              <a:endParaRPr lang="en-US" sz="1100" b="1" dirty="0">
                <a:solidFill>
                  <a:srgbClr val="0070C0"/>
                </a:solidFill>
                <a:latin typeface="Arial" panose="020B0604020202020204" pitchFamily="34" charset="0"/>
                <a:ea typeface="Arial Unicode MS" panose="020B0604020202020204" pitchFamily="34" charset="-122"/>
                <a:cs typeface="Arial" panose="020B0604020202020204" pitchFamily="34" charset="0"/>
              </a:endParaRPr>
            </a:p>
          </p:txBody>
        </p:sp>
        <p:sp>
          <p:nvSpPr>
            <p:cNvPr id="12" name="TextBox 11"/>
            <p:cNvSpPr txBox="1"/>
            <p:nvPr/>
          </p:nvSpPr>
          <p:spPr>
            <a:xfrm>
              <a:off x="2401441" y="2918890"/>
              <a:ext cx="1676400" cy="43088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dirty="0" smtClean="0">
                  <a:latin typeface="Arial" panose="020B0604020202020204" pitchFamily="34" charset="0"/>
                  <a:ea typeface="Arial Unicode MS" panose="020B0604020202020204" pitchFamily="34" charset="-122"/>
                  <a:cs typeface="Arial" panose="020B0604020202020204" pitchFamily="34" charset="0"/>
                </a:rPr>
                <a:t>(</a:t>
              </a:r>
              <a:r>
                <a:rPr lang="en-US" sz="1100" b="1" dirty="0" smtClean="0">
                  <a:solidFill>
                    <a:srgbClr val="0070C0"/>
                  </a:solidFill>
                  <a:latin typeface="Arial" panose="020B0604020202020204" pitchFamily="34" charset="0"/>
                  <a:ea typeface="Arial Unicode MS" panose="020B0604020202020204" pitchFamily="34" charset="-122"/>
                  <a:cs typeface="Arial" panose="020B0604020202020204" pitchFamily="34" charset="0"/>
                </a:rPr>
                <a:t>COX-1/COX-2 or peroxidase)</a:t>
              </a:r>
            </a:p>
          </p:txBody>
        </p:sp>
        <p:sp>
          <p:nvSpPr>
            <p:cNvPr id="14" name="TextBox 13"/>
            <p:cNvSpPr txBox="1"/>
            <p:nvPr/>
          </p:nvSpPr>
          <p:spPr>
            <a:xfrm>
              <a:off x="3677496" y="3610258"/>
              <a:ext cx="698658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dirty="0" smtClean="0">
                  <a:latin typeface="Arial" panose="020B0604020202020204" pitchFamily="34" charset="0"/>
                  <a:ea typeface="Arial Unicode MS" panose="020B0604020202020204" pitchFamily="34" charset="-122"/>
                  <a:cs typeface="Arial" panose="020B0604020202020204" pitchFamily="34" charset="0"/>
                </a:rPr>
                <a:t>PGH</a:t>
              </a:r>
              <a:r>
                <a:rPr lang="en-US" sz="1600" baseline="-25000" dirty="0" smtClean="0">
                  <a:latin typeface="Arial" panose="020B0604020202020204" pitchFamily="34" charset="0"/>
                  <a:ea typeface="Arial Unicode MS" panose="020B0604020202020204" pitchFamily="34" charset="-122"/>
                  <a:cs typeface="Arial" panose="020B0604020202020204" pitchFamily="34" charset="0"/>
                </a:rPr>
                <a:t>2</a:t>
              </a:r>
              <a:endParaRPr lang="en-US" sz="1600" dirty="0">
                <a:latin typeface="Arial" panose="020B0604020202020204" pitchFamily="34" charset="0"/>
                <a:ea typeface="Arial Unicode MS" panose="020B0604020202020204" pitchFamily="34" charset="-122"/>
                <a:cs typeface="Arial" panose="020B0604020202020204" pitchFamily="34" charset="0"/>
              </a:endParaRPr>
            </a:p>
          </p:txBody>
        </p:sp>
        <p:cxnSp>
          <p:nvCxnSpPr>
            <p:cNvPr id="15" name="Straight Arrow Connector 14"/>
            <p:cNvCxnSpPr/>
            <p:nvPr/>
          </p:nvCxnSpPr>
          <p:spPr>
            <a:xfrm flipH="1">
              <a:off x="2498575" y="3772184"/>
              <a:ext cx="1178921" cy="0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0" name="TextBox 19"/>
            <p:cNvSpPr txBox="1"/>
            <p:nvPr/>
          </p:nvSpPr>
          <p:spPr>
            <a:xfrm>
              <a:off x="1928593" y="3634400"/>
              <a:ext cx="543739" cy="261610"/>
            </a:xfrm>
            <a:prstGeom prst="rect">
              <a:avLst/>
            </a:prstGeom>
            <a:noFill/>
            <a:ln w="9525">
              <a:solidFill>
                <a:schemeClr val="tx1"/>
              </a:solidFill>
            </a:ln>
          </p:spPr>
          <p:txBody>
            <a:bodyPr wrap="none" rtlCol="0">
              <a:spAutoFit/>
            </a:bodyPr>
            <a:lstStyle/>
            <a:p>
              <a:r>
                <a:rPr lang="en-US" sz="1100" dirty="0" smtClean="0">
                  <a:latin typeface="Arial" panose="020B0604020202020204" pitchFamily="34" charset="0"/>
                  <a:ea typeface="Arial Unicode MS" panose="020B0604020202020204" pitchFamily="34" charset="-122"/>
                  <a:cs typeface="Arial" panose="020B0604020202020204" pitchFamily="34" charset="0"/>
                </a:rPr>
                <a:t>PGD</a:t>
              </a:r>
              <a:r>
                <a:rPr lang="en-US" sz="1100" baseline="-25000" dirty="0" smtClean="0">
                  <a:latin typeface="Arial" panose="020B0604020202020204" pitchFamily="34" charset="0"/>
                  <a:ea typeface="Arial Unicode MS" panose="020B0604020202020204" pitchFamily="34" charset="-122"/>
                  <a:cs typeface="Arial" panose="020B0604020202020204" pitchFamily="34" charset="0"/>
                </a:rPr>
                <a:t>2</a:t>
              </a:r>
              <a:endParaRPr lang="en-US" sz="1100" baseline="-25000" dirty="0">
                <a:latin typeface="Arial" panose="020B0604020202020204" pitchFamily="34" charset="0"/>
                <a:ea typeface="Arial Unicode MS" panose="020B0604020202020204" pitchFamily="34" charset="-122"/>
                <a:cs typeface="Arial" panose="020B0604020202020204" pitchFamily="34" charset="0"/>
              </a:endParaRPr>
            </a:p>
          </p:txBody>
        </p:sp>
        <p:sp>
          <p:nvSpPr>
            <p:cNvPr id="21" name="TextBox 20"/>
            <p:cNvSpPr txBox="1"/>
            <p:nvPr/>
          </p:nvSpPr>
          <p:spPr>
            <a:xfrm>
              <a:off x="2249392" y="3538820"/>
              <a:ext cx="1782564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b="1" dirty="0" smtClean="0">
                  <a:solidFill>
                    <a:srgbClr val="0070C0"/>
                  </a:solidFill>
                  <a:latin typeface="Arial" panose="020B0604020202020204" pitchFamily="34" charset="0"/>
                  <a:ea typeface="Arial Unicode MS" panose="020B0604020202020204" pitchFamily="34" charset="-122"/>
                  <a:cs typeface="Arial" panose="020B0604020202020204" pitchFamily="34" charset="0"/>
                </a:rPr>
                <a:t>PGD</a:t>
              </a:r>
              <a:r>
                <a:rPr lang="en-US" sz="1100" b="1" baseline="-25000" dirty="0" smtClean="0">
                  <a:solidFill>
                    <a:srgbClr val="0070C0"/>
                  </a:solidFill>
                  <a:latin typeface="Arial" panose="020B0604020202020204" pitchFamily="34" charset="0"/>
                  <a:ea typeface="Arial Unicode MS" panose="020B0604020202020204" pitchFamily="34" charset="-122"/>
                  <a:cs typeface="Arial" panose="020B0604020202020204" pitchFamily="34" charset="0"/>
                </a:rPr>
                <a:t>2</a:t>
              </a:r>
              <a:r>
                <a:rPr lang="en-US" sz="1100" b="1" dirty="0" smtClean="0">
                  <a:solidFill>
                    <a:srgbClr val="0070C0"/>
                  </a:solidFill>
                  <a:latin typeface="Arial" panose="020B0604020202020204" pitchFamily="34" charset="0"/>
                  <a:ea typeface="Arial Unicode MS" panose="020B0604020202020204" pitchFamily="34" charset="-122"/>
                  <a:cs typeface="Arial" panose="020B0604020202020204" pitchFamily="34" charset="0"/>
                </a:rPr>
                <a:t> synthase</a:t>
              </a:r>
              <a:endParaRPr lang="en-US" sz="1100" b="1" dirty="0">
                <a:solidFill>
                  <a:srgbClr val="0070C0"/>
                </a:solidFill>
                <a:latin typeface="Arial" panose="020B0604020202020204" pitchFamily="34" charset="0"/>
                <a:ea typeface="Arial Unicode MS" panose="020B0604020202020204" pitchFamily="34" charset="-122"/>
                <a:cs typeface="Arial" panose="020B0604020202020204" pitchFamily="34" charset="0"/>
              </a:endParaRPr>
            </a:p>
          </p:txBody>
        </p:sp>
        <p:sp>
          <p:nvSpPr>
            <p:cNvPr id="22" name="TextBox 21"/>
            <p:cNvSpPr txBox="1"/>
            <p:nvPr/>
          </p:nvSpPr>
          <p:spPr>
            <a:xfrm>
              <a:off x="1905000" y="5040868"/>
              <a:ext cx="535724" cy="261610"/>
            </a:xfrm>
            <a:prstGeom prst="rect">
              <a:avLst/>
            </a:prstGeom>
            <a:noFill/>
            <a:ln w="9525">
              <a:solidFill>
                <a:schemeClr val="tx1"/>
              </a:solidFill>
            </a:ln>
          </p:spPr>
          <p:txBody>
            <a:bodyPr wrap="none" rtlCol="0">
              <a:spAutoFit/>
            </a:bodyPr>
            <a:lstStyle/>
            <a:p>
              <a:r>
                <a:rPr lang="en-US" sz="1100" dirty="0" smtClean="0">
                  <a:latin typeface="Arial" panose="020B0604020202020204" pitchFamily="34" charset="0"/>
                  <a:ea typeface="Arial Unicode MS" panose="020B0604020202020204" pitchFamily="34" charset="-122"/>
                  <a:cs typeface="Arial" panose="020B0604020202020204" pitchFamily="34" charset="0"/>
                </a:rPr>
                <a:t>PGE</a:t>
              </a:r>
              <a:r>
                <a:rPr lang="en-US" sz="1100" baseline="-25000" dirty="0" smtClean="0">
                  <a:latin typeface="Arial" panose="020B0604020202020204" pitchFamily="34" charset="0"/>
                  <a:ea typeface="Arial Unicode MS" panose="020B0604020202020204" pitchFamily="34" charset="-122"/>
                  <a:cs typeface="Arial" panose="020B0604020202020204" pitchFamily="34" charset="0"/>
                </a:rPr>
                <a:t>2</a:t>
              </a:r>
              <a:endParaRPr lang="en-US" sz="1400" b="1" baseline="-25000" dirty="0">
                <a:solidFill>
                  <a:srgbClr val="0070C0"/>
                </a:solidFill>
                <a:latin typeface="Arial" panose="020B0604020202020204" pitchFamily="34" charset="0"/>
                <a:ea typeface="Arial Unicode MS" panose="020B0604020202020204" pitchFamily="34" charset="-122"/>
                <a:cs typeface="Arial" panose="020B0604020202020204" pitchFamily="34" charset="0"/>
              </a:endParaRPr>
            </a:p>
          </p:txBody>
        </p:sp>
        <p:cxnSp>
          <p:nvCxnSpPr>
            <p:cNvPr id="25" name="Straight Arrow Connector 24"/>
            <p:cNvCxnSpPr/>
            <p:nvPr/>
          </p:nvCxnSpPr>
          <p:spPr>
            <a:xfrm rot="10800000" flipV="1">
              <a:off x="2390402" y="3967448"/>
              <a:ext cx="1287095" cy="954402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6" name="TextBox 25"/>
            <p:cNvSpPr txBox="1"/>
            <p:nvPr/>
          </p:nvSpPr>
          <p:spPr>
            <a:xfrm>
              <a:off x="3055409" y="5040868"/>
              <a:ext cx="660758" cy="261610"/>
            </a:xfrm>
            <a:prstGeom prst="rect">
              <a:avLst/>
            </a:prstGeom>
            <a:noFill/>
            <a:ln w="9525">
              <a:solidFill>
                <a:schemeClr val="tx1"/>
              </a:solidFill>
            </a:ln>
          </p:spPr>
          <p:txBody>
            <a:bodyPr wrap="none" rtlCol="0">
              <a:spAutoFit/>
            </a:bodyPr>
            <a:lstStyle/>
            <a:p>
              <a:r>
                <a:rPr lang="en-US" sz="1100" dirty="0" smtClean="0">
                  <a:latin typeface="Arial" panose="020B0604020202020204" pitchFamily="34" charset="0"/>
                  <a:ea typeface="Arial Unicode MS" panose="020B0604020202020204" pitchFamily="34" charset="-122"/>
                  <a:cs typeface="Arial" panose="020B0604020202020204" pitchFamily="34" charset="0"/>
                </a:rPr>
                <a:t>PGF</a:t>
              </a:r>
              <a:r>
                <a:rPr lang="en-US" sz="1100" baseline="-25000" dirty="0" smtClean="0">
                  <a:latin typeface="Arial" panose="020B0604020202020204" pitchFamily="34" charset="0"/>
                  <a:ea typeface="Arial Unicode MS" panose="020B0604020202020204" pitchFamily="34" charset="-122"/>
                  <a:cs typeface="Arial" panose="020B0604020202020204" pitchFamily="34" charset="0"/>
                </a:rPr>
                <a:t>1/2</a:t>
              </a:r>
              <a:r>
                <a:rPr lang="el-GR" sz="1100" baseline="-25000" dirty="0" smtClean="0">
                  <a:latin typeface="Arial" panose="020B0604020202020204" pitchFamily="34" charset="0"/>
                  <a:ea typeface="Arial Unicode MS" panose="020B0604020202020204" pitchFamily="34" charset="-122"/>
                  <a:cs typeface="Arial" panose="020B0604020202020204" pitchFamily="34" charset="0"/>
                </a:rPr>
                <a:t>α</a:t>
              </a:r>
              <a:endParaRPr lang="en-US" sz="1100" baseline="-25000" dirty="0">
                <a:latin typeface="Arial" panose="020B0604020202020204" pitchFamily="34" charset="0"/>
                <a:ea typeface="Arial Unicode MS" panose="020B0604020202020204" pitchFamily="34" charset="-122"/>
                <a:cs typeface="Arial" panose="020B0604020202020204" pitchFamily="34" charset="0"/>
              </a:endParaRPr>
            </a:p>
          </p:txBody>
        </p:sp>
        <p:sp>
          <p:nvSpPr>
            <p:cNvPr id="27" name="TextBox 26"/>
            <p:cNvSpPr txBox="1"/>
            <p:nvPr/>
          </p:nvSpPr>
          <p:spPr>
            <a:xfrm>
              <a:off x="4046009" y="5040868"/>
              <a:ext cx="184666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endParaRPr lang="en-US" sz="1100" dirty="0">
                <a:latin typeface="Arial" panose="020B0604020202020204" pitchFamily="34" charset="0"/>
                <a:ea typeface="Arial Unicode MS" panose="020B0604020202020204" pitchFamily="34" charset="-122"/>
                <a:cs typeface="Arial" panose="020B0604020202020204" pitchFamily="34" charset="0"/>
              </a:endParaRPr>
            </a:p>
          </p:txBody>
        </p:sp>
        <p:sp>
          <p:nvSpPr>
            <p:cNvPr id="28" name="TextBox 27"/>
            <p:cNvSpPr txBox="1"/>
            <p:nvPr/>
          </p:nvSpPr>
          <p:spPr>
            <a:xfrm>
              <a:off x="5173477" y="5045080"/>
              <a:ext cx="513282" cy="261610"/>
            </a:xfrm>
            <a:prstGeom prst="rect">
              <a:avLst/>
            </a:prstGeom>
            <a:noFill/>
            <a:ln w="9525">
              <a:solidFill>
                <a:schemeClr val="tx1"/>
              </a:solidFill>
            </a:ln>
          </p:spPr>
          <p:txBody>
            <a:bodyPr wrap="none" rtlCol="0">
              <a:spAutoFit/>
            </a:bodyPr>
            <a:lstStyle/>
            <a:p>
              <a:r>
                <a:rPr lang="en-US" sz="1100" dirty="0" smtClean="0">
                  <a:latin typeface="Arial" panose="020B0604020202020204" pitchFamily="34" charset="0"/>
                  <a:ea typeface="Arial Unicode MS" panose="020B0604020202020204" pitchFamily="34" charset="-122"/>
                  <a:cs typeface="Arial" panose="020B0604020202020204" pitchFamily="34" charset="0"/>
                </a:rPr>
                <a:t>TXB</a:t>
              </a:r>
              <a:r>
                <a:rPr lang="en-US" sz="1100" baseline="-25000" dirty="0" smtClean="0">
                  <a:latin typeface="Arial" panose="020B0604020202020204" pitchFamily="34" charset="0"/>
                  <a:ea typeface="Arial Unicode MS" panose="020B0604020202020204" pitchFamily="34" charset="-122"/>
                  <a:cs typeface="Arial" panose="020B0604020202020204" pitchFamily="34" charset="0"/>
                </a:rPr>
                <a:t>2</a:t>
              </a:r>
              <a:endParaRPr lang="en-US" sz="1400" b="1" baseline="-25000" dirty="0">
                <a:solidFill>
                  <a:srgbClr val="0070C0"/>
                </a:solidFill>
                <a:latin typeface="Arial" panose="020B0604020202020204" pitchFamily="34" charset="0"/>
                <a:ea typeface="Arial Unicode MS" panose="020B0604020202020204" pitchFamily="34" charset="-122"/>
                <a:cs typeface="Arial" panose="020B0604020202020204" pitchFamily="34" charset="0"/>
              </a:endParaRPr>
            </a:p>
          </p:txBody>
        </p:sp>
        <p:sp>
          <p:nvSpPr>
            <p:cNvPr id="32" name="TextBox 31"/>
            <p:cNvSpPr txBox="1"/>
            <p:nvPr/>
          </p:nvSpPr>
          <p:spPr>
            <a:xfrm rot="19336668">
              <a:off x="2363784" y="4221026"/>
              <a:ext cx="1143000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b="1" dirty="0" smtClean="0">
                  <a:solidFill>
                    <a:srgbClr val="0070C0"/>
                  </a:solidFill>
                  <a:latin typeface="Arial" panose="020B0604020202020204" pitchFamily="34" charset="0"/>
                  <a:ea typeface="Arial Unicode MS" panose="020B0604020202020204" pitchFamily="34" charset="-122"/>
                  <a:cs typeface="Arial" panose="020B0604020202020204" pitchFamily="34" charset="0"/>
                </a:rPr>
                <a:t>PGE synthase</a:t>
              </a:r>
              <a:endParaRPr lang="en-US" sz="1100" b="1" dirty="0">
                <a:solidFill>
                  <a:srgbClr val="0070C0"/>
                </a:solidFill>
                <a:latin typeface="Arial" panose="020B0604020202020204" pitchFamily="34" charset="0"/>
                <a:ea typeface="Arial Unicode MS" panose="020B0604020202020204" pitchFamily="34" charset="-122"/>
                <a:cs typeface="Arial" panose="020B0604020202020204" pitchFamily="34" charset="0"/>
              </a:endParaRPr>
            </a:p>
          </p:txBody>
        </p:sp>
        <p:cxnSp>
          <p:nvCxnSpPr>
            <p:cNvPr id="33" name="Straight Arrow Connector 32"/>
            <p:cNvCxnSpPr/>
            <p:nvPr/>
          </p:nvCxnSpPr>
          <p:spPr>
            <a:xfrm flipH="1">
              <a:off x="3385788" y="4156474"/>
              <a:ext cx="571598" cy="900000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7" name="TextBox 36"/>
            <p:cNvSpPr txBox="1"/>
            <p:nvPr/>
          </p:nvSpPr>
          <p:spPr>
            <a:xfrm rot="18194601">
              <a:off x="3047749" y="4347302"/>
              <a:ext cx="1143000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b="1" dirty="0" smtClean="0">
                  <a:solidFill>
                    <a:srgbClr val="0070C0"/>
                  </a:solidFill>
                  <a:latin typeface="Arial" panose="020B0604020202020204" pitchFamily="34" charset="0"/>
                  <a:ea typeface="Arial Unicode MS" panose="020B0604020202020204" pitchFamily="34" charset="-122"/>
                  <a:cs typeface="Arial" panose="020B0604020202020204" pitchFamily="34" charset="0"/>
                </a:rPr>
                <a:t>PGF synthase</a:t>
              </a:r>
              <a:endParaRPr lang="en-US" sz="1100" b="1" dirty="0">
                <a:solidFill>
                  <a:srgbClr val="0070C0"/>
                </a:solidFill>
                <a:latin typeface="Arial" panose="020B0604020202020204" pitchFamily="34" charset="0"/>
                <a:ea typeface="Arial Unicode MS" panose="020B0604020202020204" pitchFamily="34" charset="-122"/>
                <a:cs typeface="Arial" panose="020B0604020202020204" pitchFamily="34" charset="0"/>
              </a:endParaRPr>
            </a:p>
          </p:txBody>
        </p:sp>
        <p:cxnSp>
          <p:nvCxnSpPr>
            <p:cNvPr id="38" name="Straight Arrow Connector 37"/>
            <p:cNvCxnSpPr/>
            <p:nvPr/>
          </p:nvCxnSpPr>
          <p:spPr>
            <a:xfrm rot="16200000" flipH="1">
              <a:off x="3890699" y="4376839"/>
              <a:ext cx="877486" cy="427236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2" name="TextBox 41"/>
            <p:cNvSpPr txBox="1"/>
            <p:nvPr/>
          </p:nvSpPr>
          <p:spPr>
            <a:xfrm rot="3836811">
              <a:off x="3733119" y="4321890"/>
              <a:ext cx="1186239" cy="42759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b="1" dirty="0" err="1" smtClean="0">
                  <a:solidFill>
                    <a:srgbClr val="0070C0"/>
                  </a:solidFill>
                  <a:latin typeface="Arial" panose="020B0604020202020204" pitchFamily="34" charset="0"/>
                  <a:ea typeface="Arial Unicode MS" panose="020B0604020202020204" pitchFamily="34" charset="-122"/>
                  <a:cs typeface="Arial" panose="020B0604020202020204" pitchFamily="34" charset="0"/>
                </a:rPr>
                <a:t>Prostacyclin</a:t>
              </a:r>
              <a:endParaRPr lang="en-US" sz="1100" b="1" dirty="0" smtClean="0">
                <a:solidFill>
                  <a:srgbClr val="0070C0"/>
                </a:solidFill>
                <a:latin typeface="Arial" panose="020B0604020202020204" pitchFamily="34" charset="0"/>
                <a:ea typeface="Arial Unicode MS" panose="020B0604020202020204" pitchFamily="34" charset="-122"/>
                <a:cs typeface="Arial" panose="020B0604020202020204" pitchFamily="34" charset="0"/>
              </a:endParaRPr>
            </a:p>
            <a:p>
              <a:pPr algn="ctr"/>
              <a:r>
                <a:rPr lang="en-US" sz="1100" b="1" dirty="0" smtClean="0">
                  <a:solidFill>
                    <a:srgbClr val="0070C0"/>
                  </a:solidFill>
                  <a:latin typeface="Arial" panose="020B0604020202020204" pitchFamily="34" charset="0"/>
                  <a:ea typeface="Arial Unicode MS" panose="020B0604020202020204" pitchFamily="34" charset="-122"/>
                  <a:cs typeface="Arial" panose="020B0604020202020204" pitchFamily="34" charset="0"/>
                </a:rPr>
                <a:t>synthase</a:t>
              </a:r>
              <a:endParaRPr lang="en-US" sz="1100" b="1" dirty="0">
                <a:solidFill>
                  <a:srgbClr val="0070C0"/>
                </a:solidFill>
                <a:latin typeface="Arial" panose="020B0604020202020204" pitchFamily="34" charset="0"/>
                <a:ea typeface="Arial Unicode MS" panose="020B0604020202020204" pitchFamily="34" charset="-122"/>
                <a:cs typeface="Arial" panose="020B0604020202020204" pitchFamily="34" charset="0"/>
              </a:endParaRPr>
            </a:p>
          </p:txBody>
        </p:sp>
        <p:cxnSp>
          <p:nvCxnSpPr>
            <p:cNvPr id="43" name="Straight Arrow Connector 42"/>
            <p:cNvCxnSpPr>
              <a:endCxn id="28" idx="0"/>
            </p:cNvCxnSpPr>
            <p:nvPr/>
          </p:nvCxnSpPr>
          <p:spPr>
            <a:xfrm rot="16200000" flipH="1">
              <a:off x="4477193" y="4092153"/>
              <a:ext cx="971535" cy="934318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1" name="TextBox 50"/>
            <p:cNvSpPr txBox="1"/>
            <p:nvPr/>
          </p:nvSpPr>
          <p:spPr>
            <a:xfrm rot="2721175">
              <a:off x="4521434" y="4332809"/>
              <a:ext cx="1016625" cy="25961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100" b="1" dirty="0" smtClean="0">
                  <a:solidFill>
                    <a:srgbClr val="0070C0"/>
                  </a:solidFill>
                  <a:latin typeface="Arial" panose="020B0604020202020204" pitchFamily="34" charset="0"/>
                  <a:ea typeface="Arial Unicode MS" panose="020B0604020202020204" pitchFamily="34" charset="-122"/>
                  <a:cs typeface="Arial" panose="020B0604020202020204" pitchFamily="34" charset="0"/>
                </a:rPr>
                <a:t>TX synthase</a:t>
              </a:r>
              <a:endParaRPr lang="en-US" sz="1100" b="1" dirty="0">
                <a:solidFill>
                  <a:srgbClr val="0070C0"/>
                </a:solidFill>
                <a:latin typeface="Arial" panose="020B0604020202020204" pitchFamily="34" charset="0"/>
                <a:ea typeface="Arial Unicode MS" panose="020B0604020202020204" pitchFamily="34" charset="-122"/>
                <a:cs typeface="Arial" panose="020B0604020202020204" pitchFamily="34" charset="0"/>
              </a:endParaRPr>
            </a:p>
          </p:txBody>
        </p:sp>
        <p:cxnSp>
          <p:nvCxnSpPr>
            <p:cNvPr id="52" name="Straight Arrow Connector 51"/>
            <p:cNvCxnSpPr/>
            <p:nvPr/>
          </p:nvCxnSpPr>
          <p:spPr>
            <a:xfrm>
              <a:off x="4528201" y="2538688"/>
              <a:ext cx="1178920" cy="0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4" name="TextBox 53"/>
            <p:cNvSpPr txBox="1"/>
            <p:nvPr/>
          </p:nvSpPr>
          <p:spPr>
            <a:xfrm>
              <a:off x="4811769" y="2219598"/>
              <a:ext cx="708920" cy="261610"/>
            </a:xfrm>
            <a:prstGeom prst="rect">
              <a:avLst/>
            </a:prstGeom>
            <a:noFill/>
            <a:ln>
              <a:solidFill>
                <a:schemeClr val="bg1"/>
              </a:solidFill>
            </a:ln>
          </p:spPr>
          <p:txBody>
            <a:bodyPr wrap="square" rtlCol="0">
              <a:spAutoFit/>
            </a:bodyPr>
            <a:lstStyle/>
            <a:p>
              <a:r>
                <a:rPr lang="en-US" sz="1100" b="1" dirty="0" smtClean="0">
                  <a:solidFill>
                    <a:srgbClr val="0070C0"/>
                  </a:solidFill>
                  <a:latin typeface="Arial" panose="020B0604020202020204" pitchFamily="34" charset="0"/>
                  <a:ea typeface="Arial Unicode MS" panose="020B0604020202020204" pitchFamily="34" charset="-122"/>
                  <a:cs typeface="Arial" panose="020B0604020202020204" pitchFamily="34" charset="0"/>
                </a:rPr>
                <a:t>5-LOX </a:t>
              </a:r>
            </a:p>
          </p:txBody>
        </p:sp>
        <p:sp>
          <p:nvSpPr>
            <p:cNvPr id="55" name="TextBox 54"/>
            <p:cNvSpPr txBox="1"/>
            <p:nvPr/>
          </p:nvSpPr>
          <p:spPr>
            <a:xfrm>
              <a:off x="5733365" y="2252936"/>
              <a:ext cx="567136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 smtClean="0">
                  <a:latin typeface="Arial" panose="020B0604020202020204" pitchFamily="34" charset="0"/>
                  <a:ea typeface="Arial Unicode MS" panose="020B0604020202020204" pitchFamily="34" charset="-122"/>
                  <a:cs typeface="Arial" panose="020B0604020202020204" pitchFamily="34" charset="0"/>
                </a:rPr>
                <a:t>LTA</a:t>
              </a:r>
              <a:r>
                <a:rPr lang="en-US" sz="1400" baseline="-25000" dirty="0" smtClean="0">
                  <a:latin typeface="Arial" panose="020B0604020202020204" pitchFamily="34" charset="0"/>
                  <a:ea typeface="Arial Unicode MS" panose="020B0604020202020204" pitchFamily="34" charset="-122"/>
                  <a:cs typeface="Arial" panose="020B0604020202020204" pitchFamily="34" charset="0"/>
                </a:rPr>
                <a:t>4</a:t>
              </a:r>
              <a:endParaRPr lang="en-US" sz="1400" baseline="-25000" dirty="0">
                <a:latin typeface="Arial" panose="020B0604020202020204" pitchFamily="34" charset="0"/>
                <a:ea typeface="Arial Unicode MS" panose="020B0604020202020204" pitchFamily="34" charset="-122"/>
                <a:cs typeface="Arial" panose="020B0604020202020204" pitchFamily="34" charset="0"/>
              </a:endParaRPr>
            </a:p>
          </p:txBody>
        </p:sp>
        <p:sp>
          <p:nvSpPr>
            <p:cNvPr id="60" name="TextBox 59"/>
            <p:cNvSpPr txBox="1"/>
            <p:nvPr/>
          </p:nvSpPr>
          <p:spPr>
            <a:xfrm>
              <a:off x="5804257" y="3610258"/>
              <a:ext cx="497252" cy="261610"/>
            </a:xfrm>
            <a:prstGeom prst="rect">
              <a:avLst/>
            </a:prstGeom>
            <a:noFill/>
            <a:ln w="9525">
              <a:solidFill>
                <a:schemeClr val="tx1"/>
              </a:solidFill>
            </a:ln>
          </p:spPr>
          <p:txBody>
            <a:bodyPr wrap="none" rtlCol="0">
              <a:spAutoFit/>
            </a:bodyPr>
            <a:lstStyle/>
            <a:p>
              <a:r>
                <a:rPr lang="en-US" sz="1100" dirty="0" smtClean="0">
                  <a:latin typeface="Arial" panose="020B0604020202020204" pitchFamily="34" charset="0"/>
                  <a:ea typeface="Arial Unicode MS" panose="020B0604020202020204" pitchFamily="34" charset="-122"/>
                  <a:cs typeface="Arial" panose="020B0604020202020204" pitchFamily="34" charset="0"/>
                </a:rPr>
                <a:t>LTB</a:t>
              </a:r>
              <a:r>
                <a:rPr lang="en-US" sz="1100" baseline="-25000" dirty="0" smtClean="0">
                  <a:latin typeface="Arial" panose="020B0604020202020204" pitchFamily="34" charset="0"/>
                  <a:ea typeface="Arial Unicode MS" panose="020B0604020202020204" pitchFamily="34" charset="-122"/>
                  <a:cs typeface="Arial" panose="020B0604020202020204" pitchFamily="34" charset="0"/>
                </a:rPr>
                <a:t>4</a:t>
              </a:r>
              <a:endParaRPr lang="en-US" sz="1100" baseline="-25000" dirty="0">
                <a:latin typeface="Arial" panose="020B0604020202020204" pitchFamily="34" charset="0"/>
                <a:ea typeface="Arial Unicode MS" panose="020B0604020202020204" pitchFamily="34" charset="-122"/>
                <a:cs typeface="Arial" panose="020B0604020202020204" pitchFamily="34" charset="0"/>
              </a:endParaRPr>
            </a:p>
          </p:txBody>
        </p:sp>
        <p:sp>
          <p:nvSpPr>
            <p:cNvPr id="68" name="TextBox 67"/>
            <p:cNvSpPr txBox="1"/>
            <p:nvPr/>
          </p:nvSpPr>
          <p:spPr>
            <a:xfrm rot="5400000">
              <a:off x="5594152" y="2824957"/>
              <a:ext cx="857257" cy="42759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b="1" dirty="0" smtClean="0">
                  <a:solidFill>
                    <a:srgbClr val="0070C0"/>
                  </a:solidFill>
                  <a:latin typeface="Arial" panose="020B0604020202020204" pitchFamily="34" charset="0"/>
                  <a:ea typeface="Arial Unicode MS" panose="020B0604020202020204" pitchFamily="34" charset="-122"/>
                  <a:cs typeface="Arial" panose="020B0604020202020204" pitchFamily="34" charset="0"/>
                </a:rPr>
                <a:t>LTA</a:t>
              </a:r>
              <a:r>
                <a:rPr lang="en-US" sz="1100" b="1" baseline="-25000" dirty="0" smtClean="0">
                  <a:solidFill>
                    <a:srgbClr val="0070C0"/>
                  </a:solidFill>
                  <a:latin typeface="Arial" panose="020B0604020202020204" pitchFamily="34" charset="0"/>
                  <a:ea typeface="Arial Unicode MS" panose="020B0604020202020204" pitchFamily="34" charset="-122"/>
                  <a:cs typeface="Arial" panose="020B0604020202020204" pitchFamily="34" charset="0"/>
                </a:rPr>
                <a:t>4</a:t>
              </a:r>
              <a:r>
                <a:rPr lang="en-US" sz="1100" b="1" dirty="0" smtClean="0">
                  <a:solidFill>
                    <a:srgbClr val="0070C0"/>
                  </a:solidFill>
                  <a:latin typeface="Arial" panose="020B0604020202020204" pitchFamily="34" charset="0"/>
                  <a:ea typeface="Arial Unicode MS" panose="020B0604020202020204" pitchFamily="34" charset="-122"/>
                  <a:cs typeface="Arial" panose="020B0604020202020204" pitchFamily="34" charset="0"/>
                </a:rPr>
                <a:t> hydrolase</a:t>
              </a:r>
              <a:endParaRPr lang="en-US" sz="1100" b="1" dirty="0">
                <a:solidFill>
                  <a:srgbClr val="0070C0"/>
                </a:solidFill>
                <a:latin typeface="Arial" panose="020B0604020202020204" pitchFamily="34" charset="0"/>
                <a:ea typeface="Arial Unicode MS" panose="020B0604020202020204" pitchFamily="34" charset="-122"/>
                <a:cs typeface="Arial" panose="020B0604020202020204" pitchFamily="34" charset="0"/>
              </a:endParaRPr>
            </a:p>
          </p:txBody>
        </p:sp>
        <p:sp>
          <p:nvSpPr>
            <p:cNvPr id="71" name="TextBox 70"/>
            <p:cNvSpPr txBox="1"/>
            <p:nvPr/>
          </p:nvSpPr>
          <p:spPr>
            <a:xfrm>
              <a:off x="6158717" y="2277078"/>
              <a:ext cx="638028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b="1" dirty="0" smtClean="0">
                  <a:solidFill>
                    <a:srgbClr val="0070C0"/>
                  </a:solidFill>
                  <a:latin typeface="Arial" panose="020B0604020202020204" pitchFamily="34" charset="0"/>
                  <a:ea typeface="Arial Unicode MS" panose="020B0604020202020204" pitchFamily="34" charset="-122"/>
                  <a:cs typeface="Arial" panose="020B0604020202020204" pitchFamily="34" charset="0"/>
                </a:rPr>
                <a:t>GST</a:t>
              </a:r>
              <a:endParaRPr lang="en-US" sz="1100" b="1" dirty="0">
                <a:solidFill>
                  <a:srgbClr val="0070C0"/>
                </a:solidFill>
                <a:latin typeface="Arial" panose="020B0604020202020204" pitchFamily="34" charset="0"/>
                <a:ea typeface="Arial Unicode MS" panose="020B0604020202020204" pitchFamily="34" charset="-122"/>
                <a:cs typeface="Arial" panose="020B0604020202020204" pitchFamily="34" charset="0"/>
              </a:endParaRPr>
            </a:p>
          </p:txBody>
        </p:sp>
        <p:sp>
          <p:nvSpPr>
            <p:cNvPr id="73" name="TextBox 72"/>
            <p:cNvSpPr txBox="1"/>
            <p:nvPr/>
          </p:nvSpPr>
          <p:spPr>
            <a:xfrm>
              <a:off x="6796745" y="2224276"/>
              <a:ext cx="522900" cy="60016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 smtClean="0">
                  <a:latin typeface="Arial" panose="020B0604020202020204" pitchFamily="34" charset="0"/>
                  <a:ea typeface="Arial Unicode MS" panose="020B0604020202020204" pitchFamily="34" charset="-122"/>
                  <a:cs typeface="Arial" panose="020B0604020202020204" pitchFamily="34" charset="0"/>
                </a:rPr>
                <a:t>LTC</a:t>
              </a:r>
              <a:r>
                <a:rPr lang="en-US" sz="1100" baseline="-25000" dirty="0" smtClean="0">
                  <a:latin typeface="Arial" panose="020B0604020202020204" pitchFamily="34" charset="0"/>
                  <a:ea typeface="Arial Unicode MS" panose="020B0604020202020204" pitchFamily="34" charset="-122"/>
                  <a:cs typeface="Arial" panose="020B0604020202020204" pitchFamily="34" charset="0"/>
                </a:rPr>
                <a:t>4</a:t>
              </a:r>
            </a:p>
            <a:p>
              <a:r>
                <a:rPr lang="en-US" sz="1100" dirty="0" smtClean="0">
                  <a:latin typeface="Arial" panose="020B0604020202020204" pitchFamily="34" charset="0"/>
                  <a:ea typeface="Arial Unicode MS" panose="020B0604020202020204" pitchFamily="34" charset="-122"/>
                  <a:cs typeface="Arial" panose="020B0604020202020204" pitchFamily="34" charset="0"/>
                </a:rPr>
                <a:t>LTD</a:t>
              </a:r>
              <a:r>
                <a:rPr lang="en-US" sz="1100" baseline="-25000" dirty="0" smtClean="0">
                  <a:latin typeface="Arial" panose="020B0604020202020204" pitchFamily="34" charset="0"/>
                  <a:ea typeface="Arial Unicode MS" panose="020B0604020202020204" pitchFamily="34" charset="-122"/>
                  <a:cs typeface="Arial" panose="020B0604020202020204" pitchFamily="34" charset="0"/>
                </a:rPr>
                <a:t>4</a:t>
              </a:r>
            </a:p>
            <a:p>
              <a:r>
                <a:rPr lang="en-US" sz="1100" dirty="0" smtClean="0">
                  <a:latin typeface="Arial" panose="020B0604020202020204" pitchFamily="34" charset="0"/>
                  <a:ea typeface="Arial Unicode MS" panose="020B0604020202020204" pitchFamily="34" charset="-122"/>
                  <a:cs typeface="Arial" panose="020B0604020202020204" pitchFamily="34" charset="0"/>
                </a:rPr>
                <a:t>LTE</a:t>
              </a:r>
              <a:r>
                <a:rPr lang="en-US" sz="1100" baseline="-25000" dirty="0" smtClean="0">
                  <a:latin typeface="Arial" panose="020B0604020202020204" pitchFamily="34" charset="0"/>
                  <a:ea typeface="Arial Unicode MS" panose="020B0604020202020204" pitchFamily="34" charset="-122"/>
                  <a:cs typeface="Arial" panose="020B0604020202020204" pitchFamily="34" charset="0"/>
                </a:rPr>
                <a:t>4</a:t>
              </a:r>
              <a:endParaRPr lang="en-US" sz="1400" b="1" baseline="-25000" dirty="0">
                <a:solidFill>
                  <a:srgbClr val="0070C0"/>
                </a:solidFill>
                <a:latin typeface="Arial" panose="020B0604020202020204" pitchFamily="34" charset="0"/>
                <a:ea typeface="Arial Unicode MS" panose="020B0604020202020204" pitchFamily="34" charset="-122"/>
                <a:cs typeface="Arial" panose="020B0604020202020204" pitchFamily="34" charset="0"/>
              </a:endParaRPr>
            </a:p>
          </p:txBody>
        </p:sp>
        <p:cxnSp>
          <p:nvCxnSpPr>
            <p:cNvPr id="50" name="Straight Arrow Connector 49"/>
            <p:cNvCxnSpPr/>
            <p:nvPr/>
          </p:nvCxnSpPr>
          <p:spPr>
            <a:xfrm>
              <a:off x="2590800" y="5181600"/>
              <a:ext cx="294516" cy="0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6" name="TextBox 15"/>
          <p:cNvSpPr txBox="1"/>
          <p:nvPr/>
        </p:nvSpPr>
        <p:spPr>
          <a:xfrm>
            <a:off x="3186104" y="6429396"/>
            <a:ext cx="271464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dirty="0" smtClean="0">
                <a:latin typeface="Arial" panose="020B0604020202020204" pitchFamily="34" charset="0"/>
                <a:ea typeface="Arial Unicode MS" panose="020B0604020202020204" pitchFamily="34" charset="-122"/>
                <a:cs typeface="Arial" panose="020B0604020202020204" pitchFamily="34" charset="0"/>
              </a:rPr>
              <a:t>Differential gene expression</a:t>
            </a:r>
            <a:endParaRPr lang="en-US" sz="1600" dirty="0">
              <a:latin typeface="Arial" panose="020B0604020202020204" pitchFamily="34" charset="0"/>
              <a:ea typeface="Arial Unicode MS" panose="020B0604020202020204" pitchFamily="34" charset="-122"/>
              <a:cs typeface="Arial" panose="020B0604020202020204" pitchFamily="34" charset="0"/>
            </a:endParaRPr>
          </a:p>
        </p:txBody>
      </p:sp>
      <p:sp>
        <p:nvSpPr>
          <p:cNvPr id="17" name="Striped Right Arrow 16"/>
          <p:cNvSpPr/>
          <p:nvPr/>
        </p:nvSpPr>
        <p:spPr>
          <a:xfrm rot="635775">
            <a:off x="3010597" y="5731464"/>
            <a:ext cx="445654" cy="521820"/>
          </a:xfrm>
          <a:prstGeom prst="stripedRightArrow">
            <a:avLst/>
          </a:prstGeom>
          <a:pattFill prst="wdUpDiag">
            <a:fgClr>
              <a:schemeClr val="bg1">
                <a:lumMod val="75000"/>
              </a:schemeClr>
            </a:fgClr>
            <a:bgClr>
              <a:schemeClr val="bg1"/>
            </a:bgClr>
          </a:patt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100">
              <a:latin typeface="Arial" panose="020B0604020202020204" pitchFamily="34" charset="0"/>
              <a:ea typeface="Arial Unicode MS" panose="020B0604020202020204" pitchFamily="34" charset="-122"/>
              <a:cs typeface="Arial" panose="020B0604020202020204" pitchFamily="34" charset="0"/>
            </a:endParaRPr>
          </a:p>
        </p:txBody>
      </p:sp>
      <p:sp>
        <p:nvSpPr>
          <p:cNvPr id="57" name="Striped Right Arrow 56"/>
          <p:cNvSpPr/>
          <p:nvPr/>
        </p:nvSpPr>
        <p:spPr>
          <a:xfrm rot="21015402" flipH="1">
            <a:off x="5571020" y="5705109"/>
            <a:ext cx="448780" cy="521820"/>
          </a:xfrm>
          <a:prstGeom prst="stripedRightArrow">
            <a:avLst/>
          </a:prstGeom>
          <a:pattFill prst="pct10">
            <a:fgClr>
              <a:schemeClr val="bg1">
                <a:lumMod val="75000"/>
              </a:schemeClr>
            </a:fgClr>
            <a:bgClr>
              <a:schemeClr val="bg1"/>
            </a:bgClr>
          </a:patt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100">
              <a:latin typeface="Arial" panose="020B0604020202020204" pitchFamily="34" charset="0"/>
              <a:ea typeface="Arial Unicode MS" panose="020B0604020202020204" pitchFamily="34" charset="-122"/>
              <a:cs typeface="Arial" panose="020B0604020202020204" pitchFamily="34" charset="0"/>
            </a:endParaRPr>
          </a:p>
        </p:txBody>
      </p:sp>
      <p:sp>
        <p:nvSpPr>
          <p:cNvPr id="18" name="TextBox 17"/>
          <p:cNvSpPr txBox="1"/>
          <p:nvPr/>
        </p:nvSpPr>
        <p:spPr>
          <a:xfrm>
            <a:off x="323528" y="5029200"/>
            <a:ext cx="2175980" cy="338554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sz="1600" b="1" dirty="0" smtClean="0">
                <a:latin typeface="Arial" panose="020B0604020202020204" pitchFamily="34" charset="0"/>
                <a:ea typeface="Arial Unicode MS" panose="020B0604020202020204" pitchFamily="34" charset="-122"/>
                <a:cs typeface="Arial" panose="020B0604020202020204" pitchFamily="34" charset="0"/>
              </a:rPr>
              <a:t>± IL-1</a:t>
            </a:r>
            <a:r>
              <a:rPr lang="el-GR" sz="1600" b="1" dirty="0" smtClean="0">
                <a:latin typeface="Arial" panose="020B0604020202020204" pitchFamily="34" charset="0"/>
                <a:ea typeface="Arial Unicode MS" panose="020B0604020202020204" pitchFamily="34" charset="-122"/>
                <a:cs typeface="Arial" panose="020B0604020202020204" pitchFamily="34" charset="0"/>
              </a:rPr>
              <a:t>β</a:t>
            </a:r>
            <a:r>
              <a:rPr lang="en-US" sz="1600" b="1" dirty="0" smtClean="0">
                <a:latin typeface="Arial" panose="020B0604020202020204" pitchFamily="34" charset="0"/>
                <a:ea typeface="Arial Unicode MS" panose="020B0604020202020204" pitchFamily="34" charset="-122"/>
                <a:cs typeface="Arial" panose="020B0604020202020204" pitchFamily="34" charset="0"/>
              </a:rPr>
              <a:t>  and /or </a:t>
            </a:r>
            <a:r>
              <a:rPr lang="el-GR" sz="1600" b="1" dirty="0" smtClean="0">
                <a:latin typeface="Arial" panose="020B0604020202020204" pitchFamily="34" charset="0"/>
                <a:ea typeface="Arial Unicode MS" panose="020B0604020202020204" pitchFamily="34" charset="-122"/>
                <a:cs typeface="Arial" panose="020B0604020202020204" pitchFamily="34" charset="0"/>
              </a:rPr>
              <a:t>±</a:t>
            </a:r>
            <a:r>
              <a:rPr lang="en-US" sz="1600" b="1" dirty="0" smtClean="0">
                <a:latin typeface="Arial" panose="020B0604020202020204" pitchFamily="34" charset="0"/>
                <a:ea typeface="Arial Unicode MS" panose="020B0604020202020204" pitchFamily="34" charset="-122"/>
                <a:cs typeface="Arial" panose="020B0604020202020204" pitchFamily="34" charset="0"/>
              </a:rPr>
              <a:t> AA</a:t>
            </a:r>
            <a:endParaRPr lang="en-US" sz="1600" b="1" dirty="0">
              <a:latin typeface="Arial" panose="020B0604020202020204" pitchFamily="34" charset="0"/>
              <a:ea typeface="Arial Unicode MS" panose="020B0604020202020204" pitchFamily="34" charset="-122"/>
              <a:cs typeface="Arial" panose="020B0604020202020204" pitchFamily="34" charset="0"/>
            </a:endParaRPr>
          </a:p>
        </p:txBody>
      </p:sp>
      <p:sp>
        <p:nvSpPr>
          <p:cNvPr id="58" name="TextBox 57"/>
          <p:cNvSpPr txBox="1"/>
          <p:nvPr/>
        </p:nvSpPr>
        <p:spPr>
          <a:xfrm>
            <a:off x="3419872" y="0"/>
            <a:ext cx="2153154" cy="338554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sz="1600" b="1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± IL-1</a:t>
            </a:r>
            <a:r>
              <a:rPr lang="el-GR" sz="1600" b="1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β</a:t>
            </a:r>
            <a:r>
              <a:rPr lang="en-US" sz="1600" b="1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  and / or </a:t>
            </a:r>
            <a:r>
              <a:rPr lang="el-GR" sz="1600" b="1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±</a:t>
            </a:r>
            <a:r>
              <a:rPr lang="en-US" sz="1600" b="1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 AA</a:t>
            </a:r>
            <a:endParaRPr lang="en-US" sz="1600" b="1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59" name="TextBox 58"/>
          <p:cNvSpPr txBox="1"/>
          <p:nvPr/>
        </p:nvSpPr>
        <p:spPr>
          <a:xfrm>
            <a:off x="6660232" y="5013176"/>
            <a:ext cx="2175980" cy="338554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sz="1600" b="1" dirty="0" smtClean="0">
                <a:latin typeface="Arial" panose="020B0604020202020204" pitchFamily="34" charset="0"/>
                <a:ea typeface="Arial Unicode MS" panose="020B0604020202020204" pitchFamily="34" charset="-122"/>
                <a:cs typeface="Arial" panose="020B0604020202020204" pitchFamily="34" charset="0"/>
              </a:rPr>
              <a:t>± IL-1</a:t>
            </a:r>
            <a:r>
              <a:rPr lang="el-GR" sz="1600" b="1" dirty="0" smtClean="0">
                <a:latin typeface="Arial" panose="020B0604020202020204" pitchFamily="34" charset="0"/>
                <a:ea typeface="Arial Unicode MS" panose="020B0604020202020204" pitchFamily="34" charset="-122"/>
                <a:cs typeface="Arial" panose="020B0604020202020204" pitchFamily="34" charset="0"/>
              </a:rPr>
              <a:t>β</a:t>
            </a:r>
            <a:r>
              <a:rPr lang="en-US" sz="1600" b="1" dirty="0" smtClean="0">
                <a:latin typeface="Arial" panose="020B0604020202020204" pitchFamily="34" charset="0"/>
                <a:ea typeface="Arial Unicode MS" panose="020B0604020202020204" pitchFamily="34" charset="-122"/>
                <a:cs typeface="Arial" panose="020B0604020202020204" pitchFamily="34" charset="0"/>
              </a:rPr>
              <a:t> and /or  </a:t>
            </a:r>
            <a:r>
              <a:rPr lang="el-GR" sz="1600" b="1" dirty="0" smtClean="0">
                <a:latin typeface="Arial" panose="020B0604020202020204" pitchFamily="34" charset="0"/>
                <a:ea typeface="Arial Unicode MS" panose="020B0604020202020204" pitchFamily="34" charset="-122"/>
                <a:cs typeface="Arial" panose="020B0604020202020204" pitchFamily="34" charset="0"/>
              </a:rPr>
              <a:t>±</a:t>
            </a:r>
            <a:r>
              <a:rPr lang="en-US" sz="1600" b="1" dirty="0" smtClean="0">
                <a:latin typeface="Arial" panose="020B0604020202020204" pitchFamily="34" charset="0"/>
                <a:ea typeface="Arial Unicode MS" panose="020B0604020202020204" pitchFamily="34" charset="-122"/>
                <a:cs typeface="Arial" panose="020B0604020202020204" pitchFamily="34" charset="0"/>
              </a:rPr>
              <a:t> AA</a:t>
            </a:r>
            <a:endParaRPr lang="en-US" sz="1600" b="1" dirty="0">
              <a:latin typeface="Arial" panose="020B0604020202020204" pitchFamily="34" charset="0"/>
              <a:ea typeface="Arial Unicode MS" panose="020B0604020202020204" pitchFamily="34" charset="-122"/>
              <a:cs typeface="Arial" panose="020B0604020202020204" pitchFamily="34" charset="0"/>
            </a:endParaRPr>
          </a:p>
        </p:txBody>
      </p:sp>
      <p:sp>
        <p:nvSpPr>
          <p:cNvPr id="24" name="Up Arrow Callout 23"/>
          <p:cNvSpPr/>
          <p:nvPr/>
        </p:nvSpPr>
        <p:spPr>
          <a:xfrm>
            <a:off x="3633781" y="5253051"/>
            <a:ext cx="1814525" cy="1176345"/>
          </a:xfrm>
          <a:prstGeom prst="upArrowCallou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100">
              <a:latin typeface="Arial" panose="020B0604020202020204" pitchFamily="34" charset="0"/>
              <a:ea typeface="Arial Unicode MS" panose="020B0604020202020204" pitchFamily="34" charset="-122"/>
              <a:cs typeface="Arial" panose="020B0604020202020204" pitchFamily="34" charset="0"/>
            </a:endParaRPr>
          </a:p>
        </p:txBody>
      </p:sp>
      <p:pic>
        <p:nvPicPr>
          <p:cNvPr id="1028" name="Picture 4" descr="http://gtbinf.files.wordpress.com/2013/11/fasting.png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8185"/>
          <a:stretch>
            <a:fillRect/>
          </a:stretch>
        </p:blipFill>
        <p:spPr bwMode="auto">
          <a:xfrm rot="5400000">
            <a:off x="4227098" y="5226475"/>
            <a:ext cx="642919" cy="1667627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9" name="TextBox 28"/>
          <p:cNvSpPr txBox="1"/>
          <p:nvPr/>
        </p:nvSpPr>
        <p:spPr>
          <a:xfrm>
            <a:off x="3531144" y="4959919"/>
            <a:ext cx="204414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latin typeface="Arial" panose="020B0604020202020204" pitchFamily="34" charset="0"/>
                <a:ea typeface="Arial Unicode MS" panose="020B0604020202020204" pitchFamily="34" charset="-122"/>
                <a:cs typeface="Arial" panose="020B0604020202020204" pitchFamily="34" charset="0"/>
              </a:rPr>
              <a:t>Integration of data</a:t>
            </a:r>
            <a:endParaRPr lang="en-US" dirty="0">
              <a:latin typeface="Arial" panose="020B0604020202020204" pitchFamily="34" charset="0"/>
              <a:ea typeface="Arial Unicode MS" panose="020B0604020202020204" pitchFamily="34" charset="-122"/>
              <a:cs typeface="Arial" panose="020B0604020202020204" pitchFamily="34" charset="0"/>
            </a:endParaRPr>
          </a:p>
        </p:txBody>
      </p:sp>
      <p:cxnSp>
        <p:nvCxnSpPr>
          <p:cNvPr id="72" name="Straight Arrow Connector 71"/>
          <p:cNvCxnSpPr/>
          <p:nvPr/>
        </p:nvCxnSpPr>
        <p:spPr>
          <a:xfrm>
            <a:off x="6643702" y="2207810"/>
            <a:ext cx="428628" cy="1588"/>
          </a:xfrm>
          <a:prstGeom prst="straightConnector1">
            <a:avLst/>
          </a:prstGeom>
          <a:ln w="1905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" name="Left Bracket 1"/>
          <p:cNvSpPr/>
          <p:nvPr/>
        </p:nvSpPr>
        <p:spPr>
          <a:xfrm>
            <a:off x="2928926" y="2425020"/>
            <a:ext cx="101255" cy="622066"/>
          </a:xfrm>
          <a:prstGeom prst="leftBracket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366643" y="3419708"/>
            <a:ext cx="168507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>
                <a:latin typeface="Arial" panose="020B0604020202020204" pitchFamily="34" charset="0"/>
                <a:cs typeface="Arial" panose="020B0604020202020204" pitchFamily="34" charset="0"/>
              </a:rPr>
              <a:t>COX pathway</a:t>
            </a:r>
            <a:endParaRPr 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Right Bracket 18"/>
          <p:cNvSpPr/>
          <p:nvPr/>
        </p:nvSpPr>
        <p:spPr>
          <a:xfrm rot="16200000">
            <a:off x="6305840" y="1015644"/>
            <a:ext cx="108012" cy="1718303"/>
          </a:xfrm>
          <a:prstGeom prst="rightBracket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5" name="TextBox 64"/>
          <p:cNvSpPr txBox="1"/>
          <p:nvPr/>
        </p:nvSpPr>
        <p:spPr>
          <a:xfrm>
            <a:off x="5572132" y="1428736"/>
            <a:ext cx="165942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L</a:t>
            </a:r>
            <a:r>
              <a:rPr lang="en-US" b="1" dirty="0" smtClean="0">
                <a:latin typeface="Arial" panose="020B0604020202020204" pitchFamily="34" charset="0"/>
                <a:cs typeface="Arial" panose="020B0604020202020204" pitchFamily="34" charset="0"/>
              </a:rPr>
              <a:t>OX pathway</a:t>
            </a:r>
            <a:endParaRPr 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Left Bracket 29"/>
          <p:cNvSpPr/>
          <p:nvPr/>
        </p:nvSpPr>
        <p:spPr>
          <a:xfrm>
            <a:off x="2000232" y="2714620"/>
            <a:ext cx="142876" cy="2115787"/>
          </a:xfrm>
          <a:prstGeom prst="leftBracket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6" name="TextBox 85"/>
          <p:cNvSpPr txBox="1"/>
          <p:nvPr/>
        </p:nvSpPr>
        <p:spPr>
          <a:xfrm>
            <a:off x="6286512" y="4286256"/>
            <a:ext cx="150019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dirty="0" smtClean="0">
                <a:latin typeface="Arial" panose="020B0604020202020204" pitchFamily="34" charset="0"/>
                <a:cs typeface="Arial" panose="020B0604020202020204" pitchFamily="34" charset="0"/>
              </a:rPr>
              <a:t>TX pathway</a:t>
            </a:r>
            <a:endParaRPr 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Right Brace 39"/>
          <p:cNvSpPr/>
          <p:nvPr/>
        </p:nvSpPr>
        <p:spPr>
          <a:xfrm>
            <a:off x="6000760" y="3718500"/>
            <a:ext cx="229134" cy="1454477"/>
          </a:xfrm>
          <a:prstGeom prst="rightBrac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5" name="TextBox 84"/>
          <p:cNvSpPr txBox="1"/>
          <p:nvPr/>
        </p:nvSpPr>
        <p:spPr>
          <a:xfrm>
            <a:off x="4549094" y="4686638"/>
            <a:ext cx="522971" cy="261610"/>
          </a:xfrm>
          <a:prstGeom prst="rect">
            <a:avLst/>
          </a:prstGeom>
          <a:noFill/>
          <a:ln w="9525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US" sz="1100" dirty="0" smtClean="0">
                <a:latin typeface="Arial" panose="020B0604020202020204" pitchFamily="34" charset="0"/>
                <a:ea typeface="Arial Unicode MS" panose="020B0604020202020204" pitchFamily="34" charset="-122"/>
                <a:cs typeface="Arial" panose="020B0604020202020204" pitchFamily="34" charset="0"/>
              </a:rPr>
              <a:t>PGI</a:t>
            </a:r>
            <a:r>
              <a:rPr lang="en-US" sz="1100" baseline="-25000" dirty="0" smtClean="0">
                <a:latin typeface="Arial" panose="020B0604020202020204" pitchFamily="34" charset="0"/>
                <a:ea typeface="Arial Unicode MS" panose="020B0604020202020204" pitchFamily="34" charset="-122"/>
                <a:cs typeface="Arial" panose="020B0604020202020204" pitchFamily="34" charset="0"/>
              </a:rPr>
              <a:t>2</a:t>
            </a:r>
            <a:endParaRPr lang="en-US" sz="1100" baseline="-25000" dirty="0">
              <a:latin typeface="Arial" panose="020B0604020202020204" pitchFamily="34" charset="0"/>
              <a:ea typeface="Arial Unicode MS" panose="020B0604020202020204" pitchFamily="34" charset="-122"/>
              <a:cs typeface="Arial" panose="020B0604020202020204" pitchFamily="34" charset="0"/>
            </a:endParaRPr>
          </a:p>
        </p:txBody>
      </p:sp>
      <p:cxnSp>
        <p:nvCxnSpPr>
          <p:cNvPr id="92" name="Straight Arrow Connector 51"/>
          <p:cNvCxnSpPr/>
          <p:nvPr/>
        </p:nvCxnSpPr>
        <p:spPr>
          <a:xfrm rot="5400000">
            <a:off x="5926744" y="2781892"/>
            <a:ext cx="864000" cy="1588"/>
          </a:xfrm>
          <a:prstGeom prst="straightConnector1">
            <a:avLst/>
          </a:prstGeom>
          <a:ln w="1905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99209264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607</TotalTime>
  <Words>80</Words>
  <Application>Microsoft Office PowerPoint</Application>
  <PresentationFormat>On-screen Show (4:3)</PresentationFormat>
  <Paragraphs>39</Paragraphs>
  <Slides>1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主题​​</vt:lpstr>
      <vt:lpstr>PowerPoint Presentation</vt:lpstr>
    </vt:vector>
  </TitlesOfParts>
  <Company>微软中国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JL</dc:creator>
  <cp:lastModifiedBy>Ashok</cp:lastModifiedBy>
  <cp:revision>47</cp:revision>
  <dcterms:created xsi:type="dcterms:W3CDTF">2014-09-16T06:57:51Z</dcterms:created>
  <dcterms:modified xsi:type="dcterms:W3CDTF">2016-03-30T02:29:25Z</dcterms:modified>
</cp:coreProperties>
</file>